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slides/slide10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10.xml" ContentType="application/vnd.openxmlformats-officedocument.presentationml.notes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2"/>
  </p:notesMasterIdLst>
  <p:sldIdLst>
    <p:sldId id="258" r:id="rId2"/>
    <p:sldId id="260" r:id="rId3"/>
    <p:sldId id="262" r:id="rId4"/>
    <p:sldId id="261" r:id="rId5"/>
    <p:sldId id="263" r:id="rId6"/>
    <p:sldId id="264" r:id="rId7"/>
    <p:sldId id="265" r:id="rId8"/>
    <p:sldId id="266" r:id="rId9"/>
    <p:sldId id="267" r:id="rId10"/>
    <p:sldId id="268" r:id="rId11"/>
  </p:sldIdLst>
  <p:sldSz cx="9144000" cy="6858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pitchFamily="-72" charset="0"/>
        <a:ea typeface="ＭＳ Ｐゴシック" pitchFamily="-72" charset="-128"/>
        <a:cs typeface="ＭＳ Ｐゴシック" pitchFamily="-72" charset="-128"/>
      </a:defRPr>
    </a:lvl1pPr>
    <a:lvl2pPr marL="4572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pitchFamily="-72" charset="0"/>
        <a:ea typeface="ＭＳ Ｐゴシック" pitchFamily="-72" charset="-128"/>
        <a:cs typeface="ＭＳ Ｐゴシック" pitchFamily="-72" charset="-128"/>
      </a:defRPr>
    </a:lvl2pPr>
    <a:lvl3pPr marL="9144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pitchFamily="-72" charset="0"/>
        <a:ea typeface="ＭＳ Ｐゴシック" pitchFamily="-72" charset="-128"/>
        <a:cs typeface="ＭＳ Ｐゴシック" pitchFamily="-72" charset="-128"/>
      </a:defRPr>
    </a:lvl3pPr>
    <a:lvl4pPr marL="13716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pitchFamily="-72" charset="0"/>
        <a:ea typeface="ＭＳ Ｐゴシック" pitchFamily="-72" charset="-128"/>
        <a:cs typeface="ＭＳ Ｐゴシック" pitchFamily="-72" charset="-128"/>
      </a:defRPr>
    </a:lvl4pPr>
    <a:lvl5pPr marL="18288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pitchFamily="-72" charset="0"/>
        <a:ea typeface="ＭＳ Ｐゴシック" pitchFamily="-72" charset="-128"/>
        <a:cs typeface="ＭＳ Ｐゴシック" pitchFamily="-72" charset="-128"/>
      </a:defRPr>
    </a:lvl5pPr>
    <a:lvl6pPr marL="2286000" algn="l" defTabSz="457200" rtl="0" eaLnBrk="1" latinLnBrk="0" hangingPunct="1">
      <a:defRPr sz="2400" kern="1200">
        <a:solidFill>
          <a:schemeClr val="tx1"/>
        </a:solidFill>
        <a:latin typeface="Arial" pitchFamily="-72" charset="0"/>
        <a:ea typeface="ＭＳ Ｐゴシック" pitchFamily="-72" charset="-128"/>
        <a:cs typeface="ＭＳ Ｐゴシック" pitchFamily="-72" charset="-128"/>
      </a:defRPr>
    </a:lvl6pPr>
    <a:lvl7pPr marL="2743200" algn="l" defTabSz="457200" rtl="0" eaLnBrk="1" latinLnBrk="0" hangingPunct="1">
      <a:defRPr sz="2400" kern="1200">
        <a:solidFill>
          <a:schemeClr val="tx1"/>
        </a:solidFill>
        <a:latin typeface="Arial" pitchFamily="-72" charset="0"/>
        <a:ea typeface="ＭＳ Ｐゴシック" pitchFamily="-72" charset="-128"/>
        <a:cs typeface="ＭＳ Ｐゴシック" pitchFamily="-72" charset="-128"/>
      </a:defRPr>
    </a:lvl7pPr>
    <a:lvl8pPr marL="3200400" algn="l" defTabSz="457200" rtl="0" eaLnBrk="1" latinLnBrk="0" hangingPunct="1">
      <a:defRPr sz="2400" kern="1200">
        <a:solidFill>
          <a:schemeClr val="tx1"/>
        </a:solidFill>
        <a:latin typeface="Arial" pitchFamily="-72" charset="0"/>
        <a:ea typeface="ＭＳ Ｐゴシック" pitchFamily="-72" charset="-128"/>
        <a:cs typeface="ＭＳ Ｐゴシック" pitchFamily="-72" charset="-128"/>
      </a:defRPr>
    </a:lvl8pPr>
    <a:lvl9pPr marL="3657600" algn="l" defTabSz="457200" rtl="0" eaLnBrk="1" latinLnBrk="0" hangingPunct="1">
      <a:defRPr sz="2400" kern="1200">
        <a:solidFill>
          <a:schemeClr val="tx1"/>
        </a:solidFill>
        <a:latin typeface="Arial" pitchFamily="-72" charset="0"/>
        <a:ea typeface="ＭＳ Ｐゴシック" pitchFamily="-72" charset="-128"/>
        <a:cs typeface="ＭＳ Ｐゴシック" pitchFamily="-72" charset="-128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clrMru>
    <a:srgbClr val="DCDCDC"/>
    <a:srgbClr val="FF0000"/>
    <a:srgbClr val="0000FA"/>
    <a:srgbClr val="CCECFF"/>
    <a:srgbClr val="0000FF"/>
    <a:srgbClr val="0000FD"/>
    <a:srgbClr val="0000F0"/>
    <a:srgbClr val="0000D2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682" autoAdjust="0"/>
    <p:restoredTop sz="94650" autoAdjust="0"/>
  </p:normalViewPr>
  <p:slideViewPr>
    <p:cSldViewPr snapToGrid="0">
      <p:cViewPr>
        <p:scale>
          <a:sx n="100" d="100"/>
          <a:sy n="100" d="100"/>
        </p:scale>
        <p:origin x="-1344" y="-96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2" name="Rectangle 1026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5363" name="Rectangle 1027"/>
          <p:cNvSpPr>
            <a:spLocks noGrp="1" noChangeArrowheads="1"/>
          </p:cNvSpPr>
          <p:nvPr>
            <p:ph type="dt" idx="1"/>
          </p:nvPr>
        </p:nvSpPr>
        <p:spPr bwMode="auto">
          <a:xfrm>
            <a:off x="3886200" y="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fld id="{8B8E7D71-F6C6-44A7-A7DD-F9366EA0DE96}" type="datetime1">
              <a:rPr lang="en-US"/>
              <a:pPr>
                <a:defRPr/>
              </a:pPr>
              <a:t>1/28/2017</a:t>
            </a:fld>
            <a:endParaRPr lang="en-US"/>
          </a:p>
        </p:txBody>
      </p:sp>
      <p:sp>
        <p:nvSpPr>
          <p:cNvPr id="13316" name="Placeholder 1028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1143000" y="685800"/>
            <a:ext cx="4572000" cy="342900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15365" name="Rectangle 1029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914400" y="4343400"/>
            <a:ext cx="5029200" cy="411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noProof="0"/>
              <a:t>Click to edit Master text styles</a:t>
            </a:r>
          </a:p>
          <a:p>
            <a:pPr lvl="1"/>
            <a:r>
              <a:rPr lang="en-US" noProof="0"/>
              <a:t>Second level</a:t>
            </a:r>
          </a:p>
          <a:p>
            <a:pPr lvl="2"/>
            <a:r>
              <a:rPr lang="en-US" noProof="0"/>
              <a:t>Third level</a:t>
            </a:r>
          </a:p>
          <a:p>
            <a:pPr lvl="3"/>
            <a:r>
              <a:rPr lang="en-US" noProof="0"/>
              <a:t>Fourth level</a:t>
            </a:r>
          </a:p>
          <a:p>
            <a:pPr lvl="4"/>
            <a:r>
              <a:rPr lang="en-US" noProof="0"/>
              <a:t>Fifth level</a:t>
            </a:r>
          </a:p>
        </p:txBody>
      </p:sp>
      <p:sp>
        <p:nvSpPr>
          <p:cNvPr id="15366" name="Rectangle 1030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868680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5367" name="Rectangle 1031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86200" y="868680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fld id="{F6A780D4-DC63-4F21-8820-F63CFA35C9D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829390111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Calibri" pitchFamily="-72" charset="0"/>
        <a:ea typeface="ＭＳ Ｐゴシック" pitchFamily="-72" charset="-128"/>
        <a:cs typeface="ＭＳ Ｐゴシック" pitchFamily="-72" charset="-128"/>
      </a:defRPr>
    </a:lvl1pPr>
    <a:lvl2pPr marL="4572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Calibri" pitchFamily="-72" charset="0"/>
        <a:ea typeface="ＭＳ Ｐゴシック" pitchFamily="-72" charset="-128"/>
        <a:cs typeface="+mn-cs"/>
      </a:defRPr>
    </a:lvl2pPr>
    <a:lvl3pPr marL="9144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Calibri" pitchFamily="-72" charset="0"/>
        <a:ea typeface="ＭＳ Ｐゴシック" pitchFamily="-72" charset="-128"/>
        <a:cs typeface="+mn-cs"/>
      </a:defRPr>
    </a:lvl3pPr>
    <a:lvl4pPr marL="13716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Calibri" pitchFamily="-72" charset="0"/>
        <a:ea typeface="ＭＳ Ｐゴシック" pitchFamily="-72" charset="-128"/>
        <a:cs typeface="+mn-cs"/>
      </a:defRPr>
    </a:lvl4pPr>
    <a:lvl5pPr marL="18288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Calibri" pitchFamily="-72" charset="0"/>
        <a:ea typeface="ＭＳ Ｐゴシック" pitchFamily="-72" charset="-128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1" name="Placeholder 1026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15362" name="Placeholder 1027"/>
          <p:cNvSpPr>
            <a:spLocks noGrp="1" noChangeArrowheads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pPr eaLnBrk="1" hangingPunct="1"/>
            <a:endParaRPr lang="en-US"/>
          </a:p>
        </p:txBody>
      </p:sp>
    </p:spTree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1" name="Placeholder 1026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15362" name="Placeholder 1027"/>
          <p:cNvSpPr>
            <a:spLocks noGrp="1" noChangeArrowheads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pPr eaLnBrk="1" hangingPunct="1"/>
            <a:endParaRPr 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1" name="Placeholder 1026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15362" name="Placeholder 1027"/>
          <p:cNvSpPr>
            <a:spLocks noGrp="1" noChangeArrowheads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pPr eaLnBrk="1" hangingPunct="1"/>
            <a:endParaRPr lang="en-US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1" name="Placeholder 1026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15362" name="Placeholder 1027"/>
          <p:cNvSpPr>
            <a:spLocks noGrp="1" noChangeArrowheads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pPr eaLnBrk="1" hangingPunct="1"/>
            <a:endParaRPr lang="en-US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1" name="Placeholder 1026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15362" name="Placeholder 1027"/>
          <p:cNvSpPr>
            <a:spLocks noGrp="1" noChangeArrowheads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pPr eaLnBrk="1" hangingPunct="1"/>
            <a:endParaRPr lang="en-US"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1" name="Placeholder 1026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15362" name="Placeholder 1027"/>
          <p:cNvSpPr>
            <a:spLocks noGrp="1" noChangeArrowheads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pPr eaLnBrk="1" hangingPunct="1"/>
            <a:endParaRPr lang="en-US"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1" name="Placeholder 1026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15362" name="Placeholder 1027"/>
          <p:cNvSpPr>
            <a:spLocks noGrp="1" noChangeArrowheads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pPr eaLnBrk="1" hangingPunct="1"/>
            <a:endParaRPr lang="en-US"/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1" name="Placeholder 1026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15362" name="Placeholder 1027"/>
          <p:cNvSpPr>
            <a:spLocks noGrp="1" noChangeArrowheads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pPr eaLnBrk="1" hangingPunct="1"/>
            <a:endParaRPr lang="en-US"/>
          </a:p>
        </p:txBody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1" name="Placeholder 1026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15362" name="Placeholder 1027"/>
          <p:cNvSpPr>
            <a:spLocks noGrp="1" noChangeArrowheads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pPr eaLnBrk="1" hangingPunct="1"/>
            <a:endParaRPr lang="en-US"/>
          </a:p>
        </p:txBody>
      </p:sp>
    </p:spTree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1" name="Placeholder 1026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15362" name="Placeholder 1027"/>
          <p:cNvSpPr>
            <a:spLocks noGrp="1" noChangeArrowheads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pPr eaLnBrk="1" hangingPunct="1"/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09ECCCC-7990-46FB-9BE6-354644F5DCB9}" type="datetimeFigureOut">
              <a:rPr lang="en-US"/>
              <a:pPr>
                <a:defRPr/>
              </a:pPr>
              <a:t>1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468EF91-59C7-43BB-AF17-583CFFC3983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4508E92-C7D6-44F2-90B3-88853A881363}" type="datetimeFigureOut">
              <a:rPr lang="en-US"/>
              <a:pPr>
                <a:defRPr/>
              </a:pPr>
              <a:t>1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3B3C653-54A3-400F-B744-091764D268C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DE18D71-4B6F-491F-AE6B-9AAC5B6A3722}" type="datetimeFigureOut">
              <a:rPr lang="en-US"/>
              <a:pPr>
                <a:defRPr/>
              </a:pPr>
              <a:t>1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424855-E52A-46FB-9E5D-B156FFAD96F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60335F4-2CA4-445E-8CCB-EC7445C70464}" type="datetimeFigureOut">
              <a:rPr lang="en-US"/>
              <a:pPr>
                <a:defRPr/>
              </a:pPr>
              <a:t>1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8E9AC97-9FF1-4448-BEAA-99911238318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5430395-3F52-4295-A71D-686DB19526C0}" type="datetimeFigureOut">
              <a:rPr lang="en-US"/>
              <a:pPr>
                <a:defRPr/>
              </a:pPr>
              <a:t>1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23DE4E1-E10A-450C-881B-CE69C214393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C7658C9-5A16-42C2-ACE1-F3135A010921}" type="datetimeFigureOut">
              <a:rPr lang="en-US"/>
              <a:pPr>
                <a:defRPr/>
              </a:pPr>
              <a:t>1/28/2017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DEB5A9-0C59-4D71-837C-BA3E4BBC9DF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A6BEB70-DDA6-47DD-98AB-89632A32D5C4}" type="datetimeFigureOut">
              <a:rPr lang="en-US"/>
              <a:pPr>
                <a:defRPr/>
              </a:pPr>
              <a:t>1/28/2017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CF28FD4-B91C-40EE-9D6D-27107BD62C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FA620B2-ED06-4760-B116-40548B8685B1}" type="datetimeFigureOut">
              <a:rPr lang="en-US"/>
              <a:pPr>
                <a:defRPr/>
              </a:pPr>
              <a:t>1/28/2017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A431118-BE33-41F7-AAED-8CF137A3EA6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510E73F-45E1-4156-9E7D-9AC793C5D951}" type="datetimeFigureOut">
              <a:rPr lang="en-US"/>
              <a:pPr>
                <a:defRPr/>
              </a:pPr>
              <a:t>1/28/2017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53B1E00-AAE9-4D6E-B59D-EB2ECBA39CC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BE479DA-2772-4447-A02B-7CDBE0252081}" type="datetimeFigureOut">
              <a:rPr lang="en-US"/>
              <a:pPr>
                <a:defRPr/>
              </a:pPr>
              <a:t>1/28/2017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AADB547-6ADA-409D-B6B3-5068342B87C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B1C978-8948-4B3B-9BB9-F9085566B8AF}" type="datetimeFigureOut">
              <a:rPr lang="en-US"/>
              <a:pPr>
                <a:defRPr/>
              </a:pPr>
              <a:t>1/28/2017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4AA8099-F072-48FF-A7B6-1B5E7CE5964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CCEC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70D16032-546A-47D0-9A4A-21BE43BF2192}" type="datetimeFigureOut">
              <a:rPr lang="en-US"/>
              <a:pPr>
                <a:defRPr/>
              </a:pPr>
              <a:t>1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AA13752C-06FF-4C4B-A274-27BF3934470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ＭＳ Ｐゴシック" pitchFamily="-72" charset="-128"/>
          <a:cs typeface="ＭＳ Ｐゴシック" pitchFamily="-72" charset="-128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pitchFamily="-72" charset="-128"/>
          <a:cs typeface="ＭＳ Ｐゴシック" pitchFamily="-72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pitchFamily="-72" charset="-128"/>
          <a:cs typeface="ＭＳ Ｐゴシック" pitchFamily="-72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pitchFamily="-72" charset="-128"/>
          <a:cs typeface="ＭＳ Ｐゴシック" pitchFamily="-72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pitchFamily="-72" charset="-128"/>
          <a:cs typeface="ＭＳ Ｐゴシック" pitchFamily="-72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pitchFamily="-72" charset="0"/>
        <a:buChar char="•"/>
        <a:defRPr sz="3200" kern="1200">
          <a:solidFill>
            <a:schemeClr val="tx1"/>
          </a:solidFill>
          <a:latin typeface="+mn-lt"/>
          <a:ea typeface="ＭＳ Ｐゴシック" pitchFamily="-72" charset="-128"/>
          <a:cs typeface="ＭＳ Ｐゴシック" pitchFamily="-72" charset="-128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pitchFamily="-72" charset="0"/>
        <a:buChar char="–"/>
        <a:defRPr sz="2800" kern="1200">
          <a:solidFill>
            <a:schemeClr val="tx1"/>
          </a:solidFill>
          <a:latin typeface="+mn-lt"/>
          <a:ea typeface="ＭＳ Ｐゴシック" pitchFamily="-72" charset="-128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pitchFamily="-72" charset="0"/>
        <a:buChar char="•"/>
        <a:defRPr sz="2400" kern="1200">
          <a:solidFill>
            <a:schemeClr val="tx1"/>
          </a:solidFill>
          <a:latin typeface="+mn-lt"/>
          <a:ea typeface="ＭＳ Ｐゴシック" pitchFamily="-72" charset="-128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pitchFamily="-72" charset="0"/>
        <a:buChar char="–"/>
        <a:defRPr sz="2000" kern="1200">
          <a:solidFill>
            <a:schemeClr val="tx1"/>
          </a:solidFill>
          <a:latin typeface="+mn-lt"/>
          <a:ea typeface="ＭＳ Ｐゴシック" pitchFamily="-72" charset="-128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pitchFamily="-72" charset="0"/>
        <a:buChar char="»"/>
        <a:defRPr sz="2000" kern="1200">
          <a:solidFill>
            <a:schemeClr val="tx1"/>
          </a:solidFill>
          <a:latin typeface="+mn-lt"/>
          <a:ea typeface="ＭＳ Ｐゴシック" pitchFamily="-72" charset="-128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7"/>
          <p:cNvGrpSpPr>
            <a:grpSpLocks/>
          </p:cNvGrpSpPr>
          <p:nvPr/>
        </p:nvGrpSpPr>
        <p:grpSpPr bwMode="auto">
          <a:xfrm>
            <a:off x="28575" y="434975"/>
            <a:ext cx="4513263" cy="3008313"/>
            <a:chOff x="232013" y="464024"/>
            <a:chExt cx="4258100" cy="2838735"/>
          </a:xfrm>
        </p:grpSpPr>
        <p:sp>
          <p:nvSpPr>
            <p:cNvPr id="4" name="Oval 3"/>
            <p:cNvSpPr/>
            <p:nvPr/>
          </p:nvSpPr>
          <p:spPr>
            <a:xfrm>
              <a:off x="497115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solidFill>
                <a:srgbClr val="0000FF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" name="Rectangle 9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11" name="Oval 10"/>
            <p:cNvSpPr/>
            <p:nvPr/>
          </p:nvSpPr>
          <p:spPr>
            <a:xfrm>
              <a:off x="1803152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solidFill>
                <a:srgbClr val="0000FF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2" name="Oval 11"/>
            <p:cNvSpPr/>
            <p:nvPr/>
          </p:nvSpPr>
          <p:spPr>
            <a:xfrm>
              <a:off x="3103198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solidFill>
                <a:srgbClr val="0000FF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3" name="Oval 12"/>
            <p:cNvSpPr/>
            <p:nvPr/>
          </p:nvSpPr>
          <p:spPr>
            <a:xfrm>
              <a:off x="497115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solidFill>
                <a:srgbClr val="0000FF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4" name="Oval 13"/>
            <p:cNvSpPr/>
            <p:nvPr/>
          </p:nvSpPr>
          <p:spPr>
            <a:xfrm>
              <a:off x="1803152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solidFill>
                <a:srgbClr val="0000FF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5" name="Oval 14"/>
            <p:cNvSpPr/>
            <p:nvPr/>
          </p:nvSpPr>
          <p:spPr>
            <a:xfrm>
              <a:off x="3103198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solidFill>
                <a:srgbClr val="0000FF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6" name="Arc 15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17" name="Arc 16"/>
            <p:cNvSpPr/>
            <p:nvPr/>
          </p:nvSpPr>
          <p:spPr>
            <a:xfrm flipV="1">
              <a:off x="3564504" y="2376987"/>
              <a:ext cx="915124" cy="915285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grpSp>
        <p:nvGrpSpPr>
          <p:cNvPr id="3" name="Group 61"/>
          <p:cNvGrpSpPr>
            <a:grpSpLocks/>
          </p:cNvGrpSpPr>
          <p:nvPr/>
        </p:nvGrpSpPr>
        <p:grpSpPr bwMode="auto">
          <a:xfrm>
            <a:off x="4589463" y="438150"/>
            <a:ext cx="4513262" cy="3008313"/>
            <a:chOff x="232013" y="464024"/>
            <a:chExt cx="4258100" cy="2838735"/>
          </a:xfrm>
        </p:grpSpPr>
        <p:sp>
          <p:nvSpPr>
            <p:cNvPr id="63" name="Oval 62"/>
            <p:cNvSpPr/>
            <p:nvPr/>
          </p:nvSpPr>
          <p:spPr>
            <a:xfrm>
              <a:off x="497114" y="664758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solidFill>
                <a:srgbClr val="0000FF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4" name="Rectangle 63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65" name="Oval 64"/>
            <p:cNvSpPr/>
            <p:nvPr/>
          </p:nvSpPr>
          <p:spPr>
            <a:xfrm>
              <a:off x="1803151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solidFill>
                <a:srgbClr val="0000FF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6" name="Oval 65"/>
            <p:cNvSpPr/>
            <p:nvPr/>
          </p:nvSpPr>
          <p:spPr>
            <a:xfrm>
              <a:off x="3103197" y="664758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solidFill>
                <a:srgbClr val="0000FF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7" name="Oval 66"/>
            <p:cNvSpPr/>
            <p:nvPr/>
          </p:nvSpPr>
          <p:spPr>
            <a:xfrm>
              <a:off x="497114" y="1965033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solidFill>
                <a:srgbClr val="0000FF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8" name="Oval 67"/>
            <p:cNvSpPr/>
            <p:nvPr/>
          </p:nvSpPr>
          <p:spPr>
            <a:xfrm>
              <a:off x="1803151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solidFill>
                <a:srgbClr val="0000FF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9" name="Oval 68"/>
            <p:cNvSpPr/>
            <p:nvPr/>
          </p:nvSpPr>
          <p:spPr>
            <a:xfrm>
              <a:off x="3103197" y="1965033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solidFill>
                <a:srgbClr val="0000FF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70" name="Arc 69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71" name="Arc 70"/>
            <p:cNvSpPr/>
            <p:nvPr/>
          </p:nvSpPr>
          <p:spPr>
            <a:xfrm flipV="1">
              <a:off x="3564504" y="2376987"/>
              <a:ext cx="915125" cy="915285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grpSp>
        <p:nvGrpSpPr>
          <p:cNvPr id="5" name="Group 78"/>
          <p:cNvGrpSpPr>
            <a:grpSpLocks/>
          </p:cNvGrpSpPr>
          <p:nvPr/>
        </p:nvGrpSpPr>
        <p:grpSpPr bwMode="auto">
          <a:xfrm>
            <a:off x="28575" y="3486150"/>
            <a:ext cx="4513263" cy="3008313"/>
            <a:chOff x="232013" y="464024"/>
            <a:chExt cx="4258100" cy="2838735"/>
          </a:xfrm>
        </p:grpSpPr>
        <p:sp>
          <p:nvSpPr>
            <p:cNvPr id="80" name="Oval 79"/>
            <p:cNvSpPr/>
            <p:nvPr/>
          </p:nvSpPr>
          <p:spPr>
            <a:xfrm>
              <a:off x="497115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solidFill>
                <a:srgbClr val="0000FF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1" name="Rectangle 80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82" name="Oval 81"/>
            <p:cNvSpPr/>
            <p:nvPr/>
          </p:nvSpPr>
          <p:spPr>
            <a:xfrm>
              <a:off x="1803152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solidFill>
                <a:srgbClr val="0000FF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3" name="Oval 82"/>
            <p:cNvSpPr/>
            <p:nvPr/>
          </p:nvSpPr>
          <p:spPr>
            <a:xfrm>
              <a:off x="3103198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solidFill>
                <a:srgbClr val="0000FF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4" name="Oval 83"/>
            <p:cNvSpPr/>
            <p:nvPr/>
          </p:nvSpPr>
          <p:spPr>
            <a:xfrm>
              <a:off x="497115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solidFill>
                <a:srgbClr val="0000FF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5" name="Oval 84"/>
            <p:cNvSpPr/>
            <p:nvPr/>
          </p:nvSpPr>
          <p:spPr>
            <a:xfrm>
              <a:off x="1803152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solidFill>
                <a:srgbClr val="0000FF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6" name="Oval 85"/>
            <p:cNvSpPr/>
            <p:nvPr/>
          </p:nvSpPr>
          <p:spPr>
            <a:xfrm>
              <a:off x="3103198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solidFill>
                <a:srgbClr val="0000FF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7" name="Arc 86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88" name="Arc 87"/>
            <p:cNvSpPr/>
            <p:nvPr/>
          </p:nvSpPr>
          <p:spPr>
            <a:xfrm flipV="1">
              <a:off x="3564504" y="2376987"/>
              <a:ext cx="915124" cy="915285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grpSp>
        <p:nvGrpSpPr>
          <p:cNvPr id="6" name="Group 95"/>
          <p:cNvGrpSpPr>
            <a:grpSpLocks/>
          </p:cNvGrpSpPr>
          <p:nvPr/>
        </p:nvGrpSpPr>
        <p:grpSpPr bwMode="auto">
          <a:xfrm>
            <a:off x="4591050" y="3481388"/>
            <a:ext cx="4513263" cy="3008312"/>
            <a:chOff x="232013" y="464024"/>
            <a:chExt cx="4258100" cy="2838735"/>
          </a:xfrm>
        </p:grpSpPr>
        <p:sp>
          <p:nvSpPr>
            <p:cNvPr id="97" name="Oval 96"/>
            <p:cNvSpPr/>
            <p:nvPr/>
          </p:nvSpPr>
          <p:spPr>
            <a:xfrm>
              <a:off x="497115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solidFill>
                <a:srgbClr val="0000FF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98" name="Rectangle 97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99" name="Oval 98"/>
            <p:cNvSpPr/>
            <p:nvPr/>
          </p:nvSpPr>
          <p:spPr>
            <a:xfrm>
              <a:off x="1803152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solidFill>
                <a:srgbClr val="0000FF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0" name="Oval 99"/>
            <p:cNvSpPr/>
            <p:nvPr/>
          </p:nvSpPr>
          <p:spPr>
            <a:xfrm>
              <a:off x="3103198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solidFill>
                <a:srgbClr val="0000FF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1" name="Oval 100"/>
            <p:cNvSpPr/>
            <p:nvPr/>
          </p:nvSpPr>
          <p:spPr>
            <a:xfrm>
              <a:off x="497115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solidFill>
                <a:srgbClr val="0000FF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2" name="Oval 101"/>
            <p:cNvSpPr/>
            <p:nvPr/>
          </p:nvSpPr>
          <p:spPr>
            <a:xfrm>
              <a:off x="1803152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solidFill>
                <a:srgbClr val="0000FF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3" name="Oval 102"/>
            <p:cNvSpPr/>
            <p:nvPr/>
          </p:nvSpPr>
          <p:spPr>
            <a:xfrm>
              <a:off x="3103198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solidFill>
                <a:srgbClr val="0000FF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4" name="Arc 103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105" name="Arc 104"/>
            <p:cNvSpPr/>
            <p:nvPr/>
          </p:nvSpPr>
          <p:spPr>
            <a:xfrm flipV="1">
              <a:off x="3564504" y="2376987"/>
              <a:ext cx="915124" cy="915287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sp>
        <p:nvSpPr>
          <p:cNvPr id="44" name="TextBox 43"/>
          <p:cNvSpPr txBox="1"/>
          <p:nvPr/>
        </p:nvSpPr>
        <p:spPr>
          <a:xfrm>
            <a:off x="4856844" y="68862"/>
            <a:ext cx="42783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Setup: align plates and manually advance to next slide (</a:t>
            </a:r>
            <a:r>
              <a:rPr lang="en-US" sz="1200" dirty="0" smtClean="0">
                <a:latin typeface="Calibri"/>
              </a:rPr>
              <a:t>→)</a:t>
            </a:r>
            <a:endParaRPr lang="en-US" sz="1200" dirty="0"/>
          </a:p>
        </p:txBody>
      </p:sp>
      <p:sp>
        <p:nvSpPr>
          <p:cNvPr id="43" name="Rectangle 42"/>
          <p:cNvSpPr/>
          <p:nvPr/>
        </p:nvSpPr>
        <p:spPr>
          <a:xfrm>
            <a:off x="263770" y="0"/>
            <a:ext cx="415876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800" dirty="0" smtClean="0"/>
              <a:t>rotating red cross </a:t>
            </a:r>
            <a:r>
              <a:rPr lang="en-US" sz="1800" dirty="0" err="1" smtClean="0"/>
              <a:t>cw-ccw</a:t>
            </a:r>
            <a:r>
              <a:rPr lang="en-US" sz="1800" dirty="0" smtClean="0"/>
              <a:t>, </a:t>
            </a:r>
            <a:r>
              <a:rPr lang="en-US" sz="1800" dirty="0" smtClean="0"/>
              <a:t>4x </a:t>
            </a:r>
            <a:r>
              <a:rPr lang="en-US" sz="1800" dirty="0" smtClean="0"/>
              <a:t>repeated</a:t>
            </a:r>
            <a:endParaRPr lang="en-US" sz="1800" dirty="0"/>
          </a:p>
        </p:txBody>
      </p:sp>
    </p:spTree>
  </p:cSld>
  <p:clrMapOvr>
    <a:masterClrMapping/>
  </p:clrMapOvr>
  <p:transition/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337" name="Group 17"/>
          <p:cNvGrpSpPr>
            <a:grpSpLocks/>
          </p:cNvGrpSpPr>
          <p:nvPr/>
        </p:nvGrpSpPr>
        <p:grpSpPr bwMode="auto">
          <a:xfrm>
            <a:off x="28575" y="434975"/>
            <a:ext cx="4513263" cy="3008313"/>
            <a:chOff x="232013" y="464024"/>
            <a:chExt cx="4258100" cy="2838735"/>
          </a:xfrm>
        </p:grpSpPr>
        <p:sp>
          <p:nvSpPr>
            <p:cNvPr id="4" name="Oval 3"/>
            <p:cNvSpPr/>
            <p:nvPr/>
          </p:nvSpPr>
          <p:spPr>
            <a:xfrm>
              <a:off x="497115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" name="Rectangle 9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11" name="Oval 10"/>
            <p:cNvSpPr/>
            <p:nvPr/>
          </p:nvSpPr>
          <p:spPr>
            <a:xfrm>
              <a:off x="1803152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2" name="Oval 11"/>
            <p:cNvSpPr/>
            <p:nvPr/>
          </p:nvSpPr>
          <p:spPr>
            <a:xfrm>
              <a:off x="3103198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3" name="Oval 12"/>
            <p:cNvSpPr/>
            <p:nvPr/>
          </p:nvSpPr>
          <p:spPr>
            <a:xfrm>
              <a:off x="497115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4" name="Oval 13"/>
            <p:cNvSpPr/>
            <p:nvPr/>
          </p:nvSpPr>
          <p:spPr>
            <a:xfrm>
              <a:off x="1803152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5" name="Oval 14"/>
            <p:cNvSpPr/>
            <p:nvPr/>
          </p:nvSpPr>
          <p:spPr>
            <a:xfrm>
              <a:off x="3103198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 dirty="0"/>
            </a:p>
          </p:txBody>
        </p:sp>
        <p:sp>
          <p:nvSpPr>
            <p:cNvPr id="16" name="Arc 15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17" name="Arc 16"/>
            <p:cNvSpPr/>
            <p:nvPr/>
          </p:nvSpPr>
          <p:spPr>
            <a:xfrm flipV="1">
              <a:off x="3564504" y="2376987"/>
              <a:ext cx="915124" cy="915285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grpSp>
        <p:nvGrpSpPr>
          <p:cNvPr id="14338" name="Group 61"/>
          <p:cNvGrpSpPr>
            <a:grpSpLocks/>
          </p:cNvGrpSpPr>
          <p:nvPr/>
        </p:nvGrpSpPr>
        <p:grpSpPr bwMode="auto">
          <a:xfrm>
            <a:off x="4589463" y="438150"/>
            <a:ext cx="4513262" cy="3008313"/>
            <a:chOff x="232013" y="464024"/>
            <a:chExt cx="4258100" cy="2838735"/>
          </a:xfrm>
        </p:grpSpPr>
        <p:sp>
          <p:nvSpPr>
            <p:cNvPr id="63" name="Oval 62"/>
            <p:cNvSpPr/>
            <p:nvPr/>
          </p:nvSpPr>
          <p:spPr>
            <a:xfrm>
              <a:off x="497114" y="664758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4" name="Rectangle 63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65" name="Oval 64"/>
            <p:cNvSpPr/>
            <p:nvPr/>
          </p:nvSpPr>
          <p:spPr>
            <a:xfrm>
              <a:off x="1803151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6" name="Oval 65"/>
            <p:cNvSpPr/>
            <p:nvPr/>
          </p:nvSpPr>
          <p:spPr>
            <a:xfrm>
              <a:off x="3103197" y="664758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7" name="Oval 66"/>
            <p:cNvSpPr/>
            <p:nvPr/>
          </p:nvSpPr>
          <p:spPr>
            <a:xfrm>
              <a:off x="497114" y="1965033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8" name="Oval 67"/>
            <p:cNvSpPr/>
            <p:nvPr/>
          </p:nvSpPr>
          <p:spPr>
            <a:xfrm>
              <a:off x="1803151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9" name="Oval 68"/>
            <p:cNvSpPr/>
            <p:nvPr/>
          </p:nvSpPr>
          <p:spPr>
            <a:xfrm>
              <a:off x="3103197" y="1965033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70" name="Arc 69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71" name="Arc 70"/>
            <p:cNvSpPr/>
            <p:nvPr/>
          </p:nvSpPr>
          <p:spPr>
            <a:xfrm flipV="1">
              <a:off x="3564504" y="2376987"/>
              <a:ext cx="915125" cy="915285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grpSp>
        <p:nvGrpSpPr>
          <p:cNvPr id="14339" name="Group 78"/>
          <p:cNvGrpSpPr>
            <a:grpSpLocks/>
          </p:cNvGrpSpPr>
          <p:nvPr/>
        </p:nvGrpSpPr>
        <p:grpSpPr bwMode="auto">
          <a:xfrm>
            <a:off x="28575" y="3486150"/>
            <a:ext cx="4513263" cy="3008313"/>
            <a:chOff x="232013" y="464024"/>
            <a:chExt cx="4258100" cy="2838735"/>
          </a:xfrm>
        </p:grpSpPr>
        <p:sp>
          <p:nvSpPr>
            <p:cNvPr id="80" name="Oval 79"/>
            <p:cNvSpPr/>
            <p:nvPr/>
          </p:nvSpPr>
          <p:spPr>
            <a:xfrm>
              <a:off x="497115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1" name="Rectangle 80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82" name="Oval 81"/>
            <p:cNvSpPr/>
            <p:nvPr/>
          </p:nvSpPr>
          <p:spPr>
            <a:xfrm>
              <a:off x="1803152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3" name="Oval 82"/>
            <p:cNvSpPr/>
            <p:nvPr/>
          </p:nvSpPr>
          <p:spPr>
            <a:xfrm>
              <a:off x="3103198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4" name="Oval 83"/>
            <p:cNvSpPr/>
            <p:nvPr/>
          </p:nvSpPr>
          <p:spPr>
            <a:xfrm>
              <a:off x="497115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5" name="Oval 84"/>
            <p:cNvSpPr/>
            <p:nvPr/>
          </p:nvSpPr>
          <p:spPr>
            <a:xfrm>
              <a:off x="1803152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6" name="Oval 85"/>
            <p:cNvSpPr/>
            <p:nvPr/>
          </p:nvSpPr>
          <p:spPr>
            <a:xfrm>
              <a:off x="3103198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7" name="Arc 86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88" name="Arc 87"/>
            <p:cNvSpPr/>
            <p:nvPr/>
          </p:nvSpPr>
          <p:spPr>
            <a:xfrm flipV="1">
              <a:off x="3564504" y="2376987"/>
              <a:ext cx="915124" cy="915285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grpSp>
        <p:nvGrpSpPr>
          <p:cNvPr id="14340" name="Group 95"/>
          <p:cNvGrpSpPr>
            <a:grpSpLocks/>
          </p:cNvGrpSpPr>
          <p:nvPr/>
        </p:nvGrpSpPr>
        <p:grpSpPr bwMode="auto">
          <a:xfrm>
            <a:off x="4591050" y="3481388"/>
            <a:ext cx="4513263" cy="3008312"/>
            <a:chOff x="232013" y="464024"/>
            <a:chExt cx="4258100" cy="2838735"/>
          </a:xfrm>
        </p:grpSpPr>
        <p:sp>
          <p:nvSpPr>
            <p:cNvPr id="97" name="Oval 96"/>
            <p:cNvSpPr/>
            <p:nvPr/>
          </p:nvSpPr>
          <p:spPr>
            <a:xfrm>
              <a:off x="497115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98" name="Rectangle 97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99" name="Oval 98"/>
            <p:cNvSpPr/>
            <p:nvPr/>
          </p:nvSpPr>
          <p:spPr>
            <a:xfrm>
              <a:off x="1803152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0" name="Oval 99"/>
            <p:cNvSpPr/>
            <p:nvPr/>
          </p:nvSpPr>
          <p:spPr>
            <a:xfrm>
              <a:off x="3103198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1" name="Oval 100"/>
            <p:cNvSpPr/>
            <p:nvPr/>
          </p:nvSpPr>
          <p:spPr>
            <a:xfrm>
              <a:off x="497115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2" name="Oval 101"/>
            <p:cNvSpPr/>
            <p:nvPr/>
          </p:nvSpPr>
          <p:spPr>
            <a:xfrm>
              <a:off x="1803152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3" name="Oval 102"/>
            <p:cNvSpPr/>
            <p:nvPr/>
          </p:nvSpPr>
          <p:spPr>
            <a:xfrm>
              <a:off x="3103198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4" name="Arc 103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105" name="Arc 104"/>
            <p:cNvSpPr/>
            <p:nvPr/>
          </p:nvSpPr>
          <p:spPr>
            <a:xfrm flipV="1">
              <a:off x="3564504" y="2376987"/>
              <a:ext cx="915124" cy="915287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sp>
        <p:nvSpPr>
          <p:cNvPr id="951" name="TextBox 950"/>
          <p:cNvSpPr txBox="1"/>
          <p:nvPr/>
        </p:nvSpPr>
        <p:spPr>
          <a:xfrm>
            <a:off x="1034041" y="68365"/>
            <a:ext cx="1632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Visual stimuli (CCW) </a:t>
            </a:r>
            <a:endParaRPr lang="en-US" sz="1200" dirty="0"/>
          </a:p>
        </p:txBody>
      </p:sp>
      <p:sp>
        <p:nvSpPr>
          <p:cNvPr id="952" name="TextBox 951"/>
          <p:cNvSpPr txBox="1"/>
          <p:nvPr/>
        </p:nvSpPr>
        <p:spPr>
          <a:xfrm>
            <a:off x="5459338" y="66941"/>
            <a:ext cx="15893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Visual stimuli (CCW)</a:t>
            </a:r>
            <a:endParaRPr lang="en-US" sz="1200" dirty="0"/>
          </a:p>
        </p:txBody>
      </p:sp>
      <p:grpSp>
        <p:nvGrpSpPr>
          <p:cNvPr id="478" name="Group 477"/>
          <p:cNvGrpSpPr/>
          <p:nvPr/>
        </p:nvGrpSpPr>
        <p:grpSpPr>
          <a:xfrm>
            <a:off x="4866873" y="650512"/>
            <a:ext cx="1213161" cy="1209875"/>
            <a:chOff x="4866873" y="650512"/>
            <a:chExt cx="1213161" cy="1209875"/>
          </a:xfrm>
        </p:grpSpPr>
        <p:sp>
          <p:nvSpPr>
            <p:cNvPr id="479" name="Isosceles Triangle 47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0" name="Isosceles Triangle 47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1" name="Isosceles Triangle 48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2" name="Isosceles Triangle 48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83" name="Group 482"/>
          <p:cNvGrpSpPr/>
          <p:nvPr/>
        </p:nvGrpSpPr>
        <p:grpSpPr>
          <a:xfrm>
            <a:off x="6251678" y="651843"/>
            <a:ext cx="1213161" cy="1209875"/>
            <a:chOff x="4866873" y="650512"/>
            <a:chExt cx="1213161" cy="1209875"/>
          </a:xfrm>
        </p:grpSpPr>
        <p:sp>
          <p:nvSpPr>
            <p:cNvPr id="484" name="Isosceles Triangle 48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5" name="Isosceles Triangle 48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6" name="Isosceles Triangle 48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7" name="Isosceles Triangle 48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88" name="Group 487"/>
          <p:cNvGrpSpPr/>
          <p:nvPr/>
        </p:nvGrpSpPr>
        <p:grpSpPr>
          <a:xfrm>
            <a:off x="7635551" y="653733"/>
            <a:ext cx="1213161" cy="1209875"/>
            <a:chOff x="4866873" y="650512"/>
            <a:chExt cx="1213161" cy="1209875"/>
          </a:xfrm>
        </p:grpSpPr>
        <p:sp>
          <p:nvSpPr>
            <p:cNvPr id="489" name="Isosceles Triangle 48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0" name="Isosceles Triangle 48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1" name="Isosceles Triangle 49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2" name="Isosceles Triangle 49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93" name="Group 492"/>
          <p:cNvGrpSpPr/>
          <p:nvPr/>
        </p:nvGrpSpPr>
        <p:grpSpPr>
          <a:xfrm>
            <a:off x="4872038" y="2028825"/>
            <a:ext cx="1213161" cy="1209875"/>
            <a:chOff x="4866873" y="650512"/>
            <a:chExt cx="1213161" cy="1209875"/>
          </a:xfrm>
        </p:grpSpPr>
        <p:sp>
          <p:nvSpPr>
            <p:cNvPr id="494" name="Isosceles Triangle 49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5" name="Isosceles Triangle 49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6" name="Isosceles Triangle 49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7" name="Isosceles Triangle 49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98" name="Group 497"/>
          <p:cNvGrpSpPr/>
          <p:nvPr/>
        </p:nvGrpSpPr>
        <p:grpSpPr>
          <a:xfrm>
            <a:off x="6256338" y="2028477"/>
            <a:ext cx="1213161" cy="1209875"/>
            <a:chOff x="4866873" y="650512"/>
            <a:chExt cx="1213161" cy="1209875"/>
          </a:xfrm>
        </p:grpSpPr>
        <p:sp>
          <p:nvSpPr>
            <p:cNvPr id="499" name="Isosceles Triangle 49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0" name="Isosceles Triangle 49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1" name="Isosceles Triangle 50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2" name="Isosceles Triangle 50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03" name="Group 502"/>
          <p:cNvGrpSpPr/>
          <p:nvPr/>
        </p:nvGrpSpPr>
        <p:grpSpPr>
          <a:xfrm>
            <a:off x="7630802" y="2028955"/>
            <a:ext cx="1213161" cy="1209875"/>
            <a:chOff x="4866873" y="650512"/>
            <a:chExt cx="1213161" cy="1209875"/>
          </a:xfrm>
        </p:grpSpPr>
        <p:sp>
          <p:nvSpPr>
            <p:cNvPr id="504" name="Isosceles Triangle 50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5" name="Isosceles Triangle 50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6" name="Isosceles Triangle 50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7" name="Isosceles Triangle 50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08" name="Group 507"/>
          <p:cNvGrpSpPr/>
          <p:nvPr/>
        </p:nvGrpSpPr>
        <p:grpSpPr>
          <a:xfrm>
            <a:off x="4866873" y="3698974"/>
            <a:ext cx="1213161" cy="1209875"/>
            <a:chOff x="4866873" y="650512"/>
            <a:chExt cx="1213161" cy="1209875"/>
          </a:xfrm>
        </p:grpSpPr>
        <p:sp>
          <p:nvSpPr>
            <p:cNvPr id="509" name="Isosceles Triangle 50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0" name="Isosceles Triangle 50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1" name="Isosceles Triangle 51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2" name="Isosceles Triangle 51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13" name="Group 512"/>
          <p:cNvGrpSpPr/>
          <p:nvPr/>
        </p:nvGrpSpPr>
        <p:grpSpPr>
          <a:xfrm>
            <a:off x="6257060" y="3698974"/>
            <a:ext cx="1213161" cy="1209875"/>
            <a:chOff x="4866873" y="650512"/>
            <a:chExt cx="1213161" cy="1209875"/>
          </a:xfrm>
        </p:grpSpPr>
        <p:sp>
          <p:nvSpPr>
            <p:cNvPr id="514" name="Isosceles Triangle 51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5" name="Isosceles Triangle 51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6" name="Isosceles Triangle 51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7" name="Isosceles Triangle 51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18" name="Group 517"/>
          <p:cNvGrpSpPr/>
          <p:nvPr/>
        </p:nvGrpSpPr>
        <p:grpSpPr>
          <a:xfrm>
            <a:off x="7635551" y="3698974"/>
            <a:ext cx="1213161" cy="1209875"/>
            <a:chOff x="4866873" y="650512"/>
            <a:chExt cx="1213161" cy="1209875"/>
          </a:xfrm>
        </p:grpSpPr>
        <p:sp>
          <p:nvSpPr>
            <p:cNvPr id="519" name="Isosceles Triangle 51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0" name="Isosceles Triangle 51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1" name="Isosceles Triangle 52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2" name="Isosceles Triangle 52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23" name="Group 522"/>
          <p:cNvGrpSpPr/>
          <p:nvPr/>
        </p:nvGrpSpPr>
        <p:grpSpPr>
          <a:xfrm>
            <a:off x="4873223" y="5072063"/>
            <a:ext cx="1213161" cy="1209875"/>
            <a:chOff x="4866873" y="650512"/>
            <a:chExt cx="1213161" cy="1209875"/>
          </a:xfrm>
        </p:grpSpPr>
        <p:sp>
          <p:nvSpPr>
            <p:cNvPr id="524" name="Isosceles Triangle 52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5" name="Isosceles Triangle 52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6" name="Isosceles Triangle 52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7" name="Isosceles Triangle 52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28" name="Group 527"/>
          <p:cNvGrpSpPr/>
          <p:nvPr/>
        </p:nvGrpSpPr>
        <p:grpSpPr>
          <a:xfrm>
            <a:off x="6257060" y="5070820"/>
            <a:ext cx="1213161" cy="1209875"/>
            <a:chOff x="4866873" y="650512"/>
            <a:chExt cx="1213161" cy="1209875"/>
          </a:xfrm>
        </p:grpSpPr>
        <p:sp>
          <p:nvSpPr>
            <p:cNvPr id="529" name="Isosceles Triangle 52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0" name="Isosceles Triangle 52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1" name="Isosceles Triangle 53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2" name="Isosceles Triangle 53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33" name="Group 532"/>
          <p:cNvGrpSpPr/>
          <p:nvPr/>
        </p:nvGrpSpPr>
        <p:grpSpPr>
          <a:xfrm>
            <a:off x="7635551" y="5070472"/>
            <a:ext cx="1213161" cy="1209875"/>
            <a:chOff x="4866873" y="650512"/>
            <a:chExt cx="1213161" cy="1209875"/>
          </a:xfrm>
        </p:grpSpPr>
        <p:sp>
          <p:nvSpPr>
            <p:cNvPr id="534" name="Isosceles Triangle 53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5" name="Isosceles Triangle 53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6" name="Isosceles Triangle 53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7" name="Isosceles Triangle 53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60" name="Group 259"/>
          <p:cNvGrpSpPr/>
          <p:nvPr/>
        </p:nvGrpSpPr>
        <p:grpSpPr>
          <a:xfrm>
            <a:off x="309563" y="653385"/>
            <a:ext cx="1213161" cy="1209875"/>
            <a:chOff x="4866873" y="650512"/>
            <a:chExt cx="1213161" cy="1209875"/>
          </a:xfrm>
        </p:grpSpPr>
        <p:sp>
          <p:nvSpPr>
            <p:cNvPr id="261" name="Isosceles Triangle 260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4" name="Isosceles Triangle 263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7" name="Isosceles Triangle 27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8" name="Isosceles Triangle 27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79" name="Group 278"/>
          <p:cNvGrpSpPr/>
          <p:nvPr/>
        </p:nvGrpSpPr>
        <p:grpSpPr>
          <a:xfrm>
            <a:off x="1678625" y="653733"/>
            <a:ext cx="1213161" cy="1209875"/>
            <a:chOff x="4866873" y="650512"/>
            <a:chExt cx="1213161" cy="1209875"/>
          </a:xfrm>
        </p:grpSpPr>
        <p:sp>
          <p:nvSpPr>
            <p:cNvPr id="280" name="Isosceles Triangle 27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1" name="Isosceles Triangle 28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2" name="Isosceles Triangle 28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3" name="Isosceles Triangle 28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84" name="Group 283"/>
          <p:cNvGrpSpPr/>
          <p:nvPr/>
        </p:nvGrpSpPr>
        <p:grpSpPr>
          <a:xfrm>
            <a:off x="3071813" y="676329"/>
            <a:ext cx="1213161" cy="1209875"/>
            <a:chOff x="4866873" y="650512"/>
            <a:chExt cx="1213161" cy="1209875"/>
          </a:xfrm>
        </p:grpSpPr>
        <p:sp>
          <p:nvSpPr>
            <p:cNvPr id="285" name="Isosceles Triangle 28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6" name="Isosceles Triangle 28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7" name="Isosceles Triangle 28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8" name="Isosceles Triangle 28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89" name="Group 288"/>
          <p:cNvGrpSpPr/>
          <p:nvPr/>
        </p:nvGrpSpPr>
        <p:grpSpPr>
          <a:xfrm>
            <a:off x="307159" y="2030213"/>
            <a:ext cx="1213161" cy="1209875"/>
            <a:chOff x="4866873" y="650512"/>
            <a:chExt cx="1213161" cy="1209875"/>
          </a:xfrm>
        </p:grpSpPr>
        <p:sp>
          <p:nvSpPr>
            <p:cNvPr id="290" name="Isosceles Triangle 28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1" name="Isosceles Triangle 29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2" name="Isosceles Triangle 29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3" name="Isosceles Triangle 29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94" name="Group 293"/>
          <p:cNvGrpSpPr/>
          <p:nvPr/>
        </p:nvGrpSpPr>
        <p:grpSpPr>
          <a:xfrm>
            <a:off x="1676221" y="2030213"/>
            <a:ext cx="1213161" cy="1209875"/>
            <a:chOff x="4866873" y="650512"/>
            <a:chExt cx="1213161" cy="1209875"/>
          </a:xfrm>
        </p:grpSpPr>
        <p:sp>
          <p:nvSpPr>
            <p:cNvPr id="295" name="Isosceles Triangle 29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6" name="Isosceles Triangle 29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7" name="Isosceles Triangle 29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8" name="Isosceles Triangle 29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99" name="Group 298"/>
          <p:cNvGrpSpPr/>
          <p:nvPr/>
        </p:nvGrpSpPr>
        <p:grpSpPr>
          <a:xfrm>
            <a:off x="3071813" y="2012787"/>
            <a:ext cx="1213161" cy="1209875"/>
            <a:chOff x="4866873" y="650512"/>
            <a:chExt cx="1213161" cy="1209875"/>
          </a:xfrm>
        </p:grpSpPr>
        <p:sp>
          <p:nvSpPr>
            <p:cNvPr id="300" name="Isosceles Triangle 29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1" name="Isosceles Triangle 30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2" name="Isosceles Triangle 30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3" name="Isosceles Triangle 30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04" name="Group 303"/>
          <p:cNvGrpSpPr/>
          <p:nvPr/>
        </p:nvGrpSpPr>
        <p:grpSpPr>
          <a:xfrm>
            <a:off x="277161" y="3694113"/>
            <a:ext cx="1213161" cy="1209875"/>
            <a:chOff x="4866873" y="650512"/>
            <a:chExt cx="1213161" cy="1209875"/>
          </a:xfrm>
        </p:grpSpPr>
        <p:sp>
          <p:nvSpPr>
            <p:cNvPr id="305" name="Isosceles Triangle 30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6" name="Isosceles Triangle 30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7" name="Isosceles Triangle 30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8" name="Isosceles Triangle 30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09" name="Group 308"/>
          <p:cNvGrpSpPr/>
          <p:nvPr/>
        </p:nvGrpSpPr>
        <p:grpSpPr>
          <a:xfrm>
            <a:off x="1678625" y="3700263"/>
            <a:ext cx="1213161" cy="1209875"/>
            <a:chOff x="4866873" y="650512"/>
            <a:chExt cx="1213161" cy="1209875"/>
          </a:xfrm>
        </p:grpSpPr>
        <p:sp>
          <p:nvSpPr>
            <p:cNvPr id="310" name="Isosceles Triangle 30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1" name="Isosceles Triangle 31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2" name="Isosceles Triangle 31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3" name="Isosceles Triangle 31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14" name="Group 313"/>
          <p:cNvGrpSpPr/>
          <p:nvPr/>
        </p:nvGrpSpPr>
        <p:grpSpPr>
          <a:xfrm>
            <a:off x="3071813" y="3692871"/>
            <a:ext cx="1213161" cy="1209875"/>
            <a:chOff x="4866873" y="650512"/>
            <a:chExt cx="1213161" cy="1209875"/>
          </a:xfrm>
        </p:grpSpPr>
        <p:sp>
          <p:nvSpPr>
            <p:cNvPr id="315" name="Isosceles Triangle 31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6" name="Isosceles Triangle 31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7" name="Isosceles Triangle 31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8" name="Isosceles Triangle 31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19" name="Group 318"/>
          <p:cNvGrpSpPr/>
          <p:nvPr/>
        </p:nvGrpSpPr>
        <p:grpSpPr>
          <a:xfrm>
            <a:off x="274757" y="5070472"/>
            <a:ext cx="1213161" cy="1209875"/>
            <a:chOff x="4866873" y="650512"/>
            <a:chExt cx="1213161" cy="1209875"/>
          </a:xfrm>
        </p:grpSpPr>
        <p:sp>
          <p:nvSpPr>
            <p:cNvPr id="320" name="Isosceles Triangle 31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1" name="Isosceles Triangle 32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2" name="Isosceles Triangle 32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3" name="Isosceles Triangle 32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24" name="Group 323"/>
          <p:cNvGrpSpPr/>
          <p:nvPr/>
        </p:nvGrpSpPr>
        <p:grpSpPr>
          <a:xfrm>
            <a:off x="1671079" y="5070472"/>
            <a:ext cx="1213161" cy="1209875"/>
            <a:chOff x="4866873" y="650512"/>
            <a:chExt cx="1213161" cy="1209875"/>
          </a:xfrm>
        </p:grpSpPr>
        <p:sp>
          <p:nvSpPr>
            <p:cNvPr id="325" name="Isosceles Triangle 32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6" name="Isosceles Triangle 32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7" name="Isosceles Triangle 32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8" name="Isosceles Triangle 32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29" name="Group 328"/>
          <p:cNvGrpSpPr/>
          <p:nvPr/>
        </p:nvGrpSpPr>
        <p:grpSpPr>
          <a:xfrm>
            <a:off x="3071813" y="5078213"/>
            <a:ext cx="1213161" cy="1209875"/>
            <a:chOff x="4866873" y="650512"/>
            <a:chExt cx="1213161" cy="1209875"/>
          </a:xfrm>
        </p:grpSpPr>
        <p:sp>
          <p:nvSpPr>
            <p:cNvPr id="330" name="Isosceles Triangle 32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1" name="Isosceles Triangle 33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2" name="Isosceles Triangle 33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3" name="Isosceles Triangle 33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64" name="TextBox 163"/>
          <p:cNvSpPr txBox="1"/>
          <p:nvPr/>
        </p:nvSpPr>
        <p:spPr>
          <a:xfrm>
            <a:off x="131884" y="509954"/>
            <a:ext cx="4924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CCW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xmlns="" val="3579121194"/>
      </p:ext>
    </p:extLst>
  </p:cSld>
  <p:clrMapOvr>
    <a:masterClrMapping/>
  </p:clrMapOvr>
  <p:transition advClick="0" advTm="600000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6" dur="5000" fill="hold"/>
                                        <p:tgtEl>
                                          <p:spTgt spid="47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8" dur="5000" fill="hold"/>
                                        <p:tgtEl>
                                          <p:spTgt spid="48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10" dur="5000" fill="hold"/>
                                        <p:tgtEl>
                                          <p:spTgt spid="48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12" dur="5000" fill="hold"/>
                                        <p:tgtEl>
                                          <p:spTgt spid="49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14" dur="5000" fill="hold"/>
                                        <p:tgtEl>
                                          <p:spTgt spid="49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16" dur="5000" fill="hold"/>
                                        <p:tgtEl>
                                          <p:spTgt spid="50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18" dur="5000" fill="hold"/>
                                        <p:tgtEl>
                                          <p:spTgt spid="50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20" dur="5000" fill="hold"/>
                                        <p:tgtEl>
                                          <p:spTgt spid="51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22" dur="5000" fill="hold"/>
                                        <p:tgtEl>
                                          <p:spTgt spid="51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24" dur="5000" fill="hold"/>
                                        <p:tgtEl>
                                          <p:spTgt spid="52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26" dur="5000" fill="hold"/>
                                        <p:tgtEl>
                                          <p:spTgt spid="52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28" dur="5000" fill="hold"/>
                                        <p:tgtEl>
                                          <p:spTgt spid="53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30" dur="5000" fill="hold"/>
                                        <p:tgtEl>
                                          <p:spTgt spid="260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32" dur="5000" fill="hold"/>
                                        <p:tgtEl>
                                          <p:spTgt spid="27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34" dur="5000" fill="hold"/>
                                        <p:tgtEl>
                                          <p:spTgt spid="28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36" dur="5000" fill="hold"/>
                                        <p:tgtEl>
                                          <p:spTgt spid="28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38" dur="5000" fill="hold"/>
                                        <p:tgtEl>
                                          <p:spTgt spid="29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40" dur="5000" fill="hold"/>
                                        <p:tgtEl>
                                          <p:spTgt spid="29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42" dur="5000" fill="hold"/>
                                        <p:tgtEl>
                                          <p:spTgt spid="30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44" dur="5000" fill="hold"/>
                                        <p:tgtEl>
                                          <p:spTgt spid="30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46" dur="5000" fill="hold"/>
                                        <p:tgtEl>
                                          <p:spTgt spid="31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48" dur="5000" fill="hold"/>
                                        <p:tgtEl>
                                          <p:spTgt spid="31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50" dur="5000" fill="hold"/>
                                        <p:tgtEl>
                                          <p:spTgt spid="32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5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52" dur="5000" fill="hold"/>
                                        <p:tgtEl>
                                          <p:spTgt spid="32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337" name="Group 17"/>
          <p:cNvGrpSpPr>
            <a:grpSpLocks/>
          </p:cNvGrpSpPr>
          <p:nvPr/>
        </p:nvGrpSpPr>
        <p:grpSpPr bwMode="auto">
          <a:xfrm>
            <a:off x="28575" y="434975"/>
            <a:ext cx="4513263" cy="3008313"/>
            <a:chOff x="232013" y="464024"/>
            <a:chExt cx="4258100" cy="2838735"/>
          </a:xfrm>
        </p:grpSpPr>
        <p:sp>
          <p:nvSpPr>
            <p:cNvPr id="4" name="Oval 3"/>
            <p:cNvSpPr/>
            <p:nvPr/>
          </p:nvSpPr>
          <p:spPr>
            <a:xfrm>
              <a:off x="497115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" name="Rectangle 9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11" name="Oval 10"/>
            <p:cNvSpPr/>
            <p:nvPr/>
          </p:nvSpPr>
          <p:spPr>
            <a:xfrm>
              <a:off x="1803152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2" name="Oval 11"/>
            <p:cNvSpPr/>
            <p:nvPr/>
          </p:nvSpPr>
          <p:spPr>
            <a:xfrm>
              <a:off x="3103198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3" name="Oval 12"/>
            <p:cNvSpPr/>
            <p:nvPr/>
          </p:nvSpPr>
          <p:spPr>
            <a:xfrm>
              <a:off x="497115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4" name="Oval 13"/>
            <p:cNvSpPr/>
            <p:nvPr/>
          </p:nvSpPr>
          <p:spPr>
            <a:xfrm>
              <a:off x="1803152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5" name="Oval 14"/>
            <p:cNvSpPr/>
            <p:nvPr/>
          </p:nvSpPr>
          <p:spPr>
            <a:xfrm>
              <a:off x="3103198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 dirty="0"/>
            </a:p>
          </p:txBody>
        </p:sp>
        <p:sp>
          <p:nvSpPr>
            <p:cNvPr id="16" name="Arc 15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17" name="Arc 16"/>
            <p:cNvSpPr/>
            <p:nvPr/>
          </p:nvSpPr>
          <p:spPr>
            <a:xfrm flipV="1">
              <a:off x="3564504" y="2376987"/>
              <a:ext cx="915124" cy="915285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grpSp>
        <p:nvGrpSpPr>
          <p:cNvPr id="14338" name="Group 61"/>
          <p:cNvGrpSpPr>
            <a:grpSpLocks/>
          </p:cNvGrpSpPr>
          <p:nvPr/>
        </p:nvGrpSpPr>
        <p:grpSpPr bwMode="auto">
          <a:xfrm>
            <a:off x="4589463" y="438150"/>
            <a:ext cx="4513262" cy="3008313"/>
            <a:chOff x="232013" y="464024"/>
            <a:chExt cx="4258100" cy="2838735"/>
          </a:xfrm>
        </p:grpSpPr>
        <p:sp>
          <p:nvSpPr>
            <p:cNvPr id="63" name="Oval 62"/>
            <p:cNvSpPr/>
            <p:nvPr/>
          </p:nvSpPr>
          <p:spPr>
            <a:xfrm>
              <a:off x="497114" y="664758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4" name="Rectangle 63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65" name="Oval 64"/>
            <p:cNvSpPr/>
            <p:nvPr/>
          </p:nvSpPr>
          <p:spPr>
            <a:xfrm>
              <a:off x="1803151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6" name="Oval 65"/>
            <p:cNvSpPr/>
            <p:nvPr/>
          </p:nvSpPr>
          <p:spPr>
            <a:xfrm>
              <a:off x="3103197" y="664758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7" name="Oval 66"/>
            <p:cNvSpPr/>
            <p:nvPr/>
          </p:nvSpPr>
          <p:spPr>
            <a:xfrm>
              <a:off x="497114" y="1965033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8" name="Oval 67"/>
            <p:cNvSpPr/>
            <p:nvPr/>
          </p:nvSpPr>
          <p:spPr>
            <a:xfrm>
              <a:off x="1803151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9" name="Oval 68"/>
            <p:cNvSpPr/>
            <p:nvPr/>
          </p:nvSpPr>
          <p:spPr>
            <a:xfrm>
              <a:off x="3103197" y="1965033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70" name="Arc 69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71" name="Arc 70"/>
            <p:cNvSpPr/>
            <p:nvPr/>
          </p:nvSpPr>
          <p:spPr>
            <a:xfrm flipV="1">
              <a:off x="3564504" y="2376987"/>
              <a:ext cx="915125" cy="915285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grpSp>
        <p:nvGrpSpPr>
          <p:cNvPr id="14339" name="Group 78"/>
          <p:cNvGrpSpPr>
            <a:grpSpLocks/>
          </p:cNvGrpSpPr>
          <p:nvPr/>
        </p:nvGrpSpPr>
        <p:grpSpPr bwMode="auto">
          <a:xfrm>
            <a:off x="28575" y="3486150"/>
            <a:ext cx="4513263" cy="3008313"/>
            <a:chOff x="232013" y="464024"/>
            <a:chExt cx="4258100" cy="2838735"/>
          </a:xfrm>
        </p:grpSpPr>
        <p:sp>
          <p:nvSpPr>
            <p:cNvPr id="80" name="Oval 79"/>
            <p:cNvSpPr/>
            <p:nvPr/>
          </p:nvSpPr>
          <p:spPr>
            <a:xfrm>
              <a:off x="497115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1" name="Rectangle 80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82" name="Oval 81"/>
            <p:cNvSpPr/>
            <p:nvPr/>
          </p:nvSpPr>
          <p:spPr>
            <a:xfrm>
              <a:off x="1803152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3" name="Oval 82"/>
            <p:cNvSpPr/>
            <p:nvPr/>
          </p:nvSpPr>
          <p:spPr>
            <a:xfrm>
              <a:off x="3103198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4" name="Oval 83"/>
            <p:cNvSpPr/>
            <p:nvPr/>
          </p:nvSpPr>
          <p:spPr>
            <a:xfrm>
              <a:off x="497115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5" name="Oval 84"/>
            <p:cNvSpPr/>
            <p:nvPr/>
          </p:nvSpPr>
          <p:spPr>
            <a:xfrm>
              <a:off x="1803152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6" name="Oval 85"/>
            <p:cNvSpPr/>
            <p:nvPr/>
          </p:nvSpPr>
          <p:spPr>
            <a:xfrm>
              <a:off x="3103198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7" name="Arc 86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88" name="Arc 87"/>
            <p:cNvSpPr/>
            <p:nvPr/>
          </p:nvSpPr>
          <p:spPr>
            <a:xfrm flipV="1">
              <a:off x="3564504" y="2376987"/>
              <a:ext cx="915124" cy="915285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grpSp>
        <p:nvGrpSpPr>
          <p:cNvPr id="14340" name="Group 95"/>
          <p:cNvGrpSpPr>
            <a:grpSpLocks/>
          </p:cNvGrpSpPr>
          <p:nvPr/>
        </p:nvGrpSpPr>
        <p:grpSpPr bwMode="auto">
          <a:xfrm>
            <a:off x="4591050" y="3481388"/>
            <a:ext cx="4513263" cy="3008312"/>
            <a:chOff x="232013" y="464024"/>
            <a:chExt cx="4258100" cy="2838735"/>
          </a:xfrm>
        </p:grpSpPr>
        <p:sp>
          <p:nvSpPr>
            <p:cNvPr id="97" name="Oval 96"/>
            <p:cNvSpPr/>
            <p:nvPr/>
          </p:nvSpPr>
          <p:spPr>
            <a:xfrm>
              <a:off x="497115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98" name="Rectangle 97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99" name="Oval 98"/>
            <p:cNvSpPr/>
            <p:nvPr/>
          </p:nvSpPr>
          <p:spPr>
            <a:xfrm>
              <a:off x="1803152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0" name="Oval 99"/>
            <p:cNvSpPr/>
            <p:nvPr/>
          </p:nvSpPr>
          <p:spPr>
            <a:xfrm>
              <a:off x="3103198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1" name="Oval 100"/>
            <p:cNvSpPr/>
            <p:nvPr/>
          </p:nvSpPr>
          <p:spPr>
            <a:xfrm>
              <a:off x="497115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2" name="Oval 101"/>
            <p:cNvSpPr/>
            <p:nvPr/>
          </p:nvSpPr>
          <p:spPr>
            <a:xfrm>
              <a:off x="1803152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3" name="Oval 102"/>
            <p:cNvSpPr/>
            <p:nvPr/>
          </p:nvSpPr>
          <p:spPr>
            <a:xfrm>
              <a:off x="3103198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4" name="Arc 103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105" name="Arc 104"/>
            <p:cNvSpPr/>
            <p:nvPr/>
          </p:nvSpPr>
          <p:spPr>
            <a:xfrm flipV="1">
              <a:off x="3564504" y="2376987"/>
              <a:ext cx="915124" cy="915287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sp>
        <p:nvSpPr>
          <p:cNvPr id="951" name="TextBox 950"/>
          <p:cNvSpPr txBox="1"/>
          <p:nvPr/>
        </p:nvSpPr>
        <p:spPr>
          <a:xfrm>
            <a:off x="1034041" y="68365"/>
            <a:ext cx="22557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Baseline without visual stimuli </a:t>
            </a:r>
            <a:endParaRPr lang="en-US" sz="1200" dirty="0"/>
          </a:p>
        </p:txBody>
      </p:sp>
      <p:sp>
        <p:nvSpPr>
          <p:cNvPr id="952" name="TextBox 951"/>
          <p:cNvSpPr txBox="1"/>
          <p:nvPr/>
        </p:nvSpPr>
        <p:spPr>
          <a:xfrm>
            <a:off x="5459338" y="66941"/>
            <a:ext cx="22124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Baseline without visual stimuli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xmlns="" val="643098945"/>
      </p:ext>
    </p:extLst>
  </p:cSld>
  <p:clrMapOvr>
    <a:masterClrMapping/>
  </p:clrMapOvr>
  <p:transition advClick="0" advTm="1220000"/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337" name="Group 17"/>
          <p:cNvGrpSpPr>
            <a:grpSpLocks/>
          </p:cNvGrpSpPr>
          <p:nvPr/>
        </p:nvGrpSpPr>
        <p:grpSpPr bwMode="auto">
          <a:xfrm>
            <a:off x="28575" y="434975"/>
            <a:ext cx="4513263" cy="3008313"/>
            <a:chOff x="232013" y="464024"/>
            <a:chExt cx="4258100" cy="2838735"/>
          </a:xfrm>
        </p:grpSpPr>
        <p:sp>
          <p:nvSpPr>
            <p:cNvPr id="4" name="Oval 3"/>
            <p:cNvSpPr/>
            <p:nvPr/>
          </p:nvSpPr>
          <p:spPr>
            <a:xfrm>
              <a:off x="497115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" name="Rectangle 9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11" name="Oval 10"/>
            <p:cNvSpPr/>
            <p:nvPr/>
          </p:nvSpPr>
          <p:spPr>
            <a:xfrm>
              <a:off x="1803152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2" name="Oval 11"/>
            <p:cNvSpPr/>
            <p:nvPr/>
          </p:nvSpPr>
          <p:spPr>
            <a:xfrm>
              <a:off x="3103198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3" name="Oval 12"/>
            <p:cNvSpPr/>
            <p:nvPr/>
          </p:nvSpPr>
          <p:spPr>
            <a:xfrm>
              <a:off x="497115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4" name="Oval 13"/>
            <p:cNvSpPr/>
            <p:nvPr/>
          </p:nvSpPr>
          <p:spPr>
            <a:xfrm>
              <a:off x="1803152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5" name="Oval 14"/>
            <p:cNvSpPr/>
            <p:nvPr/>
          </p:nvSpPr>
          <p:spPr>
            <a:xfrm>
              <a:off x="3103198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 dirty="0"/>
            </a:p>
          </p:txBody>
        </p:sp>
        <p:sp>
          <p:nvSpPr>
            <p:cNvPr id="16" name="Arc 15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17" name="Arc 16"/>
            <p:cNvSpPr/>
            <p:nvPr/>
          </p:nvSpPr>
          <p:spPr>
            <a:xfrm flipV="1">
              <a:off x="3564504" y="2376987"/>
              <a:ext cx="915124" cy="915285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grpSp>
        <p:nvGrpSpPr>
          <p:cNvPr id="14338" name="Group 61"/>
          <p:cNvGrpSpPr>
            <a:grpSpLocks/>
          </p:cNvGrpSpPr>
          <p:nvPr/>
        </p:nvGrpSpPr>
        <p:grpSpPr bwMode="auto">
          <a:xfrm>
            <a:off x="4589463" y="438150"/>
            <a:ext cx="4513262" cy="3008313"/>
            <a:chOff x="232013" y="464024"/>
            <a:chExt cx="4258100" cy="2838735"/>
          </a:xfrm>
        </p:grpSpPr>
        <p:sp>
          <p:nvSpPr>
            <p:cNvPr id="63" name="Oval 62"/>
            <p:cNvSpPr/>
            <p:nvPr/>
          </p:nvSpPr>
          <p:spPr>
            <a:xfrm>
              <a:off x="497114" y="664758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4" name="Rectangle 63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65" name="Oval 64"/>
            <p:cNvSpPr/>
            <p:nvPr/>
          </p:nvSpPr>
          <p:spPr>
            <a:xfrm>
              <a:off x="1803151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6" name="Oval 65"/>
            <p:cNvSpPr/>
            <p:nvPr/>
          </p:nvSpPr>
          <p:spPr>
            <a:xfrm>
              <a:off x="3103197" y="664758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7" name="Oval 66"/>
            <p:cNvSpPr/>
            <p:nvPr/>
          </p:nvSpPr>
          <p:spPr>
            <a:xfrm>
              <a:off x="497114" y="1965033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8" name="Oval 67"/>
            <p:cNvSpPr/>
            <p:nvPr/>
          </p:nvSpPr>
          <p:spPr>
            <a:xfrm>
              <a:off x="1803151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9" name="Oval 68"/>
            <p:cNvSpPr/>
            <p:nvPr/>
          </p:nvSpPr>
          <p:spPr>
            <a:xfrm>
              <a:off x="3103197" y="1965033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70" name="Arc 69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71" name="Arc 70"/>
            <p:cNvSpPr/>
            <p:nvPr/>
          </p:nvSpPr>
          <p:spPr>
            <a:xfrm flipV="1">
              <a:off x="3564504" y="2376987"/>
              <a:ext cx="915125" cy="915285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grpSp>
        <p:nvGrpSpPr>
          <p:cNvPr id="14339" name="Group 78"/>
          <p:cNvGrpSpPr>
            <a:grpSpLocks/>
          </p:cNvGrpSpPr>
          <p:nvPr/>
        </p:nvGrpSpPr>
        <p:grpSpPr bwMode="auto">
          <a:xfrm>
            <a:off x="28575" y="3486150"/>
            <a:ext cx="4513263" cy="3008313"/>
            <a:chOff x="232013" y="464024"/>
            <a:chExt cx="4258100" cy="2838735"/>
          </a:xfrm>
        </p:grpSpPr>
        <p:sp>
          <p:nvSpPr>
            <p:cNvPr id="80" name="Oval 79"/>
            <p:cNvSpPr/>
            <p:nvPr/>
          </p:nvSpPr>
          <p:spPr>
            <a:xfrm>
              <a:off x="497115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1" name="Rectangle 80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82" name="Oval 81"/>
            <p:cNvSpPr/>
            <p:nvPr/>
          </p:nvSpPr>
          <p:spPr>
            <a:xfrm>
              <a:off x="1803152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3" name="Oval 82"/>
            <p:cNvSpPr/>
            <p:nvPr/>
          </p:nvSpPr>
          <p:spPr>
            <a:xfrm>
              <a:off x="3103198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4" name="Oval 83"/>
            <p:cNvSpPr/>
            <p:nvPr/>
          </p:nvSpPr>
          <p:spPr>
            <a:xfrm>
              <a:off x="497115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5" name="Oval 84"/>
            <p:cNvSpPr/>
            <p:nvPr/>
          </p:nvSpPr>
          <p:spPr>
            <a:xfrm>
              <a:off x="1803152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6" name="Oval 85"/>
            <p:cNvSpPr/>
            <p:nvPr/>
          </p:nvSpPr>
          <p:spPr>
            <a:xfrm>
              <a:off x="3103198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7" name="Arc 86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88" name="Arc 87"/>
            <p:cNvSpPr/>
            <p:nvPr/>
          </p:nvSpPr>
          <p:spPr>
            <a:xfrm flipV="1">
              <a:off x="3564504" y="2376987"/>
              <a:ext cx="915124" cy="915285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grpSp>
        <p:nvGrpSpPr>
          <p:cNvPr id="14340" name="Group 95"/>
          <p:cNvGrpSpPr>
            <a:grpSpLocks/>
          </p:cNvGrpSpPr>
          <p:nvPr/>
        </p:nvGrpSpPr>
        <p:grpSpPr bwMode="auto">
          <a:xfrm>
            <a:off x="4591050" y="3481388"/>
            <a:ext cx="4513263" cy="3008312"/>
            <a:chOff x="232013" y="464024"/>
            <a:chExt cx="4258100" cy="2838735"/>
          </a:xfrm>
        </p:grpSpPr>
        <p:sp>
          <p:nvSpPr>
            <p:cNvPr id="97" name="Oval 96"/>
            <p:cNvSpPr/>
            <p:nvPr/>
          </p:nvSpPr>
          <p:spPr>
            <a:xfrm>
              <a:off x="497115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98" name="Rectangle 97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99" name="Oval 98"/>
            <p:cNvSpPr/>
            <p:nvPr/>
          </p:nvSpPr>
          <p:spPr>
            <a:xfrm>
              <a:off x="1803152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0" name="Oval 99"/>
            <p:cNvSpPr/>
            <p:nvPr/>
          </p:nvSpPr>
          <p:spPr>
            <a:xfrm>
              <a:off x="3103198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1" name="Oval 100"/>
            <p:cNvSpPr/>
            <p:nvPr/>
          </p:nvSpPr>
          <p:spPr>
            <a:xfrm>
              <a:off x="497115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2" name="Oval 101"/>
            <p:cNvSpPr/>
            <p:nvPr/>
          </p:nvSpPr>
          <p:spPr>
            <a:xfrm>
              <a:off x="1803152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3" name="Oval 102"/>
            <p:cNvSpPr/>
            <p:nvPr/>
          </p:nvSpPr>
          <p:spPr>
            <a:xfrm>
              <a:off x="3103198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4" name="Arc 103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105" name="Arc 104"/>
            <p:cNvSpPr/>
            <p:nvPr/>
          </p:nvSpPr>
          <p:spPr>
            <a:xfrm flipV="1">
              <a:off x="3564504" y="2376987"/>
              <a:ext cx="915124" cy="915287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sp>
        <p:nvSpPr>
          <p:cNvPr id="951" name="TextBox 950"/>
          <p:cNvSpPr txBox="1"/>
          <p:nvPr/>
        </p:nvSpPr>
        <p:spPr>
          <a:xfrm>
            <a:off x="1034041" y="68365"/>
            <a:ext cx="15220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Visual stimuli (CW) </a:t>
            </a:r>
            <a:endParaRPr lang="en-US" sz="1200" dirty="0"/>
          </a:p>
        </p:txBody>
      </p:sp>
      <p:sp>
        <p:nvSpPr>
          <p:cNvPr id="952" name="TextBox 951"/>
          <p:cNvSpPr txBox="1"/>
          <p:nvPr/>
        </p:nvSpPr>
        <p:spPr>
          <a:xfrm>
            <a:off x="5459338" y="66941"/>
            <a:ext cx="14787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Visual stimuli (CW)</a:t>
            </a:r>
            <a:endParaRPr lang="en-US" sz="1200" dirty="0"/>
          </a:p>
        </p:txBody>
      </p:sp>
      <p:grpSp>
        <p:nvGrpSpPr>
          <p:cNvPr id="478" name="Group 477"/>
          <p:cNvGrpSpPr/>
          <p:nvPr/>
        </p:nvGrpSpPr>
        <p:grpSpPr>
          <a:xfrm>
            <a:off x="4866873" y="650512"/>
            <a:ext cx="1213161" cy="1209875"/>
            <a:chOff x="4866873" y="650512"/>
            <a:chExt cx="1213161" cy="1209875"/>
          </a:xfrm>
        </p:grpSpPr>
        <p:sp>
          <p:nvSpPr>
            <p:cNvPr id="479" name="Isosceles Triangle 47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0" name="Isosceles Triangle 47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1" name="Isosceles Triangle 48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2" name="Isosceles Triangle 48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83" name="Group 482"/>
          <p:cNvGrpSpPr/>
          <p:nvPr/>
        </p:nvGrpSpPr>
        <p:grpSpPr>
          <a:xfrm>
            <a:off x="6251678" y="651843"/>
            <a:ext cx="1213161" cy="1209875"/>
            <a:chOff x="4866873" y="650512"/>
            <a:chExt cx="1213161" cy="1209875"/>
          </a:xfrm>
        </p:grpSpPr>
        <p:sp>
          <p:nvSpPr>
            <p:cNvPr id="484" name="Isosceles Triangle 48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5" name="Isosceles Triangle 48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6" name="Isosceles Triangle 48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7" name="Isosceles Triangle 48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88" name="Group 487"/>
          <p:cNvGrpSpPr/>
          <p:nvPr/>
        </p:nvGrpSpPr>
        <p:grpSpPr>
          <a:xfrm>
            <a:off x="7635551" y="653733"/>
            <a:ext cx="1213161" cy="1209875"/>
            <a:chOff x="4866873" y="650512"/>
            <a:chExt cx="1213161" cy="1209875"/>
          </a:xfrm>
        </p:grpSpPr>
        <p:sp>
          <p:nvSpPr>
            <p:cNvPr id="489" name="Isosceles Triangle 48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0" name="Isosceles Triangle 48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1" name="Isosceles Triangle 49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2" name="Isosceles Triangle 49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93" name="Group 492"/>
          <p:cNvGrpSpPr/>
          <p:nvPr/>
        </p:nvGrpSpPr>
        <p:grpSpPr>
          <a:xfrm>
            <a:off x="4872038" y="2028825"/>
            <a:ext cx="1213161" cy="1209875"/>
            <a:chOff x="4866873" y="650512"/>
            <a:chExt cx="1213161" cy="1209875"/>
          </a:xfrm>
        </p:grpSpPr>
        <p:sp>
          <p:nvSpPr>
            <p:cNvPr id="494" name="Isosceles Triangle 49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5" name="Isosceles Triangle 49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6" name="Isosceles Triangle 49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7" name="Isosceles Triangle 49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98" name="Group 497"/>
          <p:cNvGrpSpPr/>
          <p:nvPr/>
        </p:nvGrpSpPr>
        <p:grpSpPr>
          <a:xfrm>
            <a:off x="6256338" y="2028477"/>
            <a:ext cx="1213161" cy="1209875"/>
            <a:chOff x="4866873" y="650512"/>
            <a:chExt cx="1213161" cy="1209875"/>
          </a:xfrm>
        </p:grpSpPr>
        <p:sp>
          <p:nvSpPr>
            <p:cNvPr id="499" name="Isosceles Triangle 49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0" name="Isosceles Triangle 49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1" name="Isosceles Triangle 50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2" name="Isosceles Triangle 50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03" name="Group 502"/>
          <p:cNvGrpSpPr/>
          <p:nvPr/>
        </p:nvGrpSpPr>
        <p:grpSpPr>
          <a:xfrm>
            <a:off x="7630802" y="2028955"/>
            <a:ext cx="1213161" cy="1209875"/>
            <a:chOff x="4866873" y="650512"/>
            <a:chExt cx="1213161" cy="1209875"/>
          </a:xfrm>
        </p:grpSpPr>
        <p:sp>
          <p:nvSpPr>
            <p:cNvPr id="504" name="Isosceles Triangle 50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5" name="Isosceles Triangle 50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6" name="Isosceles Triangle 50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7" name="Isosceles Triangle 50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08" name="Group 507"/>
          <p:cNvGrpSpPr/>
          <p:nvPr/>
        </p:nvGrpSpPr>
        <p:grpSpPr>
          <a:xfrm>
            <a:off x="4866873" y="3698974"/>
            <a:ext cx="1213161" cy="1209875"/>
            <a:chOff x="4866873" y="650512"/>
            <a:chExt cx="1213161" cy="1209875"/>
          </a:xfrm>
        </p:grpSpPr>
        <p:sp>
          <p:nvSpPr>
            <p:cNvPr id="509" name="Isosceles Triangle 50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0" name="Isosceles Triangle 50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1" name="Isosceles Triangle 51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2" name="Isosceles Triangle 51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13" name="Group 512"/>
          <p:cNvGrpSpPr/>
          <p:nvPr/>
        </p:nvGrpSpPr>
        <p:grpSpPr>
          <a:xfrm>
            <a:off x="6257060" y="3698974"/>
            <a:ext cx="1213161" cy="1209875"/>
            <a:chOff x="4866873" y="650512"/>
            <a:chExt cx="1213161" cy="1209875"/>
          </a:xfrm>
        </p:grpSpPr>
        <p:sp>
          <p:nvSpPr>
            <p:cNvPr id="514" name="Isosceles Triangle 51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5" name="Isosceles Triangle 51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6" name="Isosceles Triangle 51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7" name="Isosceles Triangle 51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18" name="Group 517"/>
          <p:cNvGrpSpPr/>
          <p:nvPr/>
        </p:nvGrpSpPr>
        <p:grpSpPr>
          <a:xfrm>
            <a:off x="7635551" y="3698974"/>
            <a:ext cx="1213161" cy="1209875"/>
            <a:chOff x="4866873" y="650512"/>
            <a:chExt cx="1213161" cy="1209875"/>
          </a:xfrm>
        </p:grpSpPr>
        <p:sp>
          <p:nvSpPr>
            <p:cNvPr id="519" name="Isosceles Triangle 51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0" name="Isosceles Triangle 51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1" name="Isosceles Triangle 52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2" name="Isosceles Triangle 52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23" name="Group 522"/>
          <p:cNvGrpSpPr/>
          <p:nvPr/>
        </p:nvGrpSpPr>
        <p:grpSpPr>
          <a:xfrm>
            <a:off x="4873223" y="5072063"/>
            <a:ext cx="1213161" cy="1209875"/>
            <a:chOff x="4866873" y="650512"/>
            <a:chExt cx="1213161" cy="1209875"/>
          </a:xfrm>
        </p:grpSpPr>
        <p:sp>
          <p:nvSpPr>
            <p:cNvPr id="524" name="Isosceles Triangle 52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5" name="Isosceles Triangle 52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6" name="Isosceles Triangle 52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7" name="Isosceles Triangle 52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28" name="Group 527"/>
          <p:cNvGrpSpPr/>
          <p:nvPr/>
        </p:nvGrpSpPr>
        <p:grpSpPr>
          <a:xfrm>
            <a:off x="6257060" y="5070820"/>
            <a:ext cx="1213161" cy="1209875"/>
            <a:chOff x="4866873" y="650512"/>
            <a:chExt cx="1213161" cy="1209875"/>
          </a:xfrm>
        </p:grpSpPr>
        <p:sp>
          <p:nvSpPr>
            <p:cNvPr id="529" name="Isosceles Triangle 52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0" name="Isosceles Triangle 52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1" name="Isosceles Triangle 53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2" name="Isosceles Triangle 53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33" name="Group 532"/>
          <p:cNvGrpSpPr/>
          <p:nvPr/>
        </p:nvGrpSpPr>
        <p:grpSpPr>
          <a:xfrm>
            <a:off x="7635551" y="5070472"/>
            <a:ext cx="1213161" cy="1209875"/>
            <a:chOff x="4866873" y="650512"/>
            <a:chExt cx="1213161" cy="1209875"/>
          </a:xfrm>
        </p:grpSpPr>
        <p:sp>
          <p:nvSpPr>
            <p:cNvPr id="534" name="Isosceles Triangle 53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5" name="Isosceles Triangle 53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6" name="Isosceles Triangle 53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7" name="Isosceles Triangle 53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60" name="Group 259"/>
          <p:cNvGrpSpPr/>
          <p:nvPr/>
        </p:nvGrpSpPr>
        <p:grpSpPr>
          <a:xfrm>
            <a:off x="309563" y="653385"/>
            <a:ext cx="1213161" cy="1209875"/>
            <a:chOff x="4866873" y="650512"/>
            <a:chExt cx="1213161" cy="1209875"/>
          </a:xfrm>
        </p:grpSpPr>
        <p:sp>
          <p:nvSpPr>
            <p:cNvPr id="261" name="Isosceles Triangle 260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4" name="Isosceles Triangle 263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7" name="Isosceles Triangle 27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8" name="Isosceles Triangle 27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79" name="Group 278"/>
          <p:cNvGrpSpPr/>
          <p:nvPr/>
        </p:nvGrpSpPr>
        <p:grpSpPr>
          <a:xfrm>
            <a:off x="1678625" y="653733"/>
            <a:ext cx="1213161" cy="1209875"/>
            <a:chOff x="4866873" y="650512"/>
            <a:chExt cx="1213161" cy="1209875"/>
          </a:xfrm>
        </p:grpSpPr>
        <p:sp>
          <p:nvSpPr>
            <p:cNvPr id="280" name="Isosceles Triangle 27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1" name="Isosceles Triangle 28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2" name="Isosceles Triangle 28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3" name="Isosceles Triangle 28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84" name="Group 283"/>
          <p:cNvGrpSpPr/>
          <p:nvPr/>
        </p:nvGrpSpPr>
        <p:grpSpPr>
          <a:xfrm>
            <a:off x="3071813" y="676329"/>
            <a:ext cx="1213161" cy="1209875"/>
            <a:chOff x="4866873" y="650512"/>
            <a:chExt cx="1213161" cy="1209875"/>
          </a:xfrm>
        </p:grpSpPr>
        <p:sp>
          <p:nvSpPr>
            <p:cNvPr id="285" name="Isosceles Triangle 28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6" name="Isosceles Triangle 28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7" name="Isosceles Triangle 28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8" name="Isosceles Triangle 28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89" name="Group 288"/>
          <p:cNvGrpSpPr/>
          <p:nvPr/>
        </p:nvGrpSpPr>
        <p:grpSpPr>
          <a:xfrm>
            <a:off x="307159" y="2030213"/>
            <a:ext cx="1213161" cy="1209875"/>
            <a:chOff x="4866873" y="650512"/>
            <a:chExt cx="1213161" cy="1209875"/>
          </a:xfrm>
        </p:grpSpPr>
        <p:sp>
          <p:nvSpPr>
            <p:cNvPr id="290" name="Isosceles Triangle 28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1" name="Isosceles Triangle 29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2" name="Isosceles Triangle 29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3" name="Isosceles Triangle 29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94" name="Group 293"/>
          <p:cNvGrpSpPr/>
          <p:nvPr/>
        </p:nvGrpSpPr>
        <p:grpSpPr>
          <a:xfrm>
            <a:off x="1676221" y="2030213"/>
            <a:ext cx="1213161" cy="1209875"/>
            <a:chOff x="4866873" y="650512"/>
            <a:chExt cx="1213161" cy="1209875"/>
          </a:xfrm>
        </p:grpSpPr>
        <p:sp>
          <p:nvSpPr>
            <p:cNvPr id="295" name="Isosceles Triangle 29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6" name="Isosceles Triangle 29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7" name="Isosceles Triangle 29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8" name="Isosceles Triangle 29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99" name="Group 298"/>
          <p:cNvGrpSpPr/>
          <p:nvPr/>
        </p:nvGrpSpPr>
        <p:grpSpPr>
          <a:xfrm>
            <a:off x="3071813" y="2012787"/>
            <a:ext cx="1213161" cy="1209875"/>
            <a:chOff x="4866873" y="650512"/>
            <a:chExt cx="1213161" cy="1209875"/>
          </a:xfrm>
        </p:grpSpPr>
        <p:sp>
          <p:nvSpPr>
            <p:cNvPr id="300" name="Isosceles Triangle 29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1" name="Isosceles Triangle 30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2" name="Isosceles Triangle 30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3" name="Isosceles Triangle 30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04" name="Group 303"/>
          <p:cNvGrpSpPr/>
          <p:nvPr/>
        </p:nvGrpSpPr>
        <p:grpSpPr>
          <a:xfrm>
            <a:off x="277161" y="3694113"/>
            <a:ext cx="1213161" cy="1209875"/>
            <a:chOff x="4866873" y="650512"/>
            <a:chExt cx="1213161" cy="1209875"/>
          </a:xfrm>
        </p:grpSpPr>
        <p:sp>
          <p:nvSpPr>
            <p:cNvPr id="305" name="Isosceles Triangle 30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6" name="Isosceles Triangle 30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7" name="Isosceles Triangle 30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8" name="Isosceles Triangle 30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09" name="Group 308"/>
          <p:cNvGrpSpPr/>
          <p:nvPr/>
        </p:nvGrpSpPr>
        <p:grpSpPr>
          <a:xfrm>
            <a:off x="1678625" y="3700263"/>
            <a:ext cx="1213161" cy="1209875"/>
            <a:chOff x="4866873" y="650512"/>
            <a:chExt cx="1213161" cy="1209875"/>
          </a:xfrm>
        </p:grpSpPr>
        <p:sp>
          <p:nvSpPr>
            <p:cNvPr id="310" name="Isosceles Triangle 30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1" name="Isosceles Triangle 31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2" name="Isosceles Triangle 31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3" name="Isosceles Triangle 31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14" name="Group 313"/>
          <p:cNvGrpSpPr/>
          <p:nvPr/>
        </p:nvGrpSpPr>
        <p:grpSpPr>
          <a:xfrm>
            <a:off x="3071813" y="3692871"/>
            <a:ext cx="1213161" cy="1209875"/>
            <a:chOff x="4866873" y="650512"/>
            <a:chExt cx="1213161" cy="1209875"/>
          </a:xfrm>
        </p:grpSpPr>
        <p:sp>
          <p:nvSpPr>
            <p:cNvPr id="315" name="Isosceles Triangle 31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6" name="Isosceles Triangle 31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7" name="Isosceles Triangle 31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8" name="Isosceles Triangle 31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19" name="Group 318"/>
          <p:cNvGrpSpPr/>
          <p:nvPr/>
        </p:nvGrpSpPr>
        <p:grpSpPr>
          <a:xfrm>
            <a:off x="274757" y="5070472"/>
            <a:ext cx="1213161" cy="1209875"/>
            <a:chOff x="4866873" y="650512"/>
            <a:chExt cx="1213161" cy="1209875"/>
          </a:xfrm>
        </p:grpSpPr>
        <p:sp>
          <p:nvSpPr>
            <p:cNvPr id="320" name="Isosceles Triangle 31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1" name="Isosceles Triangle 32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2" name="Isosceles Triangle 32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3" name="Isosceles Triangle 32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24" name="Group 323"/>
          <p:cNvGrpSpPr/>
          <p:nvPr/>
        </p:nvGrpSpPr>
        <p:grpSpPr>
          <a:xfrm>
            <a:off x="1671079" y="5070472"/>
            <a:ext cx="1213161" cy="1209875"/>
            <a:chOff x="4866873" y="650512"/>
            <a:chExt cx="1213161" cy="1209875"/>
          </a:xfrm>
        </p:grpSpPr>
        <p:sp>
          <p:nvSpPr>
            <p:cNvPr id="325" name="Isosceles Triangle 32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6" name="Isosceles Triangle 32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7" name="Isosceles Triangle 32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8" name="Isosceles Triangle 32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29" name="Group 328"/>
          <p:cNvGrpSpPr/>
          <p:nvPr/>
        </p:nvGrpSpPr>
        <p:grpSpPr>
          <a:xfrm>
            <a:off x="3071813" y="5078213"/>
            <a:ext cx="1213161" cy="1209875"/>
            <a:chOff x="4866873" y="650512"/>
            <a:chExt cx="1213161" cy="1209875"/>
          </a:xfrm>
        </p:grpSpPr>
        <p:sp>
          <p:nvSpPr>
            <p:cNvPr id="330" name="Isosceles Triangle 32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1" name="Isosceles Triangle 33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2" name="Isosceles Triangle 33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3" name="Isosceles Triangle 33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64" name="TextBox 163"/>
          <p:cNvSpPr txBox="1"/>
          <p:nvPr/>
        </p:nvSpPr>
        <p:spPr>
          <a:xfrm>
            <a:off x="131884" y="509954"/>
            <a:ext cx="3994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CW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xmlns="" val="3357265787"/>
      </p:ext>
    </p:extLst>
  </p:cSld>
  <p:clrMapOvr>
    <a:masterClrMapping/>
  </p:clrMapOvr>
  <p:transition advClick="0" advTm="600000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6" dur="5000" fill="hold"/>
                                        <p:tgtEl>
                                          <p:spTgt spid="47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8" dur="5000" fill="hold"/>
                                        <p:tgtEl>
                                          <p:spTgt spid="48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10" dur="5000" fill="hold"/>
                                        <p:tgtEl>
                                          <p:spTgt spid="48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12" dur="5000" fill="hold"/>
                                        <p:tgtEl>
                                          <p:spTgt spid="49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14" dur="5000" fill="hold"/>
                                        <p:tgtEl>
                                          <p:spTgt spid="49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16" dur="5000" fill="hold"/>
                                        <p:tgtEl>
                                          <p:spTgt spid="50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18" dur="5000" fill="hold"/>
                                        <p:tgtEl>
                                          <p:spTgt spid="50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20" dur="5000" fill="hold"/>
                                        <p:tgtEl>
                                          <p:spTgt spid="51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22" dur="5000" fill="hold"/>
                                        <p:tgtEl>
                                          <p:spTgt spid="51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24" dur="5000" fill="hold"/>
                                        <p:tgtEl>
                                          <p:spTgt spid="52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26" dur="5000" fill="hold"/>
                                        <p:tgtEl>
                                          <p:spTgt spid="52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28" dur="5000" fill="hold"/>
                                        <p:tgtEl>
                                          <p:spTgt spid="53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30" dur="5000" fill="hold"/>
                                        <p:tgtEl>
                                          <p:spTgt spid="260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32" dur="5000" fill="hold"/>
                                        <p:tgtEl>
                                          <p:spTgt spid="27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34" dur="5000" fill="hold"/>
                                        <p:tgtEl>
                                          <p:spTgt spid="28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36" dur="5000" fill="hold"/>
                                        <p:tgtEl>
                                          <p:spTgt spid="28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38" dur="5000" fill="hold"/>
                                        <p:tgtEl>
                                          <p:spTgt spid="29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40" dur="5000" fill="hold"/>
                                        <p:tgtEl>
                                          <p:spTgt spid="29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42" dur="5000" fill="hold"/>
                                        <p:tgtEl>
                                          <p:spTgt spid="30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44" dur="5000" fill="hold"/>
                                        <p:tgtEl>
                                          <p:spTgt spid="30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46" dur="5000" fill="hold"/>
                                        <p:tgtEl>
                                          <p:spTgt spid="31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48" dur="5000" fill="hold"/>
                                        <p:tgtEl>
                                          <p:spTgt spid="31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50" dur="5000" fill="hold"/>
                                        <p:tgtEl>
                                          <p:spTgt spid="32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5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52" dur="5000" fill="hold"/>
                                        <p:tgtEl>
                                          <p:spTgt spid="32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337" name="Group 17"/>
          <p:cNvGrpSpPr>
            <a:grpSpLocks/>
          </p:cNvGrpSpPr>
          <p:nvPr/>
        </p:nvGrpSpPr>
        <p:grpSpPr bwMode="auto">
          <a:xfrm>
            <a:off x="28575" y="434975"/>
            <a:ext cx="4513263" cy="3008313"/>
            <a:chOff x="232013" y="464024"/>
            <a:chExt cx="4258100" cy="2838735"/>
          </a:xfrm>
        </p:grpSpPr>
        <p:sp>
          <p:nvSpPr>
            <p:cNvPr id="4" name="Oval 3"/>
            <p:cNvSpPr/>
            <p:nvPr/>
          </p:nvSpPr>
          <p:spPr>
            <a:xfrm>
              <a:off x="497115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" name="Rectangle 9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11" name="Oval 10"/>
            <p:cNvSpPr/>
            <p:nvPr/>
          </p:nvSpPr>
          <p:spPr>
            <a:xfrm>
              <a:off x="1803152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2" name="Oval 11"/>
            <p:cNvSpPr/>
            <p:nvPr/>
          </p:nvSpPr>
          <p:spPr>
            <a:xfrm>
              <a:off x="3103198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3" name="Oval 12"/>
            <p:cNvSpPr/>
            <p:nvPr/>
          </p:nvSpPr>
          <p:spPr>
            <a:xfrm>
              <a:off x="497115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4" name="Oval 13"/>
            <p:cNvSpPr/>
            <p:nvPr/>
          </p:nvSpPr>
          <p:spPr>
            <a:xfrm>
              <a:off x="1803152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5" name="Oval 14"/>
            <p:cNvSpPr/>
            <p:nvPr/>
          </p:nvSpPr>
          <p:spPr>
            <a:xfrm>
              <a:off x="3103198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 dirty="0"/>
            </a:p>
          </p:txBody>
        </p:sp>
        <p:sp>
          <p:nvSpPr>
            <p:cNvPr id="16" name="Arc 15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17" name="Arc 16"/>
            <p:cNvSpPr/>
            <p:nvPr/>
          </p:nvSpPr>
          <p:spPr>
            <a:xfrm flipV="1">
              <a:off x="3564504" y="2376987"/>
              <a:ext cx="915124" cy="915285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grpSp>
        <p:nvGrpSpPr>
          <p:cNvPr id="14338" name="Group 61"/>
          <p:cNvGrpSpPr>
            <a:grpSpLocks/>
          </p:cNvGrpSpPr>
          <p:nvPr/>
        </p:nvGrpSpPr>
        <p:grpSpPr bwMode="auto">
          <a:xfrm>
            <a:off x="4589463" y="438150"/>
            <a:ext cx="4513262" cy="3008313"/>
            <a:chOff x="232013" y="464024"/>
            <a:chExt cx="4258100" cy="2838735"/>
          </a:xfrm>
        </p:grpSpPr>
        <p:sp>
          <p:nvSpPr>
            <p:cNvPr id="63" name="Oval 62"/>
            <p:cNvSpPr/>
            <p:nvPr/>
          </p:nvSpPr>
          <p:spPr>
            <a:xfrm>
              <a:off x="497114" y="664758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4" name="Rectangle 63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65" name="Oval 64"/>
            <p:cNvSpPr/>
            <p:nvPr/>
          </p:nvSpPr>
          <p:spPr>
            <a:xfrm>
              <a:off x="1803151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6" name="Oval 65"/>
            <p:cNvSpPr/>
            <p:nvPr/>
          </p:nvSpPr>
          <p:spPr>
            <a:xfrm>
              <a:off x="3103197" y="664758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7" name="Oval 66"/>
            <p:cNvSpPr/>
            <p:nvPr/>
          </p:nvSpPr>
          <p:spPr>
            <a:xfrm>
              <a:off x="497114" y="1965033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8" name="Oval 67"/>
            <p:cNvSpPr/>
            <p:nvPr/>
          </p:nvSpPr>
          <p:spPr>
            <a:xfrm>
              <a:off x="1803151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9" name="Oval 68"/>
            <p:cNvSpPr/>
            <p:nvPr/>
          </p:nvSpPr>
          <p:spPr>
            <a:xfrm>
              <a:off x="3103197" y="1965033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70" name="Arc 69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71" name="Arc 70"/>
            <p:cNvSpPr/>
            <p:nvPr/>
          </p:nvSpPr>
          <p:spPr>
            <a:xfrm flipV="1">
              <a:off x="3564504" y="2376987"/>
              <a:ext cx="915125" cy="915285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grpSp>
        <p:nvGrpSpPr>
          <p:cNvPr id="14339" name="Group 78"/>
          <p:cNvGrpSpPr>
            <a:grpSpLocks/>
          </p:cNvGrpSpPr>
          <p:nvPr/>
        </p:nvGrpSpPr>
        <p:grpSpPr bwMode="auto">
          <a:xfrm>
            <a:off x="28575" y="3486150"/>
            <a:ext cx="4513263" cy="3008313"/>
            <a:chOff x="232013" y="464024"/>
            <a:chExt cx="4258100" cy="2838735"/>
          </a:xfrm>
        </p:grpSpPr>
        <p:sp>
          <p:nvSpPr>
            <p:cNvPr id="80" name="Oval 79"/>
            <p:cNvSpPr/>
            <p:nvPr/>
          </p:nvSpPr>
          <p:spPr>
            <a:xfrm>
              <a:off x="497115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1" name="Rectangle 80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82" name="Oval 81"/>
            <p:cNvSpPr/>
            <p:nvPr/>
          </p:nvSpPr>
          <p:spPr>
            <a:xfrm>
              <a:off x="1803152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3" name="Oval 82"/>
            <p:cNvSpPr/>
            <p:nvPr/>
          </p:nvSpPr>
          <p:spPr>
            <a:xfrm>
              <a:off x="3103198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4" name="Oval 83"/>
            <p:cNvSpPr/>
            <p:nvPr/>
          </p:nvSpPr>
          <p:spPr>
            <a:xfrm>
              <a:off x="497115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5" name="Oval 84"/>
            <p:cNvSpPr/>
            <p:nvPr/>
          </p:nvSpPr>
          <p:spPr>
            <a:xfrm>
              <a:off x="1803152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6" name="Oval 85"/>
            <p:cNvSpPr/>
            <p:nvPr/>
          </p:nvSpPr>
          <p:spPr>
            <a:xfrm>
              <a:off x="3103198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7" name="Arc 86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88" name="Arc 87"/>
            <p:cNvSpPr/>
            <p:nvPr/>
          </p:nvSpPr>
          <p:spPr>
            <a:xfrm flipV="1">
              <a:off x="3564504" y="2376987"/>
              <a:ext cx="915124" cy="915285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grpSp>
        <p:nvGrpSpPr>
          <p:cNvPr id="14340" name="Group 95"/>
          <p:cNvGrpSpPr>
            <a:grpSpLocks/>
          </p:cNvGrpSpPr>
          <p:nvPr/>
        </p:nvGrpSpPr>
        <p:grpSpPr bwMode="auto">
          <a:xfrm>
            <a:off x="4591050" y="3481388"/>
            <a:ext cx="4513263" cy="3008312"/>
            <a:chOff x="232013" y="464024"/>
            <a:chExt cx="4258100" cy="2838735"/>
          </a:xfrm>
        </p:grpSpPr>
        <p:sp>
          <p:nvSpPr>
            <p:cNvPr id="97" name="Oval 96"/>
            <p:cNvSpPr/>
            <p:nvPr/>
          </p:nvSpPr>
          <p:spPr>
            <a:xfrm>
              <a:off x="497115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98" name="Rectangle 97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99" name="Oval 98"/>
            <p:cNvSpPr/>
            <p:nvPr/>
          </p:nvSpPr>
          <p:spPr>
            <a:xfrm>
              <a:off x="1803152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0" name="Oval 99"/>
            <p:cNvSpPr/>
            <p:nvPr/>
          </p:nvSpPr>
          <p:spPr>
            <a:xfrm>
              <a:off x="3103198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1" name="Oval 100"/>
            <p:cNvSpPr/>
            <p:nvPr/>
          </p:nvSpPr>
          <p:spPr>
            <a:xfrm>
              <a:off x="497115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2" name="Oval 101"/>
            <p:cNvSpPr/>
            <p:nvPr/>
          </p:nvSpPr>
          <p:spPr>
            <a:xfrm>
              <a:off x="1803152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3" name="Oval 102"/>
            <p:cNvSpPr/>
            <p:nvPr/>
          </p:nvSpPr>
          <p:spPr>
            <a:xfrm>
              <a:off x="3103198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4" name="Arc 103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105" name="Arc 104"/>
            <p:cNvSpPr/>
            <p:nvPr/>
          </p:nvSpPr>
          <p:spPr>
            <a:xfrm flipV="1">
              <a:off x="3564504" y="2376987"/>
              <a:ext cx="915124" cy="915287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sp>
        <p:nvSpPr>
          <p:cNvPr id="951" name="TextBox 950"/>
          <p:cNvSpPr txBox="1"/>
          <p:nvPr/>
        </p:nvSpPr>
        <p:spPr>
          <a:xfrm>
            <a:off x="1034041" y="68365"/>
            <a:ext cx="1632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Visual stimuli (CCW) </a:t>
            </a:r>
            <a:endParaRPr lang="en-US" sz="1200" dirty="0"/>
          </a:p>
        </p:txBody>
      </p:sp>
      <p:sp>
        <p:nvSpPr>
          <p:cNvPr id="952" name="TextBox 951"/>
          <p:cNvSpPr txBox="1"/>
          <p:nvPr/>
        </p:nvSpPr>
        <p:spPr>
          <a:xfrm>
            <a:off x="5459338" y="66941"/>
            <a:ext cx="15893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Visual stimuli (CCW)</a:t>
            </a:r>
            <a:endParaRPr lang="en-US" sz="1200" dirty="0"/>
          </a:p>
        </p:txBody>
      </p:sp>
      <p:grpSp>
        <p:nvGrpSpPr>
          <p:cNvPr id="478" name="Group 477"/>
          <p:cNvGrpSpPr/>
          <p:nvPr/>
        </p:nvGrpSpPr>
        <p:grpSpPr>
          <a:xfrm>
            <a:off x="4866873" y="650512"/>
            <a:ext cx="1213161" cy="1209875"/>
            <a:chOff x="4866873" y="650512"/>
            <a:chExt cx="1213161" cy="1209875"/>
          </a:xfrm>
        </p:grpSpPr>
        <p:sp>
          <p:nvSpPr>
            <p:cNvPr id="479" name="Isosceles Triangle 47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0" name="Isosceles Triangle 47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1" name="Isosceles Triangle 48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2" name="Isosceles Triangle 48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83" name="Group 482"/>
          <p:cNvGrpSpPr/>
          <p:nvPr/>
        </p:nvGrpSpPr>
        <p:grpSpPr>
          <a:xfrm>
            <a:off x="6251678" y="651843"/>
            <a:ext cx="1213161" cy="1209875"/>
            <a:chOff x="4866873" y="650512"/>
            <a:chExt cx="1213161" cy="1209875"/>
          </a:xfrm>
        </p:grpSpPr>
        <p:sp>
          <p:nvSpPr>
            <p:cNvPr id="484" name="Isosceles Triangle 48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5" name="Isosceles Triangle 48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6" name="Isosceles Triangle 48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7" name="Isosceles Triangle 48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88" name="Group 487"/>
          <p:cNvGrpSpPr/>
          <p:nvPr/>
        </p:nvGrpSpPr>
        <p:grpSpPr>
          <a:xfrm>
            <a:off x="7635551" y="653733"/>
            <a:ext cx="1213161" cy="1209875"/>
            <a:chOff x="4866873" y="650512"/>
            <a:chExt cx="1213161" cy="1209875"/>
          </a:xfrm>
        </p:grpSpPr>
        <p:sp>
          <p:nvSpPr>
            <p:cNvPr id="489" name="Isosceles Triangle 48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0" name="Isosceles Triangle 48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1" name="Isosceles Triangle 49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2" name="Isosceles Triangle 49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93" name="Group 492"/>
          <p:cNvGrpSpPr/>
          <p:nvPr/>
        </p:nvGrpSpPr>
        <p:grpSpPr>
          <a:xfrm>
            <a:off x="4872038" y="2028825"/>
            <a:ext cx="1213161" cy="1209875"/>
            <a:chOff x="4866873" y="650512"/>
            <a:chExt cx="1213161" cy="1209875"/>
          </a:xfrm>
        </p:grpSpPr>
        <p:sp>
          <p:nvSpPr>
            <p:cNvPr id="494" name="Isosceles Triangle 49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5" name="Isosceles Triangle 49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6" name="Isosceles Triangle 49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7" name="Isosceles Triangle 49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98" name="Group 497"/>
          <p:cNvGrpSpPr/>
          <p:nvPr/>
        </p:nvGrpSpPr>
        <p:grpSpPr>
          <a:xfrm>
            <a:off x="6256338" y="2028477"/>
            <a:ext cx="1213161" cy="1209875"/>
            <a:chOff x="4866873" y="650512"/>
            <a:chExt cx="1213161" cy="1209875"/>
          </a:xfrm>
        </p:grpSpPr>
        <p:sp>
          <p:nvSpPr>
            <p:cNvPr id="499" name="Isosceles Triangle 49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0" name="Isosceles Triangle 49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1" name="Isosceles Triangle 50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2" name="Isosceles Triangle 50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03" name="Group 502"/>
          <p:cNvGrpSpPr/>
          <p:nvPr/>
        </p:nvGrpSpPr>
        <p:grpSpPr>
          <a:xfrm>
            <a:off x="7630802" y="2028955"/>
            <a:ext cx="1213161" cy="1209875"/>
            <a:chOff x="4866873" y="650512"/>
            <a:chExt cx="1213161" cy="1209875"/>
          </a:xfrm>
        </p:grpSpPr>
        <p:sp>
          <p:nvSpPr>
            <p:cNvPr id="504" name="Isosceles Triangle 50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5" name="Isosceles Triangle 50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6" name="Isosceles Triangle 50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7" name="Isosceles Triangle 50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08" name="Group 507"/>
          <p:cNvGrpSpPr/>
          <p:nvPr/>
        </p:nvGrpSpPr>
        <p:grpSpPr>
          <a:xfrm>
            <a:off x="4866873" y="3698974"/>
            <a:ext cx="1213161" cy="1209875"/>
            <a:chOff x="4866873" y="650512"/>
            <a:chExt cx="1213161" cy="1209875"/>
          </a:xfrm>
        </p:grpSpPr>
        <p:sp>
          <p:nvSpPr>
            <p:cNvPr id="509" name="Isosceles Triangle 50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0" name="Isosceles Triangle 50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1" name="Isosceles Triangle 51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2" name="Isosceles Triangle 51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13" name="Group 512"/>
          <p:cNvGrpSpPr/>
          <p:nvPr/>
        </p:nvGrpSpPr>
        <p:grpSpPr>
          <a:xfrm>
            <a:off x="6257060" y="3698974"/>
            <a:ext cx="1213161" cy="1209875"/>
            <a:chOff x="4866873" y="650512"/>
            <a:chExt cx="1213161" cy="1209875"/>
          </a:xfrm>
        </p:grpSpPr>
        <p:sp>
          <p:nvSpPr>
            <p:cNvPr id="514" name="Isosceles Triangle 51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5" name="Isosceles Triangle 51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6" name="Isosceles Triangle 51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7" name="Isosceles Triangle 51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18" name="Group 517"/>
          <p:cNvGrpSpPr/>
          <p:nvPr/>
        </p:nvGrpSpPr>
        <p:grpSpPr>
          <a:xfrm>
            <a:off x="7635551" y="3698974"/>
            <a:ext cx="1213161" cy="1209875"/>
            <a:chOff x="4866873" y="650512"/>
            <a:chExt cx="1213161" cy="1209875"/>
          </a:xfrm>
        </p:grpSpPr>
        <p:sp>
          <p:nvSpPr>
            <p:cNvPr id="519" name="Isosceles Triangle 51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0" name="Isosceles Triangle 51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1" name="Isosceles Triangle 52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2" name="Isosceles Triangle 52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23" name="Group 522"/>
          <p:cNvGrpSpPr/>
          <p:nvPr/>
        </p:nvGrpSpPr>
        <p:grpSpPr>
          <a:xfrm>
            <a:off x="4873223" y="5072063"/>
            <a:ext cx="1213161" cy="1209875"/>
            <a:chOff x="4866873" y="650512"/>
            <a:chExt cx="1213161" cy="1209875"/>
          </a:xfrm>
        </p:grpSpPr>
        <p:sp>
          <p:nvSpPr>
            <p:cNvPr id="524" name="Isosceles Triangle 52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5" name="Isosceles Triangle 52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6" name="Isosceles Triangle 52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7" name="Isosceles Triangle 52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28" name="Group 527"/>
          <p:cNvGrpSpPr/>
          <p:nvPr/>
        </p:nvGrpSpPr>
        <p:grpSpPr>
          <a:xfrm>
            <a:off x="6257060" y="5070820"/>
            <a:ext cx="1213161" cy="1209875"/>
            <a:chOff x="4866873" y="650512"/>
            <a:chExt cx="1213161" cy="1209875"/>
          </a:xfrm>
        </p:grpSpPr>
        <p:sp>
          <p:nvSpPr>
            <p:cNvPr id="529" name="Isosceles Triangle 52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0" name="Isosceles Triangle 52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1" name="Isosceles Triangle 53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2" name="Isosceles Triangle 53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33" name="Group 532"/>
          <p:cNvGrpSpPr/>
          <p:nvPr/>
        </p:nvGrpSpPr>
        <p:grpSpPr>
          <a:xfrm>
            <a:off x="7635551" y="5070472"/>
            <a:ext cx="1213161" cy="1209875"/>
            <a:chOff x="4866873" y="650512"/>
            <a:chExt cx="1213161" cy="1209875"/>
          </a:xfrm>
        </p:grpSpPr>
        <p:sp>
          <p:nvSpPr>
            <p:cNvPr id="534" name="Isosceles Triangle 53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5" name="Isosceles Triangle 53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6" name="Isosceles Triangle 53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7" name="Isosceles Triangle 53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60" name="Group 259"/>
          <p:cNvGrpSpPr/>
          <p:nvPr/>
        </p:nvGrpSpPr>
        <p:grpSpPr>
          <a:xfrm>
            <a:off x="309563" y="653385"/>
            <a:ext cx="1213161" cy="1209875"/>
            <a:chOff x="4866873" y="650512"/>
            <a:chExt cx="1213161" cy="1209875"/>
          </a:xfrm>
        </p:grpSpPr>
        <p:sp>
          <p:nvSpPr>
            <p:cNvPr id="261" name="Isosceles Triangle 260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4" name="Isosceles Triangle 263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7" name="Isosceles Triangle 27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8" name="Isosceles Triangle 27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79" name="Group 278"/>
          <p:cNvGrpSpPr/>
          <p:nvPr/>
        </p:nvGrpSpPr>
        <p:grpSpPr>
          <a:xfrm>
            <a:off x="1678625" y="653733"/>
            <a:ext cx="1213161" cy="1209875"/>
            <a:chOff x="4866873" y="650512"/>
            <a:chExt cx="1213161" cy="1209875"/>
          </a:xfrm>
        </p:grpSpPr>
        <p:sp>
          <p:nvSpPr>
            <p:cNvPr id="280" name="Isosceles Triangle 27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1" name="Isosceles Triangle 28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2" name="Isosceles Triangle 28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3" name="Isosceles Triangle 28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84" name="Group 283"/>
          <p:cNvGrpSpPr/>
          <p:nvPr/>
        </p:nvGrpSpPr>
        <p:grpSpPr>
          <a:xfrm>
            <a:off x="3071813" y="676329"/>
            <a:ext cx="1213161" cy="1209875"/>
            <a:chOff x="4866873" y="650512"/>
            <a:chExt cx="1213161" cy="1209875"/>
          </a:xfrm>
        </p:grpSpPr>
        <p:sp>
          <p:nvSpPr>
            <p:cNvPr id="285" name="Isosceles Triangle 28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6" name="Isosceles Triangle 28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7" name="Isosceles Triangle 28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8" name="Isosceles Triangle 28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89" name="Group 288"/>
          <p:cNvGrpSpPr/>
          <p:nvPr/>
        </p:nvGrpSpPr>
        <p:grpSpPr>
          <a:xfrm>
            <a:off x="307159" y="2030213"/>
            <a:ext cx="1213161" cy="1209875"/>
            <a:chOff x="4866873" y="650512"/>
            <a:chExt cx="1213161" cy="1209875"/>
          </a:xfrm>
        </p:grpSpPr>
        <p:sp>
          <p:nvSpPr>
            <p:cNvPr id="290" name="Isosceles Triangle 28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1" name="Isosceles Triangle 29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2" name="Isosceles Triangle 29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3" name="Isosceles Triangle 29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94" name="Group 293"/>
          <p:cNvGrpSpPr/>
          <p:nvPr/>
        </p:nvGrpSpPr>
        <p:grpSpPr>
          <a:xfrm>
            <a:off x="1676221" y="2030213"/>
            <a:ext cx="1213161" cy="1209875"/>
            <a:chOff x="4866873" y="650512"/>
            <a:chExt cx="1213161" cy="1209875"/>
          </a:xfrm>
        </p:grpSpPr>
        <p:sp>
          <p:nvSpPr>
            <p:cNvPr id="295" name="Isosceles Triangle 29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6" name="Isosceles Triangle 29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7" name="Isosceles Triangle 29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8" name="Isosceles Triangle 29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99" name="Group 298"/>
          <p:cNvGrpSpPr/>
          <p:nvPr/>
        </p:nvGrpSpPr>
        <p:grpSpPr>
          <a:xfrm>
            <a:off x="3071813" y="2012787"/>
            <a:ext cx="1213161" cy="1209875"/>
            <a:chOff x="4866873" y="650512"/>
            <a:chExt cx="1213161" cy="1209875"/>
          </a:xfrm>
        </p:grpSpPr>
        <p:sp>
          <p:nvSpPr>
            <p:cNvPr id="300" name="Isosceles Triangle 29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1" name="Isosceles Triangle 30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2" name="Isosceles Triangle 30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3" name="Isosceles Triangle 30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04" name="Group 303"/>
          <p:cNvGrpSpPr/>
          <p:nvPr/>
        </p:nvGrpSpPr>
        <p:grpSpPr>
          <a:xfrm>
            <a:off x="277161" y="3694113"/>
            <a:ext cx="1213161" cy="1209875"/>
            <a:chOff x="4866873" y="650512"/>
            <a:chExt cx="1213161" cy="1209875"/>
          </a:xfrm>
        </p:grpSpPr>
        <p:sp>
          <p:nvSpPr>
            <p:cNvPr id="305" name="Isosceles Triangle 30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6" name="Isosceles Triangle 30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7" name="Isosceles Triangle 30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8" name="Isosceles Triangle 30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09" name="Group 308"/>
          <p:cNvGrpSpPr/>
          <p:nvPr/>
        </p:nvGrpSpPr>
        <p:grpSpPr>
          <a:xfrm>
            <a:off x="1678625" y="3700263"/>
            <a:ext cx="1213161" cy="1209875"/>
            <a:chOff x="4866873" y="650512"/>
            <a:chExt cx="1213161" cy="1209875"/>
          </a:xfrm>
        </p:grpSpPr>
        <p:sp>
          <p:nvSpPr>
            <p:cNvPr id="310" name="Isosceles Triangle 30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1" name="Isosceles Triangle 31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2" name="Isosceles Triangle 31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3" name="Isosceles Triangle 31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14" name="Group 313"/>
          <p:cNvGrpSpPr/>
          <p:nvPr/>
        </p:nvGrpSpPr>
        <p:grpSpPr>
          <a:xfrm>
            <a:off x="3071813" y="3692871"/>
            <a:ext cx="1213161" cy="1209875"/>
            <a:chOff x="4866873" y="650512"/>
            <a:chExt cx="1213161" cy="1209875"/>
          </a:xfrm>
        </p:grpSpPr>
        <p:sp>
          <p:nvSpPr>
            <p:cNvPr id="315" name="Isosceles Triangle 31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6" name="Isosceles Triangle 31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7" name="Isosceles Triangle 31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8" name="Isosceles Triangle 31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19" name="Group 318"/>
          <p:cNvGrpSpPr/>
          <p:nvPr/>
        </p:nvGrpSpPr>
        <p:grpSpPr>
          <a:xfrm>
            <a:off x="274757" y="5070472"/>
            <a:ext cx="1213161" cy="1209875"/>
            <a:chOff x="4866873" y="650512"/>
            <a:chExt cx="1213161" cy="1209875"/>
          </a:xfrm>
        </p:grpSpPr>
        <p:sp>
          <p:nvSpPr>
            <p:cNvPr id="320" name="Isosceles Triangle 31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1" name="Isosceles Triangle 32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2" name="Isosceles Triangle 32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3" name="Isosceles Triangle 32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24" name="Group 323"/>
          <p:cNvGrpSpPr/>
          <p:nvPr/>
        </p:nvGrpSpPr>
        <p:grpSpPr>
          <a:xfrm>
            <a:off x="1671079" y="5070472"/>
            <a:ext cx="1213161" cy="1209875"/>
            <a:chOff x="4866873" y="650512"/>
            <a:chExt cx="1213161" cy="1209875"/>
          </a:xfrm>
        </p:grpSpPr>
        <p:sp>
          <p:nvSpPr>
            <p:cNvPr id="325" name="Isosceles Triangle 32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6" name="Isosceles Triangle 32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7" name="Isosceles Triangle 32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8" name="Isosceles Triangle 32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29" name="Group 328"/>
          <p:cNvGrpSpPr/>
          <p:nvPr/>
        </p:nvGrpSpPr>
        <p:grpSpPr>
          <a:xfrm>
            <a:off x="3071813" y="5078213"/>
            <a:ext cx="1213161" cy="1209875"/>
            <a:chOff x="4866873" y="650512"/>
            <a:chExt cx="1213161" cy="1209875"/>
          </a:xfrm>
        </p:grpSpPr>
        <p:sp>
          <p:nvSpPr>
            <p:cNvPr id="330" name="Isosceles Triangle 32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1" name="Isosceles Triangle 33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2" name="Isosceles Triangle 33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3" name="Isosceles Triangle 33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64" name="TextBox 163"/>
          <p:cNvSpPr txBox="1"/>
          <p:nvPr/>
        </p:nvSpPr>
        <p:spPr>
          <a:xfrm>
            <a:off x="131884" y="509954"/>
            <a:ext cx="4924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CCW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xmlns="" val="4258284736"/>
      </p:ext>
    </p:extLst>
  </p:cSld>
  <p:clrMapOvr>
    <a:masterClrMapping/>
  </p:clrMapOvr>
  <p:transition advClick="0" advTm="600000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6" dur="5000" fill="hold"/>
                                        <p:tgtEl>
                                          <p:spTgt spid="47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8" dur="5000" fill="hold"/>
                                        <p:tgtEl>
                                          <p:spTgt spid="48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10" dur="5000" fill="hold"/>
                                        <p:tgtEl>
                                          <p:spTgt spid="48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12" dur="5000" fill="hold"/>
                                        <p:tgtEl>
                                          <p:spTgt spid="49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14" dur="5000" fill="hold"/>
                                        <p:tgtEl>
                                          <p:spTgt spid="49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16" dur="5000" fill="hold"/>
                                        <p:tgtEl>
                                          <p:spTgt spid="50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18" dur="5000" fill="hold"/>
                                        <p:tgtEl>
                                          <p:spTgt spid="50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20" dur="5000" fill="hold"/>
                                        <p:tgtEl>
                                          <p:spTgt spid="51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22" dur="5000" fill="hold"/>
                                        <p:tgtEl>
                                          <p:spTgt spid="51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24" dur="5000" fill="hold"/>
                                        <p:tgtEl>
                                          <p:spTgt spid="52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26" dur="5000" fill="hold"/>
                                        <p:tgtEl>
                                          <p:spTgt spid="52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28" dur="5000" fill="hold"/>
                                        <p:tgtEl>
                                          <p:spTgt spid="53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30" dur="5000" fill="hold"/>
                                        <p:tgtEl>
                                          <p:spTgt spid="260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32" dur="5000" fill="hold"/>
                                        <p:tgtEl>
                                          <p:spTgt spid="27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34" dur="5000" fill="hold"/>
                                        <p:tgtEl>
                                          <p:spTgt spid="28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36" dur="5000" fill="hold"/>
                                        <p:tgtEl>
                                          <p:spTgt spid="28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38" dur="5000" fill="hold"/>
                                        <p:tgtEl>
                                          <p:spTgt spid="29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40" dur="5000" fill="hold"/>
                                        <p:tgtEl>
                                          <p:spTgt spid="29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42" dur="5000" fill="hold"/>
                                        <p:tgtEl>
                                          <p:spTgt spid="30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44" dur="5000" fill="hold"/>
                                        <p:tgtEl>
                                          <p:spTgt spid="30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46" dur="5000" fill="hold"/>
                                        <p:tgtEl>
                                          <p:spTgt spid="31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48" dur="5000" fill="hold"/>
                                        <p:tgtEl>
                                          <p:spTgt spid="31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50" dur="5000" fill="hold"/>
                                        <p:tgtEl>
                                          <p:spTgt spid="32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5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52" dur="5000" fill="hold"/>
                                        <p:tgtEl>
                                          <p:spTgt spid="32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337" name="Group 17"/>
          <p:cNvGrpSpPr>
            <a:grpSpLocks/>
          </p:cNvGrpSpPr>
          <p:nvPr/>
        </p:nvGrpSpPr>
        <p:grpSpPr bwMode="auto">
          <a:xfrm>
            <a:off x="28575" y="434975"/>
            <a:ext cx="4513263" cy="3008313"/>
            <a:chOff x="232013" y="464024"/>
            <a:chExt cx="4258100" cy="2838735"/>
          </a:xfrm>
        </p:grpSpPr>
        <p:sp>
          <p:nvSpPr>
            <p:cNvPr id="4" name="Oval 3"/>
            <p:cNvSpPr/>
            <p:nvPr/>
          </p:nvSpPr>
          <p:spPr>
            <a:xfrm>
              <a:off x="497115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" name="Rectangle 9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11" name="Oval 10"/>
            <p:cNvSpPr/>
            <p:nvPr/>
          </p:nvSpPr>
          <p:spPr>
            <a:xfrm>
              <a:off x="1803152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2" name="Oval 11"/>
            <p:cNvSpPr/>
            <p:nvPr/>
          </p:nvSpPr>
          <p:spPr>
            <a:xfrm>
              <a:off x="3103198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3" name="Oval 12"/>
            <p:cNvSpPr/>
            <p:nvPr/>
          </p:nvSpPr>
          <p:spPr>
            <a:xfrm>
              <a:off x="497115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4" name="Oval 13"/>
            <p:cNvSpPr/>
            <p:nvPr/>
          </p:nvSpPr>
          <p:spPr>
            <a:xfrm>
              <a:off x="1803152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5" name="Oval 14"/>
            <p:cNvSpPr/>
            <p:nvPr/>
          </p:nvSpPr>
          <p:spPr>
            <a:xfrm>
              <a:off x="3103198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 dirty="0"/>
            </a:p>
          </p:txBody>
        </p:sp>
        <p:sp>
          <p:nvSpPr>
            <p:cNvPr id="16" name="Arc 15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17" name="Arc 16"/>
            <p:cNvSpPr/>
            <p:nvPr/>
          </p:nvSpPr>
          <p:spPr>
            <a:xfrm flipV="1">
              <a:off x="3564504" y="2376987"/>
              <a:ext cx="915124" cy="915285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grpSp>
        <p:nvGrpSpPr>
          <p:cNvPr id="14338" name="Group 61"/>
          <p:cNvGrpSpPr>
            <a:grpSpLocks/>
          </p:cNvGrpSpPr>
          <p:nvPr/>
        </p:nvGrpSpPr>
        <p:grpSpPr bwMode="auto">
          <a:xfrm>
            <a:off x="4589463" y="438150"/>
            <a:ext cx="4513262" cy="3008313"/>
            <a:chOff x="232013" y="464024"/>
            <a:chExt cx="4258100" cy="2838735"/>
          </a:xfrm>
        </p:grpSpPr>
        <p:sp>
          <p:nvSpPr>
            <p:cNvPr id="63" name="Oval 62"/>
            <p:cNvSpPr/>
            <p:nvPr/>
          </p:nvSpPr>
          <p:spPr>
            <a:xfrm>
              <a:off x="497114" y="664758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4" name="Rectangle 63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65" name="Oval 64"/>
            <p:cNvSpPr/>
            <p:nvPr/>
          </p:nvSpPr>
          <p:spPr>
            <a:xfrm>
              <a:off x="1803151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6" name="Oval 65"/>
            <p:cNvSpPr/>
            <p:nvPr/>
          </p:nvSpPr>
          <p:spPr>
            <a:xfrm>
              <a:off x="3103197" y="664758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7" name="Oval 66"/>
            <p:cNvSpPr/>
            <p:nvPr/>
          </p:nvSpPr>
          <p:spPr>
            <a:xfrm>
              <a:off x="497114" y="1965033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8" name="Oval 67"/>
            <p:cNvSpPr/>
            <p:nvPr/>
          </p:nvSpPr>
          <p:spPr>
            <a:xfrm>
              <a:off x="1803151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9" name="Oval 68"/>
            <p:cNvSpPr/>
            <p:nvPr/>
          </p:nvSpPr>
          <p:spPr>
            <a:xfrm>
              <a:off x="3103197" y="1965033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70" name="Arc 69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71" name="Arc 70"/>
            <p:cNvSpPr/>
            <p:nvPr/>
          </p:nvSpPr>
          <p:spPr>
            <a:xfrm flipV="1">
              <a:off x="3564504" y="2376987"/>
              <a:ext cx="915125" cy="915285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grpSp>
        <p:nvGrpSpPr>
          <p:cNvPr id="14339" name="Group 78"/>
          <p:cNvGrpSpPr>
            <a:grpSpLocks/>
          </p:cNvGrpSpPr>
          <p:nvPr/>
        </p:nvGrpSpPr>
        <p:grpSpPr bwMode="auto">
          <a:xfrm>
            <a:off x="28575" y="3486150"/>
            <a:ext cx="4513263" cy="3008313"/>
            <a:chOff x="232013" y="464024"/>
            <a:chExt cx="4258100" cy="2838735"/>
          </a:xfrm>
        </p:grpSpPr>
        <p:sp>
          <p:nvSpPr>
            <p:cNvPr id="80" name="Oval 79"/>
            <p:cNvSpPr/>
            <p:nvPr/>
          </p:nvSpPr>
          <p:spPr>
            <a:xfrm>
              <a:off x="497115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1" name="Rectangle 80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82" name="Oval 81"/>
            <p:cNvSpPr/>
            <p:nvPr/>
          </p:nvSpPr>
          <p:spPr>
            <a:xfrm>
              <a:off x="1803152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3" name="Oval 82"/>
            <p:cNvSpPr/>
            <p:nvPr/>
          </p:nvSpPr>
          <p:spPr>
            <a:xfrm>
              <a:off x="3103198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4" name="Oval 83"/>
            <p:cNvSpPr/>
            <p:nvPr/>
          </p:nvSpPr>
          <p:spPr>
            <a:xfrm>
              <a:off x="497115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5" name="Oval 84"/>
            <p:cNvSpPr/>
            <p:nvPr/>
          </p:nvSpPr>
          <p:spPr>
            <a:xfrm>
              <a:off x="1803152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6" name="Oval 85"/>
            <p:cNvSpPr/>
            <p:nvPr/>
          </p:nvSpPr>
          <p:spPr>
            <a:xfrm>
              <a:off x="3103198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7" name="Arc 86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88" name="Arc 87"/>
            <p:cNvSpPr/>
            <p:nvPr/>
          </p:nvSpPr>
          <p:spPr>
            <a:xfrm flipV="1">
              <a:off x="3564504" y="2376987"/>
              <a:ext cx="915124" cy="915285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grpSp>
        <p:nvGrpSpPr>
          <p:cNvPr id="14340" name="Group 95"/>
          <p:cNvGrpSpPr>
            <a:grpSpLocks/>
          </p:cNvGrpSpPr>
          <p:nvPr/>
        </p:nvGrpSpPr>
        <p:grpSpPr bwMode="auto">
          <a:xfrm>
            <a:off x="4591050" y="3481388"/>
            <a:ext cx="4513263" cy="3008312"/>
            <a:chOff x="232013" y="464024"/>
            <a:chExt cx="4258100" cy="2838735"/>
          </a:xfrm>
        </p:grpSpPr>
        <p:sp>
          <p:nvSpPr>
            <p:cNvPr id="97" name="Oval 96"/>
            <p:cNvSpPr/>
            <p:nvPr/>
          </p:nvSpPr>
          <p:spPr>
            <a:xfrm>
              <a:off x="497115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98" name="Rectangle 97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99" name="Oval 98"/>
            <p:cNvSpPr/>
            <p:nvPr/>
          </p:nvSpPr>
          <p:spPr>
            <a:xfrm>
              <a:off x="1803152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0" name="Oval 99"/>
            <p:cNvSpPr/>
            <p:nvPr/>
          </p:nvSpPr>
          <p:spPr>
            <a:xfrm>
              <a:off x="3103198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1" name="Oval 100"/>
            <p:cNvSpPr/>
            <p:nvPr/>
          </p:nvSpPr>
          <p:spPr>
            <a:xfrm>
              <a:off x="497115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2" name="Oval 101"/>
            <p:cNvSpPr/>
            <p:nvPr/>
          </p:nvSpPr>
          <p:spPr>
            <a:xfrm>
              <a:off x="1803152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3" name="Oval 102"/>
            <p:cNvSpPr/>
            <p:nvPr/>
          </p:nvSpPr>
          <p:spPr>
            <a:xfrm>
              <a:off x="3103198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4" name="Arc 103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105" name="Arc 104"/>
            <p:cNvSpPr/>
            <p:nvPr/>
          </p:nvSpPr>
          <p:spPr>
            <a:xfrm flipV="1">
              <a:off x="3564504" y="2376987"/>
              <a:ext cx="915124" cy="915287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sp>
        <p:nvSpPr>
          <p:cNvPr id="951" name="TextBox 950"/>
          <p:cNvSpPr txBox="1"/>
          <p:nvPr/>
        </p:nvSpPr>
        <p:spPr>
          <a:xfrm>
            <a:off x="1034041" y="68365"/>
            <a:ext cx="15220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Visual stimuli (CW) </a:t>
            </a:r>
            <a:endParaRPr lang="en-US" sz="1200" dirty="0"/>
          </a:p>
        </p:txBody>
      </p:sp>
      <p:sp>
        <p:nvSpPr>
          <p:cNvPr id="952" name="TextBox 951"/>
          <p:cNvSpPr txBox="1"/>
          <p:nvPr/>
        </p:nvSpPr>
        <p:spPr>
          <a:xfrm>
            <a:off x="5459338" y="66941"/>
            <a:ext cx="14787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Visual stimuli (CW)</a:t>
            </a:r>
            <a:endParaRPr lang="en-US" sz="1200" dirty="0"/>
          </a:p>
        </p:txBody>
      </p:sp>
      <p:grpSp>
        <p:nvGrpSpPr>
          <p:cNvPr id="478" name="Group 477"/>
          <p:cNvGrpSpPr/>
          <p:nvPr/>
        </p:nvGrpSpPr>
        <p:grpSpPr>
          <a:xfrm>
            <a:off x="4866873" y="650512"/>
            <a:ext cx="1213161" cy="1209875"/>
            <a:chOff x="4866873" y="650512"/>
            <a:chExt cx="1213161" cy="1209875"/>
          </a:xfrm>
        </p:grpSpPr>
        <p:sp>
          <p:nvSpPr>
            <p:cNvPr id="479" name="Isosceles Triangle 47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0" name="Isosceles Triangle 47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1" name="Isosceles Triangle 48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2" name="Isosceles Triangle 48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83" name="Group 482"/>
          <p:cNvGrpSpPr/>
          <p:nvPr/>
        </p:nvGrpSpPr>
        <p:grpSpPr>
          <a:xfrm>
            <a:off x="6251678" y="651843"/>
            <a:ext cx="1213161" cy="1209875"/>
            <a:chOff x="4866873" y="650512"/>
            <a:chExt cx="1213161" cy="1209875"/>
          </a:xfrm>
        </p:grpSpPr>
        <p:sp>
          <p:nvSpPr>
            <p:cNvPr id="484" name="Isosceles Triangle 48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5" name="Isosceles Triangle 48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6" name="Isosceles Triangle 48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7" name="Isosceles Triangle 48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88" name="Group 487"/>
          <p:cNvGrpSpPr/>
          <p:nvPr/>
        </p:nvGrpSpPr>
        <p:grpSpPr>
          <a:xfrm>
            <a:off x="7635551" y="653733"/>
            <a:ext cx="1213161" cy="1209875"/>
            <a:chOff x="4866873" y="650512"/>
            <a:chExt cx="1213161" cy="1209875"/>
          </a:xfrm>
        </p:grpSpPr>
        <p:sp>
          <p:nvSpPr>
            <p:cNvPr id="489" name="Isosceles Triangle 48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0" name="Isosceles Triangle 48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1" name="Isosceles Triangle 49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2" name="Isosceles Triangle 49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93" name="Group 492"/>
          <p:cNvGrpSpPr/>
          <p:nvPr/>
        </p:nvGrpSpPr>
        <p:grpSpPr>
          <a:xfrm>
            <a:off x="4872038" y="2028825"/>
            <a:ext cx="1213161" cy="1209875"/>
            <a:chOff x="4866873" y="650512"/>
            <a:chExt cx="1213161" cy="1209875"/>
          </a:xfrm>
        </p:grpSpPr>
        <p:sp>
          <p:nvSpPr>
            <p:cNvPr id="494" name="Isosceles Triangle 49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5" name="Isosceles Triangle 49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6" name="Isosceles Triangle 49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7" name="Isosceles Triangle 49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98" name="Group 497"/>
          <p:cNvGrpSpPr/>
          <p:nvPr/>
        </p:nvGrpSpPr>
        <p:grpSpPr>
          <a:xfrm>
            <a:off x="6256338" y="2028477"/>
            <a:ext cx="1213161" cy="1209875"/>
            <a:chOff x="4866873" y="650512"/>
            <a:chExt cx="1213161" cy="1209875"/>
          </a:xfrm>
        </p:grpSpPr>
        <p:sp>
          <p:nvSpPr>
            <p:cNvPr id="499" name="Isosceles Triangle 49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0" name="Isosceles Triangle 49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1" name="Isosceles Triangle 50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2" name="Isosceles Triangle 50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03" name="Group 502"/>
          <p:cNvGrpSpPr/>
          <p:nvPr/>
        </p:nvGrpSpPr>
        <p:grpSpPr>
          <a:xfrm>
            <a:off x="7630802" y="2028955"/>
            <a:ext cx="1213161" cy="1209875"/>
            <a:chOff x="4866873" y="650512"/>
            <a:chExt cx="1213161" cy="1209875"/>
          </a:xfrm>
        </p:grpSpPr>
        <p:sp>
          <p:nvSpPr>
            <p:cNvPr id="504" name="Isosceles Triangle 50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5" name="Isosceles Triangle 50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6" name="Isosceles Triangle 50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7" name="Isosceles Triangle 50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08" name="Group 507"/>
          <p:cNvGrpSpPr/>
          <p:nvPr/>
        </p:nvGrpSpPr>
        <p:grpSpPr>
          <a:xfrm>
            <a:off x="4866873" y="3698974"/>
            <a:ext cx="1213161" cy="1209875"/>
            <a:chOff x="4866873" y="650512"/>
            <a:chExt cx="1213161" cy="1209875"/>
          </a:xfrm>
        </p:grpSpPr>
        <p:sp>
          <p:nvSpPr>
            <p:cNvPr id="509" name="Isosceles Triangle 50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0" name="Isosceles Triangle 50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1" name="Isosceles Triangle 51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2" name="Isosceles Triangle 51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13" name="Group 512"/>
          <p:cNvGrpSpPr/>
          <p:nvPr/>
        </p:nvGrpSpPr>
        <p:grpSpPr>
          <a:xfrm>
            <a:off x="6257060" y="3698974"/>
            <a:ext cx="1213161" cy="1209875"/>
            <a:chOff x="4866873" y="650512"/>
            <a:chExt cx="1213161" cy="1209875"/>
          </a:xfrm>
        </p:grpSpPr>
        <p:sp>
          <p:nvSpPr>
            <p:cNvPr id="514" name="Isosceles Triangle 51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5" name="Isosceles Triangle 51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6" name="Isosceles Triangle 51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7" name="Isosceles Triangle 51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18" name="Group 517"/>
          <p:cNvGrpSpPr/>
          <p:nvPr/>
        </p:nvGrpSpPr>
        <p:grpSpPr>
          <a:xfrm>
            <a:off x="7635551" y="3698974"/>
            <a:ext cx="1213161" cy="1209875"/>
            <a:chOff x="4866873" y="650512"/>
            <a:chExt cx="1213161" cy="1209875"/>
          </a:xfrm>
        </p:grpSpPr>
        <p:sp>
          <p:nvSpPr>
            <p:cNvPr id="519" name="Isosceles Triangle 51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0" name="Isosceles Triangle 51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1" name="Isosceles Triangle 52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2" name="Isosceles Triangle 52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23" name="Group 522"/>
          <p:cNvGrpSpPr/>
          <p:nvPr/>
        </p:nvGrpSpPr>
        <p:grpSpPr>
          <a:xfrm>
            <a:off x="4873223" y="5072063"/>
            <a:ext cx="1213161" cy="1209875"/>
            <a:chOff x="4866873" y="650512"/>
            <a:chExt cx="1213161" cy="1209875"/>
          </a:xfrm>
        </p:grpSpPr>
        <p:sp>
          <p:nvSpPr>
            <p:cNvPr id="524" name="Isosceles Triangle 52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5" name="Isosceles Triangle 52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6" name="Isosceles Triangle 52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7" name="Isosceles Triangle 52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28" name="Group 527"/>
          <p:cNvGrpSpPr/>
          <p:nvPr/>
        </p:nvGrpSpPr>
        <p:grpSpPr>
          <a:xfrm>
            <a:off x="6257060" y="5070820"/>
            <a:ext cx="1213161" cy="1209875"/>
            <a:chOff x="4866873" y="650512"/>
            <a:chExt cx="1213161" cy="1209875"/>
          </a:xfrm>
        </p:grpSpPr>
        <p:sp>
          <p:nvSpPr>
            <p:cNvPr id="529" name="Isosceles Triangle 52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0" name="Isosceles Triangle 52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1" name="Isosceles Triangle 53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2" name="Isosceles Triangle 53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33" name="Group 532"/>
          <p:cNvGrpSpPr/>
          <p:nvPr/>
        </p:nvGrpSpPr>
        <p:grpSpPr>
          <a:xfrm>
            <a:off x="7635551" y="5070472"/>
            <a:ext cx="1213161" cy="1209875"/>
            <a:chOff x="4866873" y="650512"/>
            <a:chExt cx="1213161" cy="1209875"/>
          </a:xfrm>
        </p:grpSpPr>
        <p:sp>
          <p:nvSpPr>
            <p:cNvPr id="534" name="Isosceles Triangle 53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5" name="Isosceles Triangle 53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6" name="Isosceles Triangle 53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7" name="Isosceles Triangle 53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60" name="Group 259"/>
          <p:cNvGrpSpPr/>
          <p:nvPr/>
        </p:nvGrpSpPr>
        <p:grpSpPr>
          <a:xfrm>
            <a:off x="309563" y="653385"/>
            <a:ext cx="1213161" cy="1209875"/>
            <a:chOff x="4866873" y="650512"/>
            <a:chExt cx="1213161" cy="1209875"/>
          </a:xfrm>
        </p:grpSpPr>
        <p:sp>
          <p:nvSpPr>
            <p:cNvPr id="261" name="Isosceles Triangle 260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4" name="Isosceles Triangle 263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7" name="Isosceles Triangle 27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8" name="Isosceles Triangle 27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79" name="Group 278"/>
          <p:cNvGrpSpPr/>
          <p:nvPr/>
        </p:nvGrpSpPr>
        <p:grpSpPr>
          <a:xfrm>
            <a:off x="1678625" y="653733"/>
            <a:ext cx="1213161" cy="1209875"/>
            <a:chOff x="4866873" y="650512"/>
            <a:chExt cx="1213161" cy="1209875"/>
          </a:xfrm>
        </p:grpSpPr>
        <p:sp>
          <p:nvSpPr>
            <p:cNvPr id="280" name="Isosceles Triangle 27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1" name="Isosceles Triangle 28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2" name="Isosceles Triangle 28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3" name="Isosceles Triangle 28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84" name="Group 283"/>
          <p:cNvGrpSpPr/>
          <p:nvPr/>
        </p:nvGrpSpPr>
        <p:grpSpPr>
          <a:xfrm>
            <a:off x="3071813" y="676329"/>
            <a:ext cx="1213161" cy="1209875"/>
            <a:chOff x="4866873" y="650512"/>
            <a:chExt cx="1213161" cy="1209875"/>
          </a:xfrm>
        </p:grpSpPr>
        <p:sp>
          <p:nvSpPr>
            <p:cNvPr id="285" name="Isosceles Triangle 28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6" name="Isosceles Triangle 28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7" name="Isosceles Triangle 28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8" name="Isosceles Triangle 28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89" name="Group 288"/>
          <p:cNvGrpSpPr/>
          <p:nvPr/>
        </p:nvGrpSpPr>
        <p:grpSpPr>
          <a:xfrm>
            <a:off x="307159" y="2030213"/>
            <a:ext cx="1213161" cy="1209875"/>
            <a:chOff x="4866873" y="650512"/>
            <a:chExt cx="1213161" cy="1209875"/>
          </a:xfrm>
        </p:grpSpPr>
        <p:sp>
          <p:nvSpPr>
            <p:cNvPr id="290" name="Isosceles Triangle 28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1" name="Isosceles Triangle 29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2" name="Isosceles Triangle 29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3" name="Isosceles Triangle 29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94" name="Group 293"/>
          <p:cNvGrpSpPr/>
          <p:nvPr/>
        </p:nvGrpSpPr>
        <p:grpSpPr>
          <a:xfrm>
            <a:off x="1676221" y="2030213"/>
            <a:ext cx="1213161" cy="1209875"/>
            <a:chOff x="4866873" y="650512"/>
            <a:chExt cx="1213161" cy="1209875"/>
          </a:xfrm>
        </p:grpSpPr>
        <p:sp>
          <p:nvSpPr>
            <p:cNvPr id="295" name="Isosceles Triangle 29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6" name="Isosceles Triangle 29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7" name="Isosceles Triangle 29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8" name="Isosceles Triangle 29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99" name="Group 298"/>
          <p:cNvGrpSpPr/>
          <p:nvPr/>
        </p:nvGrpSpPr>
        <p:grpSpPr>
          <a:xfrm>
            <a:off x="3071813" y="2012787"/>
            <a:ext cx="1213161" cy="1209875"/>
            <a:chOff x="4866873" y="650512"/>
            <a:chExt cx="1213161" cy="1209875"/>
          </a:xfrm>
        </p:grpSpPr>
        <p:sp>
          <p:nvSpPr>
            <p:cNvPr id="300" name="Isosceles Triangle 29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1" name="Isosceles Triangle 30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2" name="Isosceles Triangle 30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3" name="Isosceles Triangle 30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04" name="Group 303"/>
          <p:cNvGrpSpPr/>
          <p:nvPr/>
        </p:nvGrpSpPr>
        <p:grpSpPr>
          <a:xfrm>
            <a:off x="277161" y="3694113"/>
            <a:ext cx="1213161" cy="1209875"/>
            <a:chOff x="4866873" y="650512"/>
            <a:chExt cx="1213161" cy="1209875"/>
          </a:xfrm>
        </p:grpSpPr>
        <p:sp>
          <p:nvSpPr>
            <p:cNvPr id="305" name="Isosceles Triangle 30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6" name="Isosceles Triangle 30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7" name="Isosceles Triangle 30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8" name="Isosceles Triangle 30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09" name="Group 308"/>
          <p:cNvGrpSpPr/>
          <p:nvPr/>
        </p:nvGrpSpPr>
        <p:grpSpPr>
          <a:xfrm>
            <a:off x="1678625" y="3700263"/>
            <a:ext cx="1213161" cy="1209875"/>
            <a:chOff x="4866873" y="650512"/>
            <a:chExt cx="1213161" cy="1209875"/>
          </a:xfrm>
        </p:grpSpPr>
        <p:sp>
          <p:nvSpPr>
            <p:cNvPr id="310" name="Isosceles Triangle 30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1" name="Isosceles Triangle 31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2" name="Isosceles Triangle 31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3" name="Isosceles Triangle 31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14" name="Group 313"/>
          <p:cNvGrpSpPr/>
          <p:nvPr/>
        </p:nvGrpSpPr>
        <p:grpSpPr>
          <a:xfrm>
            <a:off x="3071813" y="3692871"/>
            <a:ext cx="1213161" cy="1209875"/>
            <a:chOff x="4866873" y="650512"/>
            <a:chExt cx="1213161" cy="1209875"/>
          </a:xfrm>
        </p:grpSpPr>
        <p:sp>
          <p:nvSpPr>
            <p:cNvPr id="315" name="Isosceles Triangle 31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6" name="Isosceles Triangle 31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7" name="Isosceles Triangle 31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8" name="Isosceles Triangle 31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19" name="Group 318"/>
          <p:cNvGrpSpPr/>
          <p:nvPr/>
        </p:nvGrpSpPr>
        <p:grpSpPr>
          <a:xfrm>
            <a:off x="274757" y="5070472"/>
            <a:ext cx="1213161" cy="1209875"/>
            <a:chOff x="4866873" y="650512"/>
            <a:chExt cx="1213161" cy="1209875"/>
          </a:xfrm>
        </p:grpSpPr>
        <p:sp>
          <p:nvSpPr>
            <p:cNvPr id="320" name="Isosceles Triangle 31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1" name="Isosceles Triangle 32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2" name="Isosceles Triangle 32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3" name="Isosceles Triangle 32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24" name="Group 323"/>
          <p:cNvGrpSpPr/>
          <p:nvPr/>
        </p:nvGrpSpPr>
        <p:grpSpPr>
          <a:xfrm>
            <a:off x="1671079" y="5070472"/>
            <a:ext cx="1213161" cy="1209875"/>
            <a:chOff x="4866873" y="650512"/>
            <a:chExt cx="1213161" cy="1209875"/>
          </a:xfrm>
        </p:grpSpPr>
        <p:sp>
          <p:nvSpPr>
            <p:cNvPr id="325" name="Isosceles Triangle 32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6" name="Isosceles Triangle 32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7" name="Isosceles Triangle 32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8" name="Isosceles Triangle 32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29" name="Group 328"/>
          <p:cNvGrpSpPr/>
          <p:nvPr/>
        </p:nvGrpSpPr>
        <p:grpSpPr>
          <a:xfrm>
            <a:off x="3071813" y="5078213"/>
            <a:ext cx="1213161" cy="1209875"/>
            <a:chOff x="4866873" y="650512"/>
            <a:chExt cx="1213161" cy="1209875"/>
          </a:xfrm>
        </p:grpSpPr>
        <p:sp>
          <p:nvSpPr>
            <p:cNvPr id="330" name="Isosceles Triangle 32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1" name="Isosceles Triangle 33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2" name="Isosceles Triangle 33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3" name="Isosceles Triangle 33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64" name="TextBox 163"/>
          <p:cNvSpPr txBox="1"/>
          <p:nvPr/>
        </p:nvSpPr>
        <p:spPr>
          <a:xfrm>
            <a:off x="131884" y="509954"/>
            <a:ext cx="3994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CW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xmlns="" val="2592161572"/>
      </p:ext>
    </p:extLst>
  </p:cSld>
  <p:clrMapOvr>
    <a:masterClrMapping/>
  </p:clrMapOvr>
  <p:transition advClick="0" advTm="600000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6" dur="5000" fill="hold"/>
                                        <p:tgtEl>
                                          <p:spTgt spid="47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8" dur="5000" fill="hold"/>
                                        <p:tgtEl>
                                          <p:spTgt spid="48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10" dur="5000" fill="hold"/>
                                        <p:tgtEl>
                                          <p:spTgt spid="48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12" dur="5000" fill="hold"/>
                                        <p:tgtEl>
                                          <p:spTgt spid="49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14" dur="5000" fill="hold"/>
                                        <p:tgtEl>
                                          <p:spTgt spid="49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16" dur="5000" fill="hold"/>
                                        <p:tgtEl>
                                          <p:spTgt spid="50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18" dur="5000" fill="hold"/>
                                        <p:tgtEl>
                                          <p:spTgt spid="50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20" dur="5000" fill="hold"/>
                                        <p:tgtEl>
                                          <p:spTgt spid="51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22" dur="5000" fill="hold"/>
                                        <p:tgtEl>
                                          <p:spTgt spid="51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24" dur="5000" fill="hold"/>
                                        <p:tgtEl>
                                          <p:spTgt spid="52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26" dur="5000" fill="hold"/>
                                        <p:tgtEl>
                                          <p:spTgt spid="52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28" dur="5000" fill="hold"/>
                                        <p:tgtEl>
                                          <p:spTgt spid="53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30" dur="5000" fill="hold"/>
                                        <p:tgtEl>
                                          <p:spTgt spid="260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32" dur="5000" fill="hold"/>
                                        <p:tgtEl>
                                          <p:spTgt spid="27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34" dur="5000" fill="hold"/>
                                        <p:tgtEl>
                                          <p:spTgt spid="28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36" dur="5000" fill="hold"/>
                                        <p:tgtEl>
                                          <p:spTgt spid="28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38" dur="5000" fill="hold"/>
                                        <p:tgtEl>
                                          <p:spTgt spid="29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40" dur="5000" fill="hold"/>
                                        <p:tgtEl>
                                          <p:spTgt spid="29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42" dur="5000" fill="hold"/>
                                        <p:tgtEl>
                                          <p:spTgt spid="30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44" dur="5000" fill="hold"/>
                                        <p:tgtEl>
                                          <p:spTgt spid="30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46" dur="5000" fill="hold"/>
                                        <p:tgtEl>
                                          <p:spTgt spid="31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48" dur="5000" fill="hold"/>
                                        <p:tgtEl>
                                          <p:spTgt spid="31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50" dur="5000" fill="hold"/>
                                        <p:tgtEl>
                                          <p:spTgt spid="32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5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52" dur="5000" fill="hold"/>
                                        <p:tgtEl>
                                          <p:spTgt spid="32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337" name="Group 17"/>
          <p:cNvGrpSpPr>
            <a:grpSpLocks/>
          </p:cNvGrpSpPr>
          <p:nvPr/>
        </p:nvGrpSpPr>
        <p:grpSpPr bwMode="auto">
          <a:xfrm>
            <a:off x="28575" y="434975"/>
            <a:ext cx="4513263" cy="3008313"/>
            <a:chOff x="232013" y="464024"/>
            <a:chExt cx="4258100" cy="2838735"/>
          </a:xfrm>
        </p:grpSpPr>
        <p:sp>
          <p:nvSpPr>
            <p:cNvPr id="4" name="Oval 3"/>
            <p:cNvSpPr/>
            <p:nvPr/>
          </p:nvSpPr>
          <p:spPr>
            <a:xfrm>
              <a:off x="497115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" name="Rectangle 9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11" name="Oval 10"/>
            <p:cNvSpPr/>
            <p:nvPr/>
          </p:nvSpPr>
          <p:spPr>
            <a:xfrm>
              <a:off x="1803152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2" name="Oval 11"/>
            <p:cNvSpPr/>
            <p:nvPr/>
          </p:nvSpPr>
          <p:spPr>
            <a:xfrm>
              <a:off x="3103198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3" name="Oval 12"/>
            <p:cNvSpPr/>
            <p:nvPr/>
          </p:nvSpPr>
          <p:spPr>
            <a:xfrm>
              <a:off x="497115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4" name="Oval 13"/>
            <p:cNvSpPr/>
            <p:nvPr/>
          </p:nvSpPr>
          <p:spPr>
            <a:xfrm>
              <a:off x="1803152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5" name="Oval 14"/>
            <p:cNvSpPr/>
            <p:nvPr/>
          </p:nvSpPr>
          <p:spPr>
            <a:xfrm>
              <a:off x="3103198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 dirty="0"/>
            </a:p>
          </p:txBody>
        </p:sp>
        <p:sp>
          <p:nvSpPr>
            <p:cNvPr id="16" name="Arc 15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17" name="Arc 16"/>
            <p:cNvSpPr/>
            <p:nvPr/>
          </p:nvSpPr>
          <p:spPr>
            <a:xfrm flipV="1">
              <a:off x="3564504" y="2376987"/>
              <a:ext cx="915124" cy="915285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grpSp>
        <p:nvGrpSpPr>
          <p:cNvPr id="14338" name="Group 61"/>
          <p:cNvGrpSpPr>
            <a:grpSpLocks/>
          </p:cNvGrpSpPr>
          <p:nvPr/>
        </p:nvGrpSpPr>
        <p:grpSpPr bwMode="auto">
          <a:xfrm>
            <a:off x="4589463" y="438150"/>
            <a:ext cx="4513262" cy="3008313"/>
            <a:chOff x="232013" y="464024"/>
            <a:chExt cx="4258100" cy="2838735"/>
          </a:xfrm>
        </p:grpSpPr>
        <p:sp>
          <p:nvSpPr>
            <p:cNvPr id="63" name="Oval 62"/>
            <p:cNvSpPr/>
            <p:nvPr/>
          </p:nvSpPr>
          <p:spPr>
            <a:xfrm>
              <a:off x="497114" y="664758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4" name="Rectangle 63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65" name="Oval 64"/>
            <p:cNvSpPr/>
            <p:nvPr/>
          </p:nvSpPr>
          <p:spPr>
            <a:xfrm>
              <a:off x="1803151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6" name="Oval 65"/>
            <p:cNvSpPr/>
            <p:nvPr/>
          </p:nvSpPr>
          <p:spPr>
            <a:xfrm>
              <a:off x="3103197" y="664758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7" name="Oval 66"/>
            <p:cNvSpPr/>
            <p:nvPr/>
          </p:nvSpPr>
          <p:spPr>
            <a:xfrm>
              <a:off x="497114" y="1965033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8" name="Oval 67"/>
            <p:cNvSpPr/>
            <p:nvPr/>
          </p:nvSpPr>
          <p:spPr>
            <a:xfrm>
              <a:off x="1803151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9" name="Oval 68"/>
            <p:cNvSpPr/>
            <p:nvPr/>
          </p:nvSpPr>
          <p:spPr>
            <a:xfrm>
              <a:off x="3103197" y="1965033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70" name="Arc 69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71" name="Arc 70"/>
            <p:cNvSpPr/>
            <p:nvPr/>
          </p:nvSpPr>
          <p:spPr>
            <a:xfrm flipV="1">
              <a:off x="3564504" y="2376987"/>
              <a:ext cx="915125" cy="915285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grpSp>
        <p:nvGrpSpPr>
          <p:cNvPr id="14339" name="Group 78"/>
          <p:cNvGrpSpPr>
            <a:grpSpLocks/>
          </p:cNvGrpSpPr>
          <p:nvPr/>
        </p:nvGrpSpPr>
        <p:grpSpPr bwMode="auto">
          <a:xfrm>
            <a:off x="28575" y="3486150"/>
            <a:ext cx="4513263" cy="3008313"/>
            <a:chOff x="232013" y="464024"/>
            <a:chExt cx="4258100" cy="2838735"/>
          </a:xfrm>
        </p:grpSpPr>
        <p:sp>
          <p:nvSpPr>
            <p:cNvPr id="80" name="Oval 79"/>
            <p:cNvSpPr/>
            <p:nvPr/>
          </p:nvSpPr>
          <p:spPr>
            <a:xfrm>
              <a:off x="497115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1" name="Rectangle 80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82" name="Oval 81"/>
            <p:cNvSpPr/>
            <p:nvPr/>
          </p:nvSpPr>
          <p:spPr>
            <a:xfrm>
              <a:off x="1803152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3" name="Oval 82"/>
            <p:cNvSpPr/>
            <p:nvPr/>
          </p:nvSpPr>
          <p:spPr>
            <a:xfrm>
              <a:off x="3103198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4" name="Oval 83"/>
            <p:cNvSpPr/>
            <p:nvPr/>
          </p:nvSpPr>
          <p:spPr>
            <a:xfrm>
              <a:off x="497115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5" name="Oval 84"/>
            <p:cNvSpPr/>
            <p:nvPr/>
          </p:nvSpPr>
          <p:spPr>
            <a:xfrm>
              <a:off x="1803152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6" name="Oval 85"/>
            <p:cNvSpPr/>
            <p:nvPr/>
          </p:nvSpPr>
          <p:spPr>
            <a:xfrm>
              <a:off x="3103198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7" name="Arc 86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88" name="Arc 87"/>
            <p:cNvSpPr/>
            <p:nvPr/>
          </p:nvSpPr>
          <p:spPr>
            <a:xfrm flipV="1">
              <a:off x="3564504" y="2376987"/>
              <a:ext cx="915124" cy="915285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grpSp>
        <p:nvGrpSpPr>
          <p:cNvPr id="14340" name="Group 95"/>
          <p:cNvGrpSpPr>
            <a:grpSpLocks/>
          </p:cNvGrpSpPr>
          <p:nvPr/>
        </p:nvGrpSpPr>
        <p:grpSpPr bwMode="auto">
          <a:xfrm>
            <a:off x="4591050" y="3481388"/>
            <a:ext cx="4513263" cy="3008312"/>
            <a:chOff x="232013" y="464024"/>
            <a:chExt cx="4258100" cy="2838735"/>
          </a:xfrm>
        </p:grpSpPr>
        <p:sp>
          <p:nvSpPr>
            <p:cNvPr id="97" name="Oval 96"/>
            <p:cNvSpPr/>
            <p:nvPr/>
          </p:nvSpPr>
          <p:spPr>
            <a:xfrm>
              <a:off x="497115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98" name="Rectangle 97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99" name="Oval 98"/>
            <p:cNvSpPr/>
            <p:nvPr/>
          </p:nvSpPr>
          <p:spPr>
            <a:xfrm>
              <a:off x="1803152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0" name="Oval 99"/>
            <p:cNvSpPr/>
            <p:nvPr/>
          </p:nvSpPr>
          <p:spPr>
            <a:xfrm>
              <a:off x="3103198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1" name="Oval 100"/>
            <p:cNvSpPr/>
            <p:nvPr/>
          </p:nvSpPr>
          <p:spPr>
            <a:xfrm>
              <a:off x="497115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2" name="Oval 101"/>
            <p:cNvSpPr/>
            <p:nvPr/>
          </p:nvSpPr>
          <p:spPr>
            <a:xfrm>
              <a:off x="1803152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3" name="Oval 102"/>
            <p:cNvSpPr/>
            <p:nvPr/>
          </p:nvSpPr>
          <p:spPr>
            <a:xfrm>
              <a:off x="3103198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4" name="Arc 103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105" name="Arc 104"/>
            <p:cNvSpPr/>
            <p:nvPr/>
          </p:nvSpPr>
          <p:spPr>
            <a:xfrm flipV="1">
              <a:off x="3564504" y="2376987"/>
              <a:ext cx="915124" cy="915287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sp>
        <p:nvSpPr>
          <p:cNvPr id="951" name="TextBox 950"/>
          <p:cNvSpPr txBox="1"/>
          <p:nvPr/>
        </p:nvSpPr>
        <p:spPr>
          <a:xfrm>
            <a:off x="1034041" y="68365"/>
            <a:ext cx="1632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Visual stimuli (CCW) </a:t>
            </a:r>
            <a:endParaRPr lang="en-US" sz="1200" dirty="0"/>
          </a:p>
        </p:txBody>
      </p:sp>
      <p:sp>
        <p:nvSpPr>
          <p:cNvPr id="952" name="TextBox 951"/>
          <p:cNvSpPr txBox="1"/>
          <p:nvPr/>
        </p:nvSpPr>
        <p:spPr>
          <a:xfrm>
            <a:off x="5459338" y="66941"/>
            <a:ext cx="15893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Visual stimuli (CCW)</a:t>
            </a:r>
            <a:endParaRPr lang="en-US" sz="1200" dirty="0"/>
          </a:p>
        </p:txBody>
      </p:sp>
      <p:grpSp>
        <p:nvGrpSpPr>
          <p:cNvPr id="478" name="Group 477"/>
          <p:cNvGrpSpPr/>
          <p:nvPr/>
        </p:nvGrpSpPr>
        <p:grpSpPr>
          <a:xfrm>
            <a:off x="4866873" y="650512"/>
            <a:ext cx="1213161" cy="1209875"/>
            <a:chOff x="4866873" y="650512"/>
            <a:chExt cx="1213161" cy="1209875"/>
          </a:xfrm>
        </p:grpSpPr>
        <p:sp>
          <p:nvSpPr>
            <p:cNvPr id="479" name="Isosceles Triangle 47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0" name="Isosceles Triangle 47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1" name="Isosceles Triangle 48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2" name="Isosceles Triangle 48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83" name="Group 482"/>
          <p:cNvGrpSpPr/>
          <p:nvPr/>
        </p:nvGrpSpPr>
        <p:grpSpPr>
          <a:xfrm>
            <a:off x="6251678" y="651843"/>
            <a:ext cx="1213161" cy="1209875"/>
            <a:chOff x="4866873" y="650512"/>
            <a:chExt cx="1213161" cy="1209875"/>
          </a:xfrm>
        </p:grpSpPr>
        <p:sp>
          <p:nvSpPr>
            <p:cNvPr id="484" name="Isosceles Triangle 48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5" name="Isosceles Triangle 48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6" name="Isosceles Triangle 48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7" name="Isosceles Triangle 48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88" name="Group 487"/>
          <p:cNvGrpSpPr/>
          <p:nvPr/>
        </p:nvGrpSpPr>
        <p:grpSpPr>
          <a:xfrm>
            <a:off x="7635551" y="653733"/>
            <a:ext cx="1213161" cy="1209875"/>
            <a:chOff x="4866873" y="650512"/>
            <a:chExt cx="1213161" cy="1209875"/>
          </a:xfrm>
        </p:grpSpPr>
        <p:sp>
          <p:nvSpPr>
            <p:cNvPr id="489" name="Isosceles Triangle 48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0" name="Isosceles Triangle 48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1" name="Isosceles Triangle 49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2" name="Isosceles Triangle 49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93" name="Group 492"/>
          <p:cNvGrpSpPr/>
          <p:nvPr/>
        </p:nvGrpSpPr>
        <p:grpSpPr>
          <a:xfrm>
            <a:off x="4872038" y="2028825"/>
            <a:ext cx="1213161" cy="1209875"/>
            <a:chOff x="4866873" y="650512"/>
            <a:chExt cx="1213161" cy="1209875"/>
          </a:xfrm>
        </p:grpSpPr>
        <p:sp>
          <p:nvSpPr>
            <p:cNvPr id="494" name="Isosceles Triangle 49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5" name="Isosceles Triangle 49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6" name="Isosceles Triangle 49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7" name="Isosceles Triangle 49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98" name="Group 497"/>
          <p:cNvGrpSpPr/>
          <p:nvPr/>
        </p:nvGrpSpPr>
        <p:grpSpPr>
          <a:xfrm>
            <a:off x="6256338" y="2028477"/>
            <a:ext cx="1213161" cy="1209875"/>
            <a:chOff x="4866873" y="650512"/>
            <a:chExt cx="1213161" cy="1209875"/>
          </a:xfrm>
        </p:grpSpPr>
        <p:sp>
          <p:nvSpPr>
            <p:cNvPr id="499" name="Isosceles Triangle 49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0" name="Isosceles Triangle 49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1" name="Isosceles Triangle 50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2" name="Isosceles Triangle 50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03" name="Group 502"/>
          <p:cNvGrpSpPr/>
          <p:nvPr/>
        </p:nvGrpSpPr>
        <p:grpSpPr>
          <a:xfrm>
            <a:off x="7630802" y="2028955"/>
            <a:ext cx="1213161" cy="1209875"/>
            <a:chOff x="4866873" y="650512"/>
            <a:chExt cx="1213161" cy="1209875"/>
          </a:xfrm>
        </p:grpSpPr>
        <p:sp>
          <p:nvSpPr>
            <p:cNvPr id="504" name="Isosceles Triangle 50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5" name="Isosceles Triangle 50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6" name="Isosceles Triangle 50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7" name="Isosceles Triangle 50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08" name="Group 507"/>
          <p:cNvGrpSpPr/>
          <p:nvPr/>
        </p:nvGrpSpPr>
        <p:grpSpPr>
          <a:xfrm>
            <a:off x="4866873" y="3698974"/>
            <a:ext cx="1213161" cy="1209875"/>
            <a:chOff x="4866873" y="650512"/>
            <a:chExt cx="1213161" cy="1209875"/>
          </a:xfrm>
        </p:grpSpPr>
        <p:sp>
          <p:nvSpPr>
            <p:cNvPr id="509" name="Isosceles Triangle 50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0" name="Isosceles Triangle 50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1" name="Isosceles Triangle 51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2" name="Isosceles Triangle 51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13" name="Group 512"/>
          <p:cNvGrpSpPr/>
          <p:nvPr/>
        </p:nvGrpSpPr>
        <p:grpSpPr>
          <a:xfrm>
            <a:off x="6257060" y="3698974"/>
            <a:ext cx="1213161" cy="1209875"/>
            <a:chOff x="4866873" y="650512"/>
            <a:chExt cx="1213161" cy="1209875"/>
          </a:xfrm>
        </p:grpSpPr>
        <p:sp>
          <p:nvSpPr>
            <p:cNvPr id="514" name="Isosceles Triangle 51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5" name="Isosceles Triangle 51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6" name="Isosceles Triangle 51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7" name="Isosceles Triangle 51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18" name="Group 517"/>
          <p:cNvGrpSpPr/>
          <p:nvPr/>
        </p:nvGrpSpPr>
        <p:grpSpPr>
          <a:xfrm>
            <a:off x="7635551" y="3698974"/>
            <a:ext cx="1213161" cy="1209875"/>
            <a:chOff x="4866873" y="650512"/>
            <a:chExt cx="1213161" cy="1209875"/>
          </a:xfrm>
        </p:grpSpPr>
        <p:sp>
          <p:nvSpPr>
            <p:cNvPr id="519" name="Isosceles Triangle 51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0" name="Isosceles Triangle 51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1" name="Isosceles Triangle 52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2" name="Isosceles Triangle 52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23" name="Group 522"/>
          <p:cNvGrpSpPr/>
          <p:nvPr/>
        </p:nvGrpSpPr>
        <p:grpSpPr>
          <a:xfrm>
            <a:off x="4873223" y="5072063"/>
            <a:ext cx="1213161" cy="1209875"/>
            <a:chOff x="4866873" y="650512"/>
            <a:chExt cx="1213161" cy="1209875"/>
          </a:xfrm>
        </p:grpSpPr>
        <p:sp>
          <p:nvSpPr>
            <p:cNvPr id="524" name="Isosceles Triangle 52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5" name="Isosceles Triangle 52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6" name="Isosceles Triangle 52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7" name="Isosceles Triangle 52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28" name="Group 527"/>
          <p:cNvGrpSpPr/>
          <p:nvPr/>
        </p:nvGrpSpPr>
        <p:grpSpPr>
          <a:xfrm>
            <a:off x="6257060" y="5070820"/>
            <a:ext cx="1213161" cy="1209875"/>
            <a:chOff x="4866873" y="650512"/>
            <a:chExt cx="1213161" cy="1209875"/>
          </a:xfrm>
        </p:grpSpPr>
        <p:sp>
          <p:nvSpPr>
            <p:cNvPr id="529" name="Isosceles Triangle 52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0" name="Isosceles Triangle 52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1" name="Isosceles Triangle 53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2" name="Isosceles Triangle 53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33" name="Group 532"/>
          <p:cNvGrpSpPr/>
          <p:nvPr/>
        </p:nvGrpSpPr>
        <p:grpSpPr>
          <a:xfrm>
            <a:off x="7635551" y="5070472"/>
            <a:ext cx="1213161" cy="1209875"/>
            <a:chOff x="4866873" y="650512"/>
            <a:chExt cx="1213161" cy="1209875"/>
          </a:xfrm>
        </p:grpSpPr>
        <p:sp>
          <p:nvSpPr>
            <p:cNvPr id="534" name="Isosceles Triangle 53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5" name="Isosceles Triangle 53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6" name="Isosceles Triangle 53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7" name="Isosceles Triangle 53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60" name="Group 259"/>
          <p:cNvGrpSpPr/>
          <p:nvPr/>
        </p:nvGrpSpPr>
        <p:grpSpPr>
          <a:xfrm>
            <a:off x="309563" y="653385"/>
            <a:ext cx="1213161" cy="1209875"/>
            <a:chOff x="4866873" y="650512"/>
            <a:chExt cx="1213161" cy="1209875"/>
          </a:xfrm>
        </p:grpSpPr>
        <p:sp>
          <p:nvSpPr>
            <p:cNvPr id="261" name="Isosceles Triangle 260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4" name="Isosceles Triangle 263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7" name="Isosceles Triangle 27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8" name="Isosceles Triangle 27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79" name="Group 278"/>
          <p:cNvGrpSpPr/>
          <p:nvPr/>
        </p:nvGrpSpPr>
        <p:grpSpPr>
          <a:xfrm>
            <a:off x="1678625" y="653733"/>
            <a:ext cx="1213161" cy="1209875"/>
            <a:chOff x="4866873" y="650512"/>
            <a:chExt cx="1213161" cy="1209875"/>
          </a:xfrm>
        </p:grpSpPr>
        <p:sp>
          <p:nvSpPr>
            <p:cNvPr id="280" name="Isosceles Triangle 27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1" name="Isosceles Triangle 28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2" name="Isosceles Triangle 28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3" name="Isosceles Triangle 28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84" name="Group 283"/>
          <p:cNvGrpSpPr/>
          <p:nvPr/>
        </p:nvGrpSpPr>
        <p:grpSpPr>
          <a:xfrm>
            <a:off x="3071813" y="676329"/>
            <a:ext cx="1213161" cy="1209875"/>
            <a:chOff x="4866873" y="650512"/>
            <a:chExt cx="1213161" cy="1209875"/>
          </a:xfrm>
        </p:grpSpPr>
        <p:sp>
          <p:nvSpPr>
            <p:cNvPr id="285" name="Isosceles Triangle 28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6" name="Isosceles Triangle 28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7" name="Isosceles Triangle 28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8" name="Isosceles Triangle 28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89" name="Group 288"/>
          <p:cNvGrpSpPr/>
          <p:nvPr/>
        </p:nvGrpSpPr>
        <p:grpSpPr>
          <a:xfrm>
            <a:off x="307159" y="2030213"/>
            <a:ext cx="1213161" cy="1209875"/>
            <a:chOff x="4866873" y="650512"/>
            <a:chExt cx="1213161" cy="1209875"/>
          </a:xfrm>
        </p:grpSpPr>
        <p:sp>
          <p:nvSpPr>
            <p:cNvPr id="290" name="Isosceles Triangle 28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1" name="Isosceles Triangle 29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2" name="Isosceles Triangle 29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3" name="Isosceles Triangle 29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94" name="Group 293"/>
          <p:cNvGrpSpPr/>
          <p:nvPr/>
        </p:nvGrpSpPr>
        <p:grpSpPr>
          <a:xfrm>
            <a:off x="1676221" y="2030213"/>
            <a:ext cx="1213161" cy="1209875"/>
            <a:chOff x="4866873" y="650512"/>
            <a:chExt cx="1213161" cy="1209875"/>
          </a:xfrm>
        </p:grpSpPr>
        <p:sp>
          <p:nvSpPr>
            <p:cNvPr id="295" name="Isosceles Triangle 29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6" name="Isosceles Triangle 29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7" name="Isosceles Triangle 29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8" name="Isosceles Triangle 29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99" name="Group 298"/>
          <p:cNvGrpSpPr/>
          <p:nvPr/>
        </p:nvGrpSpPr>
        <p:grpSpPr>
          <a:xfrm>
            <a:off x="3071813" y="2012787"/>
            <a:ext cx="1213161" cy="1209875"/>
            <a:chOff x="4866873" y="650512"/>
            <a:chExt cx="1213161" cy="1209875"/>
          </a:xfrm>
        </p:grpSpPr>
        <p:sp>
          <p:nvSpPr>
            <p:cNvPr id="300" name="Isosceles Triangle 29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1" name="Isosceles Triangle 30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2" name="Isosceles Triangle 30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3" name="Isosceles Triangle 30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04" name="Group 303"/>
          <p:cNvGrpSpPr/>
          <p:nvPr/>
        </p:nvGrpSpPr>
        <p:grpSpPr>
          <a:xfrm>
            <a:off x="277161" y="3694113"/>
            <a:ext cx="1213161" cy="1209875"/>
            <a:chOff x="4866873" y="650512"/>
            <a:chExt cx="1213161" cy="1209875"/>
          </a:xfrm>
        </p:grpSpPr>
        <p:sp>
          <p:nvSpPr>
            <p:cNvPr id="305" name="Isosceles Triangle 30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6" name="Isosceles Triangle 30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7" name="Isosceles Triangle 30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8" name="Isosceles Triangle 30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09" name="Group 308"/>
          <p:cNvGrpSpPr/>
          <p:nvPr/>
        </p:nvGrpSpPr>
        <p:grpSpPr>
          <a:xfrm>
            <a:off x="1678625" y="3700263"/>
            <a:ext cx="1213161" cy="1209875"/>
            <a:chOff x="4866873" y="650512"/>
            <a:chExt cx="1213161" cy="1209875"/>
          </a:xfrm>
        </p:grpSpPr>
        <p:sp>
          <p:nvSpPr>
            <p:cNvPr id="310" name="Isosceles Triangle 30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1" name="Isosceles Triangle 31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2" name="Isosceles Triangle 31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3" name="Isosceles Triangle 31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14" name="Group 313"/>
          <p:cNvGrpSpPr/>
          <p:nvPr/>
        </p:nvGrpSpPr>
        <p:grpSpPr>
          <a:xfrm>
            <a:off x="3071813" y="3692871"/>
            <a:ext cx="1213161" cy="1209875"/>
            <a:chOff x="4866873" y="650512"/>
            <a:chExt cx="1213161" cy="1209875"/>
          </a:xfrm>
        </p:grpSpPr>
        <p:sp>
          <p:nvSpPr>
            <p:cNvPr id="315" name="Isosceles Triangle 31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6" name="Isosceles Triangle 31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7" name="Isosceles Triangle 31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8" name="Isosceles Triangle 31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19" name="Group 318"/>
          <p:cNvGrpSpPr/>
          <p:nvPr/>
        </p:nvGrpSpPr>
        <p:grpSpPr>
          <a:xfrm>
            <a:off x="274757" y="5070472"/>
            <a:ext cx="1213161" cy="1209875"/>
            <a:chOff x="4866873" y="650512"/>
            <a:chExt cx="1213161" cy="1209875"/>
          </a:xfrm>
        </p:grpSpPr>
        <p:sp>
          <p:nvSpPr>
            <p:cNvPr id="320" name="Isosceles Triangle 31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1" name="Isosceles Triangle 32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2" name="Isosceles Triangle 32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3" name="Isosceles Triangle 32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24" name="Group 323"/>
          <p:cNvGrpSpPr/>
          <p:nvPr/>
        </p:nvGrpSpPr>
        <p:grpSpPr>
          <a:xfrm>
            <a:off x="1671079" y="5070472"/>
            <a:ext cx="1213161" cy="1209875"/>
            <a:chOff x="4866873" y="650512"/>
            <a:chExt cx="1213161" cy="1209875"/>
          </a:xfrm>
        </p:grpSpPr>
        <p:sp>
          <p:nvSpPr>
            <p:cNvPr id="325" name="Isosceles Triangle 32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6" name="Isosceles Triangle 32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7" name="Isosceles Triangle 32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8" name="Isosceles Triangle 32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29" name="Group 328"/>
          <p:cNvGrpSpPr/>
          <p:nvPr/>
        </p:nvGrpSpPr>
        <p:grpSpPr>
          <a:xfrm>
            <a:off x="3071813" y="5078213"/>
            <a:ext cx="1213161" cy="1209875"/>
            <a:chOff x="4866873" y="650512"/>
            <a:chExt cx="1213161" cy="1209875"/>
          </a:xfrm>
        </p:grpSpPr>
        <p:sp>
          <p:nvSpPr>
            <p:cNvPr id="330" name="Isosceles Triangle 32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1" name="Isosceles Triangle 33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2" name="Isosceles Triangle 33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3" name="Isosceles Triangle 33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64" name="TextBox 163"/>
          <p:cNvSpPr txBox="1"/>
          <p:nvPr/>
        </p:nvSpPr>
        <p:spPr>
          <a:xfrm>
            <a:off x="131884" y="509954"/>
            <a:ext cx="4924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CCW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xmlns="" val="3579121194"/>
      </p:ext>
    </p:extLst>
  </p:cSld>
  <p:clrMapOvr>
    <a:masterClrMapping/>
  </p:clrMapOvr>
  <p:transition advClick="0" advTm="600000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6" dur="5000" fill="hold"/>
                                        <p:tgtEl>
                                          <p:spTgt spid="47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8" dur="5000" fill="hold"/>
                                        <p:tgtEl>
                                          <p:spTgt spid="48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10" dur="5000" fill="hold"/>
                                        <p:tgtEl>
                                          <p:spTgt spid="48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12" dur="5000" fill="hold"/>
                                        <p:tgtEl>
                                          <p:spTgt spid="49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14" dur="5000" fill="hold"/>
                                        <p:tgtEl>
                                          <p:spTgt spid="49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16" dur="5000" fill="hold"/>
                                        <p:tgtEl>
                                          <p:spTgt spid="50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18" dur="5000" fill="hold"/>
                                        <p:tgtEl>
                                          <p:spTgt spid="50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20" dur="5000" fill="hold"/>
                                        <p:tgtEl>
                                          <p:spTgt spid="51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22" dur="5000" fill="hold"/>
                                        <p:tgtEl>
                                          <p:spTgt spid="51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24" dur="5000" fill="hold"/>
                                        <p:tgtEl>
                                          <p:spTgt spid="52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26" dur="5000" fill="hold"/>
                                        <p:tgtEl>
                                          <p:spTgt spid="52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28" dur="5000" fill="hold"/>
                                        <p:tgtEl>
                                          <p:spTgt spid="53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30" dur="5000" fill="hold"/>
                                        <p:tgtEl>
                                          <p:spTgt spid="260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32" dur="5000" fill="hold"/>
                                        <p:tgtEl>
                                          <p:spTgt spid="27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34" dur="5000" fill="hold"/>
                                        <p:tgtEl>
                                          <p:spTgt spid="28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36" dur="5000" fill="hold"/>
                                        <p:tgtEl>
                                          <p:spTgt spid="28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38" dur="5000" fill="hold"/>
                                        <p:tgtEl>
                                          <p:spTgt spid="29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40" dur="5000" fill="hold"/>
                                        <p:tgtEl>
                                          <p:spTgt spid="29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42" dur="5000" fill="hold"/>
                                        <p:tgtEl>
                                          <p:spTgt spid="30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44" dur="5000" fill="hold"/>
                                        <p:tgtEl>
                                          <p:spTgt spid="30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46" dur="5000" fill="hold"/>
                                        <p:tgtEl>
                                          <p:spTgt spid="31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48" dur="5000" fill="hold"/>
                                        <p:tgtEl>
                                          <p:spTgt spid="31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50" dur="5000" fill="hold"/>
                                        <p:tgtEl>
                                          <p:spTgt spid="32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5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52" dur="5000" fill="hold"/>
                                        <p:tgtEl>
                                          <p:spTgt spid="32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337" name="Group 17"/>
          <p:cNvGrpSpPr>
            <a:grpSpLocks/>
          </p:cNvGrpSpPr>
          <p:nvPr/>
        </p:nvGrpSpPr>
        <p:grpSpPr bwMode="auto">
          <a:xfrm>
            <a:off x="28575" y="434975"/>
            <a:ext cx="4513263" cy="3008313"/>
            <a:chOff x="232013" y="464024"/>
            <a:chExt cx="4258100" cy="2838735"/>
          </a:xfrm>
        </p:grpSpPr>
        <p:sp>
          <p:nvSpPr>
            <p:cNvPr id="4" name="Oval 3"/>
            <p:cNvSpPr/>
            <p:nvPr/>
          </p:nvSpPr>
          <p:spPr>
            <a:xfrm>
              <a:off x="497115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" name="Rectangle 9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11" name="Oval 10"/>
            <p:cNvSpPr/>
            <p:nvPr/>
          </p:nvSpPr>
          <p:spPr>
            <a:xfrm>
              <a:off x="1803152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2" name="Oval 11"/>
            <p:cNvSpPr/>
            <p:nvPr/>
          </p:nvSpPr>
          <p:spPr>
            <a:xfrm>
              <a:off x="3103198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3" name="Oval 12"/>
            <p:cNvSpPr/>
            <p:nvPr/>
          </p:nvSpPr>
          <p:spPr>
            <a:xfrm>
              <a:off x="497115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4" name="Oval 13"/>
            <p:cNvSpPr/>
            <p:nvPr/>
          </p:nvSpPr>
          <p:spPr>
            <a:xfrm>
              <a:off x="1803152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5" name="Oval 14"/>
            <p:cNvSpPr/>
            <p:nvPr/>
          </p:nvSpPr>
          <p:spPr>
            <a:xfrm>
              <a:off x="3103198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 dirty="0"/>
            </a:p>
          </p:txBody>
        </p:sp>
        <p:sp>
          <p:nvSpPr>
            <p:cNvPr id="16" name="Arc 15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17" name="Arc 16"/>
            <p:cNvSpPr/>
            <p:nvPr/>
          </p:nvSpPr>
          <p:spPr>
            <a:xfrm flipV="1">
              <a:off x="3564504" y="2376987"/>
              <a:ext cx="915124" cy="915285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grpSp>
        <p:nvGrpSpPr>
          <p:cNvPr id="14338" name="Group 61"/>
          <p:cNvGrpSpPr>
            <a:grpSpLocks/>
          </p:cNvGrpSpPr>
          <p:nvPr/>
        </p:nvGrpSpPr>
        <p:grpSpPr bwMode="auto">
          <a:xfrm>
            <a:off x="4589463" y="438150"/>
            <a:ext cx="4513262" cy="3008313"/>
            <a:chOff x="232013" y="464024"/>
            <a:chExt cx="4258100" cy="2838735"/>
          </a:xfrm>
        </p:grpSpPr>
        <p:sp>
          <p:nvSpPr>
            <p:cNvPr id="63" name="Oval 62"/>
            <p:cNvSpPr/>
            <p:nvPr/>
          </p:nvSpPr>
          <p:spPr>
            <a:xfrm>
              <a:off x="497114" y="664758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4" name="Rectangle 63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65" name="Oval 64"/>
            <p:cNvSpPr/>
            <p:nvPr/>
          </p:nvSpPr>
          <p:spPr>
            <a:xfrm>
              <a:off x="1803151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6" name="Oval 65"/>
            <p:cNvSpPr/>
            <p:nvPr/>
          </p:nvSpPr>
          <p:spPr>
            <a:xfrm>
              <a:off x="3103197" y="664758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7" name="Oval 66"/>
            <p:cNvSpPr/>
            <p:nvPr/>
          </p:nvSpPr>
          <p:spPr>
            <a:xfrm>
              <a:off x="497114" y="1965033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8" name="Oval 67"/>
            <p:cNvSpPr/>
            <p:nvPr/>
          </p:nvSpPr>
          <p:spPr>
            <a:xfrm>
              <a:off x="1803151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9" name="Oval 68"/>
            <p:cNvSpPr/>
            <p:nvPr/>
          </p:nvSpPr>
          <p:spPr>
            <a:xfrm>
              <a:off x="3103197" y="1965033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70" name="Arc 69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71" name="Arc 70"/>
            <p:cNvSpPr/>
            <p:nvPr/>
          </p:nvSpPr>
          <p:spPr>
            <a:xfrm flipV="1">
              <a:off x="3564504" y="2376987"/>
              <a:ext cx="915125" cy="915285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grpSp>
        <p:nvGrpSpPr>
          <p:cNvPr id="14339" name="Group 78"/>
          <p:cNvGrpSpPr>
            <a:grpSpLocks/>
          </p:cNvGrpSpPr>
          <p:nvPr/>
        </p:nvGrpSpPr>
        <p:grpSpPr bwMode="auto">
          <a:xfrm>
            <a:off x="28575" y="3486150"/>
            <a:ext cx="4513263" cy="3008313"/>
            <a:chOff x="232013" y="464024"/>
            <a:chExt cx="4258100" cy="2838735"/>
          </a:xfrm>
        </p:grpSpPr>
        <p:sp>
          <p:nvSpPr>
            <p:cNvPr id="80" name="Oval 79"/>
            <p:cNvSpPr/>
            <p:nvPr/>
          </p:nvSpPr>
          <p:spPr>
            <a:xfrm>
              <a:off x="497115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1" name="Rectangle 80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82" name="Oval 81"/>
            <p:cNvSpPr/>
            <p:nvPr/>
          </p:nvSpPr>
          <p:spPr>
            <a:xfrm>
              <a:off x="1803152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3" name="Oval 82"/>
            <p:cNvSpPr/>
            <p:nvPr/>
          </p:nvSpPr>
          <p:spPr>
            <a:xfrm>
              <a:off x="3103198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4" name="Oval 83"/>
            <p:cNvSpPr/>
            <p:nvPr/>
          </p:nvSpPr>
          <p:spPr>
            <a:xfrm>
              <a:off x="497115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5" name="Oval 84"/>
            <p:cNvSpPr/>
            <p:nvPr/>
          </p:nvSpPr>
          <p:spPr>
            <a:xfrm>
              <a:off x="1803152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6" name="Oval 85"/>
            <p:cNvSpPr/>
            <p:nvPr/>
          </p:nvSpPr>
          <p:spPr>
            <a:xfrm>
              <a:off x="3103198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7" name="Arc 86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88" name="Arc 87"/>
            <p:cNvSpPr/>
            <p:nvPr/>
          </p:nvSpPr>
          <p:spPr>
            <a:xfrm flipV="1">
              <a:off x="3564504" y="2376987"/>
              <a:ext cx="915124" cy="915285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grpSp>
        <p:nvGrpSpPr>
          <p:cNvPr id="14340" name="Group 95"/>
          <p:cNvGrpSpPr>
            <a:grpSpLocks/>
          </p:cNvGrpSpPr>
          <p:nvPr/>
        </p:nvGrpSpPr>
        <p:grpSpPr bwMode="auto">
          <a:xfrm>
            <a:off x="4591050" y="3481388"/>
            <a:ext cx="4513263" cy="3008312"/>
            <a:chOff x="232013" y="464024"/>
            <a:chExt cx="4258100" cy="2838735"/>
          </a:xfrm>
        </p:grpSpPr>
        <p:sp>
          <p:nvSpPr>
            <p:cNvPr id="97" name="Oval 96"/>
            <p:cNvSpPr/>
            <p:nvPr/>
          </p:nvSpPr>
          <p:spPr>
            <a:xfrm>
              <a:off x="497115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98" name="Rectangle 97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99" name="Oval 98"/>
            <p:cNvSpPr/>
            <p:nvPr/>
          </p:nvSpPr>
          <p:spPr>
            <a:xfrm>
              <a:off x="1803152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0" name="Oval 99"/>
            <p:cNvSpPr/>
            <p:nvPr/>
          </p:nvSpPr>
          <p:spPr>
            <a:xfrm>
              <a:off x="3103198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1" name="Oval 100"/>
            <p:cNvSpPr/>
            <p:nvPr/>
          </p:nvSpPr>
          <p:spPr>
            <a:xfrm>
              <a:off x="497115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2" name="Oval 101"/>
            <p:cNvSpPr/>
            <p:nvPr/>
          </p:nvSpPr>
          <p:spPr>
            <a:xfrm>
              <a:off x="1803152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3" name="Oval 102"/>
            <p:cNvSpPr/>
            <p:nvPr/>
          </p:nvSpPr>
          <p:spPr>
            <a:xfrm>
              <a:off x="3103198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4" name="Arc 103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105" name="Arc 104"/>
            <p:cNvSpPr/>
            <p:nvPr/>
          </p:nvSpPr>
          <p:spPr>
            <a:xfrm flipV="1">
              <a:off x="3564504" y="2376987"/>
              <a:ext cx="915124" cy="915287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sp>
        <p:nvSpPr>
          <p:cNvPr id="951" name="TextBox 950"/>
          <p:cNvSpPr txBox="1"/>
          <p:nvPr/>
        </p:nvSpPr>
        <p:spPr>
          <a:xfrm>
            <a:off x="1034041" y="68365"/>
            <a:ext cx="15220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Visual stimuli (CW) </a:t>
            </a:r>
            <a:endParaRPr lang="en-US" sz="1200" dirty="0"/>
          </a:p>
        </p:txBody>
      </p:sp>
      <p:sp>
        <p:nvSpPr>
          <p:cNvPr id="952" name="TextBox 951"/>
          <p:cNvSpPr txBox="1"/>
          <p:nvPr/>
        </p:nvSpPr>
        <p:spPr>
          <a:xfrm>
            <a:off x="5459338" y="66941"/>
            <a:ext cx="14787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Visual stimuli (CW)</a:t>
            </a:r>
            <a:endParaRPr lang="en-US" sz="1200" dirty="0"/>
          </a:p>
        </p:txBody>
      </p:sp>
      <p:grpSp>
        <p:nvGrpSpPr>
          <p:cNvPr id="478" name="Group 477"/>
          <p:cNvGrpSpPr/>
          <p:nvPr/>
        </p:nvGrpSpPr>
        <p:grpSpPr>
          <a:xfrm>
            <a:off x="4866873" y="650512"/>
            <a:ext cx="1213161" cy="1209875"/>
            <a:chOff x="4866873" y="650512"/>
            <a:chExt cx="1213161" cy="1209875"/>
          </a:xfrm>
        </p:grpSpPr>
        <p:sp>
          <p:nvSpPr>
            <p:cNvPr id="479" name="Isosceles Triangle 47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0" name="Isosceles Triangle 47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1" name="Isosceles Triangle 48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2" name="Isosceles Triangle 48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83" name="Group 482"/>
          <p:cNvGrpSpPr/>
          <p:nvPr/>
        </p:nvGrpSpPr>
        <p:grpSpPr>
          <a:xfrm>
            <a:off x="6251678" y="651843"/>
            <a:ext cx="1213161" cy="1209875"/>
            <a:chOff x="4866873" y="650512"/>
            <a:chExt cx="1213161" cy="1209875"/>
          </a:xfrm>
        </p:grpSpPr>
        <p:sp>
          <p:nvSpPr>
            <p:cNvPr id="484" name="Isosceles Triangle 48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5" name="Isosceles Triangle 48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6" name="Isosceles Triangle 48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7" name="Isosceles Triangle 48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88" name="Group 487"/>
          <p:cNvGrpSpPr/>
          <p:nvPr/>
        </p:nvGrpSpPr>
        <p:grpSpPr>
          <a:xfrm>
            <a:off x="7635551" y="653733"/>
            <a:ext cx="1213161" cy="1209875"/>
            <a:chOff x="4866873" y="650512"/>
            <a:chExt cx="1213161" cy="1209875"/>
          </a:xfrm>
        </p:grpSpPr>
        <p:sp>
          <p:nvSpPr>
            <p:cNvPr id="489" name="Isosceles Triangle 48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0" name="Isosceles Triangle 48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1" name="Isosceles Triangle 49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2" name="Isosceles Triangle 49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93" name="Group 492"/>
          <p:cNvGrpSpPr/>
          <p:nvPr/>
        </p:nvGrpSpPr>
        <p:grpSpPr>
          <a:xfrm>
            <a:off x="4872038" y="2028825"/>
            <a:ext cx="1213161" cy="1209875"/>
            <a:chOff x="4866873" y="650512"/>
            <a:chExt cx="1213161" cy="1209875"/>
          </a:xfrm>
        </p:grpSpPr>
        <p:sp>
          <p:nvSpPr>
            <p:cNvPr id="494" name="Isosceles Triangle 49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5" name="Isosceles Triangle 49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6" name="Isosceles Triangle 49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7" name="Isosceles Triangle 49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98" name="Group 497"/>
          <p:cNvGrpSpPr/>
          <p:nvPr/>
        </p:nvGrpSpPr>
        <p:grpSpPr>
          <a:xfrm>
            <a:off x="6256338" y="2028477"/>
            <a:ext cx="1213161" cy="1209875"/>
            <a:chOff x="4866873" y="650512"/>
            <a:chExt cx="1213161" cy="1209875"/>
          </a:xfrm>
        </p:grpSpPr>
        <p:sp>
          <p:nvSpPr>
            <p:cNvPr id="499" name="Isosceles Triangle 49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0" name="Isosceles Triangle 49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1" name="Isosceles Triangle 50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2" name="Isosceles Triangle 50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03" name="Group 502"/>
          <p:cNvGrpSpPr/>
          <p:nvPr/>
        </p:nvGrpSpPr>
        <p:grpSpPr>
          <a:xfrm>
            <a:off x="7630802" y="2028955"/>
            <a:ext cx="1213161" cy="1209875"/>
            <a:chOff x="4866873" y="650512"/>
            <a:chExt cx="1213161" cy="1209875"/>
          </a:xfrm>
        </p:grpSpPr>
        <p:sp>
          <p:nvSpPr>
            <p:cNvPr id="504" name="Isosceles Triangle 50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5" name="Isosceles Triangle 50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6" name="Isosceles Triangle 50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7" name="Isosceles Triangle 50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08" name="Group 507"/>
          <p:cNvGrpSpPr/>
          <p:nvPr/>
        </p:nvGrpSpPr>
        <p:grpSpPr>
          <a:xfrm>
            <a:off x="4866873" y="3698974"/>
            <a:ext cx="1213161" cy="1209875"/>
            <a:chOff x="4866873" y="650512"/>
            <a:chExt cx="1213161" cy="1209875"/>
          </a:xfrm>
        </p:grpSpPr>
        <p:sp>
          <p:nvSpPr>
            <p:cNvPr id="509" name="Isosceles Triangle 50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0" name="Isosceles Triangle 50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1" name="Isosceles Triangle 51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2" name="Isosceles Triangle 51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13" name="Group 512"/>
          <p:cNvGrpSpPr/>
          <p:nvPr/>
        </p:nvGrpSpPr>
        <p:grpSpPr>
          <a:xfrm>
            <a:off x="6257060" y="3698974"/>
            <a:ext cx="1213161" cy="1209875"/>
            <a:chOff x="4866873" y="650512"/>
            <a:chExt cx="1213161" cy="1209875"/>
          </a:xfrm>
        </p:grpSpPr>
        <p:sp>
          <p:nvSpPr>
            <p:cNvPr id="514" name="Isosceles Triangle 51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5" name="Isosceles Triangle 51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6" name="Isosceles Triangle 51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7" name="Isosceles Triangle 51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18" name="Group 517"/>
          <p:cNvGrpSpPr/>
          <p:nvPr/>
        </p:nvGrpSpPr>
        <p:grpSpPr>
          <a:xfrm>
            <a:off x="7635551" y="3698974"/>
            <a:ext cx="1213161" cy="1209875"/>
            <a:chOff x="4866873" y="650512"/>
            <a:chExt cx="1213161" cy="1209875"/>
          </a:xfrm>
        </p:grpSpPr>
        <p:sp>
          <p:nvSpPr>
            <p:cNvPr id="519" name="Isosceles Triangle 51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0" name="Isosceles Triangle 51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1" name="Isosceles Triangle 52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2" name="Isosceles Triangle 52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23" name="Group 522"/>
          <p:cNvGrpSpPr/>
          <p:nvPr/>
        </p:nvGrpSpPr>
        <p:grpSpPr>
          <a:xfrm>
            <a:off x="4873223" y="5072063"/>
            <a:ext cx="1213161" cy="1209875"/>
            <a:chOff x="4866873" y="650512"/>
            <a:chExt cx="1213161" cy="1209875"/>
          </a:xfrm>
        </p:grpSpPr>
        <p:sp>
          <p:nvSpPr>
            <p:cNvPr id="524" name="Isosceles Triangle 52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5" name="Isosceles Triangle 52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6" name="Isosceles Triangle 52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7" name="Isosceles Triangle 52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28" name="Group 527"/>
          <p:cNvGrpSpPr/>
          <p:nvPr/>
        </p:nvGrpSpPr>
        <p:grpSpPr>
          <a:xfrm>
            <a:off x="6257060" y="5070820"/>
            <a:ext cx="1213161" cy="1209875"/>
            <a:chOff x="4866873" y="650512"/>
            <a:chExt cx="1213161" cy="1209875"/>
          </a:xfrm>
        </p:grpSpPr>
        <p:sp>
          <p:nvSpPr>
            <p:cNvPr id="529" name="Isosceles Triangle 52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0" name="Isosceles Triangle 52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1" name="Isosceles Triangle 53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2" name="Isosceles Triangle 53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33" name="Group 532"/>
          <p:cNvGrpSpPr/>
          <p:nvPr/>
        </p:nvGrpSpPr>
        <p:grpSpPr>
          <a:xfrm>
            <a:off x="7635551" y="5070472"/>
            <a:ext cx="1213161" cy="1209875"/>
            <a:chOff x="4866873" y="650512"/>
            <a:chExt cx="1213161" cy="1209875"/>
          </a:xfrm>
        </p:grpSpPr>
        <p:sp>
          <p:nvSpPr>
            <p:cNvPr id="534" name="Isosceles Triangle 53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5" name="Isosceles Triangle 53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6" name="Isosceles Triangle 53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7" name="Isosceles Triangle 53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60" name="Group 259"/>
          <p:cNvGrpSpPr/>
          <p:nvPr/>
        </p:nvGrpSpPr>
        <p:grpSpPr>
          <a:xfrm>
            <a:off x="309563" y="653385"/>
            <a:ext cx="1213161" cy="1209875"/>
            <a:chOff x="4866873" y="650512"/>
            <a:chExt cx="1213161" cy="1209875"/>
          </a:xfrm>
        </p:grpSpPr>
        <p:sp>
          <p:nvSpPr>
            <p:cNvPr id="261" name="Isosceles Triangle 260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4" name="Isosceles Triangle 263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7" name="Isosceles Triangle 27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8" name="Isosceles Triangle 27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79" name="Group 278"/>
          <p:cNvGrpSpPr/>
          <p:nvPr/>
        </p:nvGrpSpPr>
        <p:grpSpPr>
          <a:xfrm>
            <a:off x="1678625" y="653733"/>
            <a:ext cx="1213161" cy="1209875"/>
            <a:chOff x="4866873" y="650512"/>
            <a:chExt cx="1213161" cy="1209875"/>
          </a:xfrm>
        </p:grpSpPr>
        <p:sp>
          <p:nvSpPr>
            <p:cNvPr id="280" name="Isosceles Triangle 27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1" name="Isosceles Triangle 28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2" name="Isosceles Triangle 28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3" name="Isosceles Triangle 28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84" name="Group 283"/>
          <p:cNvGrpSpPr/>
          <p:nvPr/>
        </p:nvGrpSpPr>
        <p:grpSpPr>
          <a:xfrm>
            <a:off x="3071813" y="676329"/>
            <a:ext cx="1213161" cy="1209875"/>
            <a:chOff x="4866873" y="650512"/>
            <a:chExt cx="1213161" cy="1209875"/>
          </a:xfrm>
        </p:grpSpPr>
        <p:sp>
          <p:nvSpPr>
            <p:cNvPr id="285" name="Isosceles Triangle 28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6" name="Isosceles Triangle 28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7" name="Isosceles Triangle 28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8" name="Isosceles Triangle 28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89" name="Group 288"/>
          <p:cNvGrpSpPr/>
          <p:nvPr/>
        </p:nvGrpSpPr>
        <p:grpSpPr>
          <a:xfrm>
            <a:off x="307159" y="2030213"/>
            <a:ext cx="1213161" cy="1209875"/>
            <a:chOff x="4866873" y="650512"/>
            <a:chExt cx="1213161" cy="1209875"/>
          </a:xfrm>
        </p:grpSpPr>
        <p:sp>
          <p:nvSpPr>
            <p:cNvPr id="290" name="Isosceles Triangle 28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1" name="Isosceles Triangle 29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2" name="Isosceles Triangle 29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3" name="Isosceles Triangle 29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94" name="Group 293"/>
          <p:cNvGrpSpPr/>
          <p:nvPr/>
        </p:nvGrpSpPr>
        <p:grpSpPr>
          <a:xfrm>
            <a:off x="1676221" y="2030213"/>
            <a:ext cx="1213161" cy="1209875"/>
            <a:chOff x="4866873" y="650512"/>
            <a:chExt cx="1213161" cy="1209875"/>
          </a:xfrm>
        </p:grpSpPr>
        <p:sp>
          <p:nvSpPr>
            <p:cNvPr id="295" name="Isosceles Triangle 29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6" name="Isosceles Triangle 29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7" name="Isosceles Triangle 29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8" name="Isosceles Triangle 29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99" name="Group 298"/>
          <p:cNvGrpSpPr/>
          <p:nvPr/>
        </p:nvGrpSpPr>
        <p:grpSpPr>
          <a:xfrm>
            <a:off x="3071813" y="2012787"/>
            <a:ext cx="1213161" cy="1209875"/>
            <a:chOff x="4866873" y="650512"/>
            <a:chExt cx="1213161" cy="1209875"/>
          </a:xfrm>
        </p:grpSpPr>
        <p:sp>
          <p:nvSpPr>
            <p:cNvPr id="300" name="Isosceles Triangle 29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1" name="Isosceles Triangle 30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2" name="Isosceles Triangle 30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3" name="Isosceles Triangle 30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04" name="Group 303"/>
          <p:cNvGrpSpPr/>
          <p:nvPr/>
        </p:nvGrpSpPr>
        <p:grpSpPr>
          <a:xfrm>
            <a:off x="277161" y="3694113"/>
            <a:ext cx="1213161" cy="1209875"/>
            <a:chOff x="4866873" y="650512"/>
            <a:chExt cx="1213161" cy="1209875"/>
          </a:xfrm>
        </p:grpSpPr>
        <p:sp>
          <p:nvSpPr>
            <p:cNvPr id="305" name="Isosceles Triangle 30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6" name="Isosceles Triangle 30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7" name="Isosceles Triangle 30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8" name="Isosceles Triangle 30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09" name="Group 308"/>
          <p:cNvGrpSpPr/>
          <p:nvPr/>
        </p:nvGrpSpPr>
        <p:grpSpPr>
          <a:xfrm>
            <a:off x="1678625" y="3700263"/>
            <a:ext cx="1213161" cy="1209875"/>
            <a:chOff x="4866873" y="650512"/>
            <a:chExt cx="1213161" cy="1209875"/>
          </a:xfrm>
        </p:grpSpPr>
        <p:sp>
          <p:nvSpPr>
            <p:cNvPr id="310" name="Isosceles Triangle 30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1" name="Isosceles Triangle 31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2" name="Isosceles Triangle 31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3" name="Isosceles Triangle 31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14" name="Group 313"/>
          <p:cNvGrpSpPr/>
          <p:nvPr/>
        </p:nvGrpSpPr>
        <p:grpSpPr>
          <a:xfrm>
            <a:off x="3071813" y="3692871"/>
            <a:ext cx="1213161" cy="1209875"/>
            <a:chOff x="4866873" y="650512"/>
            <a:chExt cx="1213161" cy="1209875"/>
          </a:xfrm>
        </p:grpSpPr>
        <p:sp>
          <p:nvSpPr>
            <p:cNvPr id="315" name="Isosceles Triangle 31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6" name="Isosceles Triangle 31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7" name="Isosceles Triangle 31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8" name="Isosceles Triangle 31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19" name="Group 318"/>
          <p:cNvGrpSpPr/>
          <p:nvPr/>
        </p:nvGrpSpPr>
        <p:grpSpPr>
          <a:xfrm>
            <a:off x="274757" y="5070472"/>
            <a:ext cx="1213161" cy="1209875"/>
            <a:chOff x="4866873" y="650512"/>
            <a:chExt cx="1213161" cy="1209875"/>
          </a:xfrm>
        </p:grpSpPr>
        <p:sp>
          <p:nvSpPr>
            <p:cNvPr id="320" name="Isosceles Triangle 31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1" name="Isosceles Triangle 32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2" name="Isosceles Triangle 32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3" name="Isosceles Triangle 32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24" name="Group 323"/>
          <p:cNvGrpSpPr/>
          <p:nvPr/>
        </p:nvGrpSpPr>
        <p:grpSpPr>
          <a:xfrm>
            <a:off x="1671079" y="5070472"/>
            <a:ext cx="1213161" cy="1209875"/>
            <a:chOff x="4866873" y="650512"/>
            <a:chExt cx="1213161" cy="1209875"/>
          </a:xfrm>
        </p:grpSpPr>
        <p:sp>
          <p:nvSpPr>
            <p:cNvPr id="325" name="Isosceles Triangle 32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6" name="Isosceles Triangle 32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7" name="Isosceles Triangle 32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8" name="Isosceles Triangle 32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29" name="Group 328"/>
          <p:cNvGrpSpPr/>
          <p:nvPr/>
        </p:nvGrpSpPr>
        <p:grpSpPr>
          <a:xfrm>
            <a:off x="3071813" y="5078213"/>
            <a:ext cx="1213161" cy="1209875"/>
            <a:chOff x="4866873" y="650512"/>
            <a:chExt cx="1213161" cy="1209875"/>
          </a:xfrm>
        </p:grpSpPr>
        <p:sp>
          <p:nvSpPr>
            <p:cNvPr id="330" name="Isosceles Triangle 32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1" name="Isosceles Triangle 33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2" name="Isosceles Triangle 33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3" name="Isosceles Triangle 33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64" name="TextBox 163"/>
          <p:cNvSpPr txBox="1"/>
          <p:nvPr/>
        </p:nvSpPr>
        <p:spPr>
          <a:xfrm>
            <a:off x="131884" y="509954"/>
            <a:ext cx="3994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CW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xmlns="" val="2592161572"/>
      </p:ext>
    </p:extLst>
  </p:cSld>
  <p:clrMapOvr>
    <a:masterClrMapping/>
  </p:clrMapOvr>
  <p:transition advClick="0" advTm="600000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6" dur="5000" fill="hold"/>
                                        <p:tgtEl>
                                          <p:spTgt spid="47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8" dur="5000" fill="hold"/>
                                        <p:tgtEl>
                                          <p:spTgt spid="48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10" dur="5000" fill="hold"/>
                                        <p:tgtEl>
                                          <p:spTgt spid="48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12" dur="5000" fill="hold"/>
                                        <p:tgtEl>
                                          <p:spTgt spid="49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14" dur="5000" fill="hold"/>
                                        <p:tgtEl>
                                          <p:spTgt spid="49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16" dur="5000" fill="hold"/>
                                        <p:tgtEl>
                                          <p:spTgt spid="50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18" dur="5000" fill="hold"/>
                                        <p:tgtEl>
                                          <p:spTgt spid="50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20" dur="5000" fill="hold"/>
                                        <p:tgtEl>
                                          <p:spTgt spid="51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22" dur="5000" fill="hold"/>
                                        <p:tgtEl>
                                          <p:spTgt spid="51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24" dur="5000" fill="hold"/>
                                        <p:tgtEl>
                                          <p:spTgt spid="52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26" dur="5000" fill="hold"/>
                                        <p:tgtEl>
                                          <p:spTgt spid="52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28" dur="5000" fill="hold"/>
                                        <p:tgtEl>
                                          <p:spTgt spid="53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30" dur="5000" fill="hold"/>
                                        <p:tgtEl>
                                          <p:spTgt spid="260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32" dur="5000" fill="hold"/>
                                        <p:tgtEl>
                                          <p:spTgt spid="27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34" dur="5000" fill="hold"/>
                                        <p:tgtEl>
                                          <p:spTgt spid="28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36" dur="5000" fill="hold"/>
                                        <p:tgtEl>
                                          <p:spTgt spid="28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38" dur="5000" fill="hold"/>
                                        <p:tgtEl>
                                          <p:spTgt spid="29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40" dur="5000" fill="hold"/>
                                        <p:tgtEl>
                                          <p:spTgt spid="29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42" dur="5000" fill="hold"/>
                                        <p:tgtEl>
                                          <p:spTgt spid="30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44" dur="5000" fill="hold"/>
                                        <p:tgtEl>
                                          <p:spTgt spid="30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46" dur="5000" fill="hold"/>
                                        <p:tgtEl>
                                          <p:spTgt spid="31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48" dur="5000" fill="hold"/>
                                        <p:tgtEl>
                                          <p:spTgt spid="31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50" dur="5000" fill="hold"/>
                                        <p:tgtEl>
                                          <p:spTgt spid="32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5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52" dur="5000" fill="hold"/>
                                        <p:tgtEl>
                                          <p:spTgt spid="32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337" name="Group 17"/>
          <p:cNvGrpSpPr>
            <a:grpSpLocks/>
          </p:cNvGrpSpPr>
          <p:nvPr/>
        </p:nvGrpSpPr>
        <p:grpSpPr bwMode="auto">
          <a:xfrm>
            <a:off x="28575" y="434975"/>
            <a:ext cx="4513263" cy="3008313"/>
            <a:chOff x="232013" y="464024"/>
            <a:chExt cx="4258100" cy="2838735"/>
          </a:xfrm>
        </p:grpSpPr>
        <p:sp>
          <p:nvSpPr>
            <p:cNvPr id="4" name="Oval 3"/>
            <p:cNvSpPr/>
            <p:nvPr/>
          </p:nvSpPr>
          <p:spPr>
            <a:xfrm>
              <a:off x="497115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" name="Rectangle 9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11" name="Oval 10"/>
            <p:cNvSpPr/>
            <p:nvPr/>
          </p:nvSpPr>
          <p:spPr>
            <a:xfrm>
              <a:off x="1803152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2" name="Oval 11"/>
            <p:cNvSpPr/>
            <p:nvPr/>
          </p:nvSpPr>
          <p:spPr>
            <a:xfrm>
              <a:off x="3103198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3" name="Oval 12"/>
            <p:cNvSpPr/>
            <p:nvPr/>
          </p:nvSpPr>
          <p:spPr>
            <a:xfrm>
              <a:off x="497115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4" name="Oval 13"/>
            <p:cNvSpPr/>
            <p:nvPr/>
          </p:nvSpPr>
          <p:spPr>
            <a:xfrm>
              <a:off x="1803152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5" name="Oval 14"/>
            <p:cNvSpPr/>
            <p:nvPr/>
          </p:nvSpPr>
          <p:spPr>
            <a:xfrm>
              <a:off x="3103198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 dirty="0"/>
            </a:p>
          </p:txBody>
        </p:sp>
        <p:sp>
          <p:nvSpPr>
            <p:cNvPr id="16" name="Arc 15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17" name="Arc 16"/>
            <p:cNvSpPr/>
            <p:nvPr/>
          </p:nvSpPr>
          <p:spPr>
            <a:xfrm flipV="1">
              <a:off x="3564504" y="2376987"/>
              <a:ext cx="915124" cy="915285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grpSp>
        <p:nvGrpSpPr>
          <p:cNvPr id="14338" name="Group 61"/>
          <p:cNvGrpSpPr>
            <a:grpSpLocks/>
          </p:cNvGrpSpPr>
          <p:nvPr/>
        </p:nvGrpSpPr>
        <p:grpSpPr bwMode="auto">
          <a:xfrm>
            <a:off x="4589463" y="438150"/>
            <a:ext cx="4513262" cy="3008313"/>
            <a:chOff x="232013" y="464024"/>
            <a:chExt cx="4258100" cy="2838735"/>
          </a:xfrm>
        </p:grpSpPr>
        <p:sp>
          <p:nvSpPr>
            <p:cNvPr id="63" name="Oval 62"/>
            <p:cNvSpPr/>
            <p:nvPr/>
          </p:nvSpPr>
          <p:spPr>
            <a:xfrm>
              <a:off x="497114" y="664758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4" name="Rectangle 63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65" name="Oval 64"/>
            <p:cNvSpPr/>
            <p:nvPr/>
          </p:nvSpPr>
          <p:spPr>
            <a:xfrm>
              <a:off x="1803151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6" name="Oval 65"/>
            <p:cNvSpPr/>
            <p:nvPr/>
          </p:nvSpPr>
          <p:spPr>
            <a:xfrm>
              <a:off x="3103197" y="664758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7" name="Oval 66"/>
            <p:cNvSpPr/>
            <p:nvPr/>
          </p:nvSpPr>
          <p:spPr>
            <a:xfrm>
              <a:off x="497114" y="1965033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8" name="Oval 67"/>
            <p:cNvSpPr/>
            <p:nvPr/>
          </p:nvSpPr>
          <p:spPr>
            <a:xfrm>
              <a:off x="1803151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9" name="Oval 68"/>
            <p:cNvSpPr/>
            <p:nvPr/>
          </p:nvSpPr>
          <p:spPr>
            <a:xfrm>
              <a:off x="3103197" y="1965033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70" name="Arc 69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71" name="Arc 70"/>
            <p:cNvSpPr/>
            <p:nvPr/>
          </p:nvSpPr>
          <p:spPr>
            <a:xfrm flipV="1">
              <a:off x="3564504" y="2376987"/>
              <a:ext cx="915125" cy="915285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grpSp>
        <p:nvGrpSpPr>
          <p:cNvPr id="14339" name="Group 78"/>
          <p:cNvGrpSpPr>
            <a:grpSpLocks/>
          </p:cNvGrpSpPr>
          <p:nvPr/>
        </p:nvGrpSpPr>
        <p:grpSpPr bwMode="auto">
          <a:xfrm>
            <a:off x="28575" y="3486150"/>
            <a:ext cx="4513263" cy="3008313"/>
            <a:chOff x="232013" y="464024"/>
            <a:chExt cx="4258100" cy="2838735"/>
          </a:xfrm>
        </p:grpSpPr>
        <p:sp>
          <p:nvSpPr>
            <p:cNvPr id="80" name="Oval 79"/>
            <p:cNvSpPr/>
            <p:nvPr/>
          </p:nvSpPr>
          <p:spPr>
            <a:xfrm>
              <a:off x="497115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1" name="Rectangle 80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82" name="Oval 81"/>
            <p:cNvSpPr/>
            <p:nvPr/>
          </p:nvSpPr>
          <p:spPr>
            <a:xfrm>
              <a:off x="1803152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3" name="Oval 82"/>
            <p:cNvSpPr/>
            <p:nvPr/>
          </p:nvSpPr>
          <p:spPr>
            <a:xfrm>
              <a:off x="3103198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4" name="Oval 83"/>
            <p:cNvSpPr/>
            <p:nvPr/>
          </p:nvSpPr>
          <p:spPr>
            <a:xfrm>
              <a:off x="497115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5" name="Oval 84"/>
            <p:cNvSpPr/>
            <p:nvPr/>
          </p:nvSpPr>
          <p:spPr>
            <a:xfrm>
              <a:off x="1803152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6" name="Oval 85"/>
            <p:cNvSpPr/>
            <p:nvPr/>
          </p:nvSpPr>
          <p:spPr>
            <a:xfrm>
              <a:off x="3103198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7" name="Arc 86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88" name="Arc 87"/>
            <p:cNvSpPr/>
            <p:nvPr/>
          </p:nvSpPr>
          <p:spPr>
            <a:xfrm flipV="1">
              <a:off x="3564504" y="2376987"/>
              <a:ext cx="915124" cy="915285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grpSp>
        <p:nvGrpSpPr>
          <p:cNvPr id="14340" name="Group 95"/>
          <p:cNvGrpSpPr>
            <a:grpSpLocks/>
          </p:cNvGrpSpPr>
          <p:nvPr/>
        </p:nvGrpSpPr>
        <p:grpSpPr bwMode="auto">
          <a:xfrm>
            <a:off x="4591050" y="3481388"/>
            <a:ext cx="4513263" cy="3008312"/>
            <a:chOff x="232013" y="464024"/>
            <a:chExt cx="4258100" cy="2838735"/>
          </a:xfrm>
        </p:grpSpPr>
        <p:sp>
          <p:nvSpPr>
            <p:cNvPr id="97" name="Oval 96"/>
            <p:cNvSpPr/>
            <p:nvPr/>
          </p:nvSpPr>
          <p:spPr>
            <a:xfrm>
              <a:off x="497115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98" name="Rectangle 97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99" name="Oval 98"/>
            <p:cNvSpPr/>
            <p:nvPr/>
          </p:nvSpPr>
          <p:spPr>
            <a:xfrm>
              <a:off x="1803152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0" name="Oval 99"/>
            <p:cNvSpPr/>
            <p:nvPr/>
          </p:nvSpPr>
          <p:spPr>
            <a:xfrm>
              <a:off x="3103198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1" name="Oval 100"/>
            <p:cNvSpPr/>
            <p:nvPr/>
          </p:nvSpPr>
          <p:spPr>
            <a:xfrm>
              <a:off x="497115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2" name="Oval 101"/>
            <p:cNvSpPr/>
            <p:nvPr/>
          </p:nvSpPr>
          <p:spPr>
            <a:xfrm>
              <a:off x="1803152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3" name="Oval 102"/>
            <p:cNvSpPr/>
            <p:nvPr/>
          </p:nvSpPr>
          <p:spPr>
            <a:xfrm>
              <a:off x="3103198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4" name="Arc 103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105" name="Arc 104"/>
            <p:cNvSpPr/>
            <p:nvPr/>
          </p:nvSpPr>
          <p:spPr>
            <a:xfrm flipV="1">
              <a:off x="3564504" y="2376987"/>
              <a:ext cx="915124" cy="915287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sp>
        <p:nvSpPr>
          <p:cNvPr id="951" name="TextBox 950"/>
          <p:cNvSpPr txBox="1"/>
          <p:nvPr/>
        </p:nvSpPr>
        <p:spPr>
          <a:xfrm>
            <a:off x="1034041" y="68365"/>
            <a:ext cx="1632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Visual stimuli (CCW) </a:t>
            </a:r>
            <a:endParaRPr lang="en-US" sz="1200" dirty="0"/>
          </a:p>
        </p:txBody>
      </p:sp>
      <p:sp>
        <p:nvSpPr>
          <p:cNvPr id="952" name="TextBox 951"/>
          <p:cNvSpPr txBox="1"/>
          <p:nvPr/>
        </p:nvSpPr>
        <p:spPr>
          <a:xfrm>
            <a:off x="5459338" y="66941"/>
            <a:ext cx="15893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Visual stimuli (CCW)</a:t>
            </a:r>
            <a:endParaRPr lang="en-US" sz="1200" dirty="0"/>
          </a:p>
        </p:txBody>
      </p:sp>
      <p:grpSp>
        <p:nvGrpSpPr>
          <p:cNvPr id="478" name="Group 477"/>
          <p:cNvGrpSpPr/>
          <p:nvPr/>
        </p:nvGrpSpPr>
        <p:grpSpPr>
          <a:xfrm>
            <a:off x="4866873" y="650512"/>
            <a:ext cx="1213161" cy="1209875"/>
            <a:chOff x="4866873" y="650512"/>
            <a:chExt cx="1213161" cy="1209875"/>
          </a:xfrm>
        </p:grpSpPr>
        <p:sp>
          <p:nvSpPr>
            <p:cNvPr id="479" name="Isosceles Triangle 47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0" name="Isosceles Triangle 47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1" name="Isosceles Triangle 48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2" name="Isosceles Triangle 48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83" name="Group 482"/>
          <p:cNvGrpSpPr/>
          <p:nvPr/>
        </p:nvGrpSpPr>
        <p:grpSpPr>
          <a:xfrm>
            <a:off x="6251678" y="651843"/>
            <a:ext cx="1213161" cy="1209875"/>
            <a:chOff x="4866873" y="650512"/>
            <a:chExt cx="1213161" cy="1209875"/>
          </a:xfrm>
        </p:grpSpPr>
        <p:sp>
          <p:nvSpPr>
            <p:cNvPr id="484" name="Isosceles Triangle 48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5" name="Isosceles Triangle 48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6" name="Isosceles Triangle 48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7" name="Isosceles Triangle 48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88" name="Group 487"/>
          <p:cNvGrpSpPr/>
          <p:nvPr/>
        </p:nvGrpSpPr>
        <p:grpSpPr>
          <a:xfrm>
            <a:off x="7635551" y="653733"/>
            <a:ext cx="1213161" cy="1209875"/>
            <a:chOff x="4866873" y="650512"/>
            <a:chExt cx="1213161" cy="1209875"/>
          </a:xfrm>
        </p:grpSpPr>
        <p:sp>
          <p:nvSpPr>
            <p:cNvPr id="489" name="Isosceles Triangle 48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0" name="Isosceles Triangle 48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1" name="Isosceles Triangle 49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2" name="Isosceles Triangle 49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93" name="Group 492"/>
          <p:cNvGrpSpPr/>
          <p:nvPr/>
        </p:nvGrpSpPr>
        <p:grpSpPr>
          <a:xfrm>
            <a:off x="4872038" y="2028825"/>
            <a:ext cx="1213161" cy="1209875"/>
            <a:chOff x="4866873" y="650512"/>
            <a:chExt cx="1213161" cy="1209875"/>
          </a:xfrm>
        </p:grpSpPr>
        <p:sp>
          <p:nvSpPr>
            <p:cNvPr id="494" name="Isosceles Triangle 49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5" name="Isosceles Triangle 49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6" name="Isosceles Triangle 49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7" name="Isosceles Triangle 49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98" name="Group 497"/>
          <p:cNvGrpSpPr/>
          <p:nvPr/>
        </p:nvGrpSpPr>
        <p:grpSpPr>
          <a:xfrm>
            <a:off x="6256338" y="2028477"/>
            <a:ext cx="1213161" cy="1209875"/>
            <a:chOff x="4866873" y="650512"/>
            <a:chExt cx="1213161" cy="1209875"/>
          </a:xfrm>
        </p:grpSpPr>
        <p:sp>
          <p:nvSpPr>
            <p:cNvPr id="499" name="Isosceles Triangle 49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0" name="Isosceles Triangle 49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1" name="Isosceles Triangle 50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2" name="Isosceles Triangle 50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03" name="Group 502"/>
          <p:cNvGrpSpPr/>
          <p:nvPr/>
        </p:nvGrpSpPr>
        <p:grpSpPr>
          <a:xfrm>
            <a:off x="7630802" y="2028955"/>
            <a:ext cx="1213161" cy="1209875"/>
            <a:chOff x="4866873" y="650512"/>
            <a:chExt cx="1213161" cy="1209875"/>
          </a:xfrm>
        </p:grpSpPr>
        <p:sp>
          <p:nvSpPr>
            <p:cNvPr id="504" name="Isosceles Triangle 50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5" name="Isosceles Triangle 50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6" name="Isosceles Triangle 50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7" name="Isosceles Triangle 50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08" name="Group 507"/>
          <p:cNvGrpSpPr/>
          <p:nvPr/>
        </p:nvGrpSpPr>
        <p:grpSpPr>
          <a:xfrm>
            <a:off x="4866873" y="3698974"/>
            <a:ext cx="1213161" cy="1209875"/>
            <a:chOff x="4866873" y="650512"/>
            <a:chExt cx="1213161" cy="1209875"/>
          </a:xfrm>
        </p:grpSpPr>
        <p:sp>
          <p:nvSpPr>
            <p:cNvPr id="509" name="Isosceles Triangle 50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0" name="Isosceles Triangle 50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1" name="Isosceles Triangle 51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2" name="Isosceles Triangle 51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13" name="Group 512"/>
          <p:cNvGrpSpPr/>
          <p:nvPr/>
        </p:nvGrpSpPr>
        <p:grpSpPr>
          <a:xfrm>
            <a:off x="6257060" y="3698974"/>
            <a:ext cx="1213161" cy="1209875"/>
            <a:chOff x="4866873" y="650512"/>
            <a:chExt cx="1213161" cy="1209875"/>
          </a:xfrm>
        </p:grpSpPr>
        <p:sp>
          <p:nvSpPr>
            <p:cNvPr id="514" name="Isosceles Triangle 51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5" name="Isosceles Triangle 51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6" name="Isosceles Triangle 51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7" name="Isosceles Triangle 51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18" name="Group 517"/>
          <p:cNvGrpSpPr/>
          <p:nvPr/>
        </p:nvGrpSpPr>
        <p:grpSpPr>
          <a:xfrm>
            <a:off x="7635551" y="3698974"/>
            <a:ext cx="1213161" cy="1209875"/>
            <a:chOff x="4866873" y="650512"/>
            <a:chExt cx="1213161" cy="1209875"/>
          </a:xfrm>
        </p:grpSpPr>
        <p:sp>
          <p:nvSpPr>
            <p:cNvPr id="519" name="Isosceles Triangle 51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0" name="Isosceles Triangle 51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1" name="Isosceles Triangle 52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2" name="Isosceles Triangle 52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23" name="Group 522"/>
          <p:cNvGrpSpPr/>
          <p:nvPr/>
        </p:nvGrpSpPr>
        <p:grpSpPr>
          <a:xfrm>
            <a:off x="4873223" y="5072063"/>
            <a:ext cx="1213161" cy="1209875"/>
            <a:chOff x="4866873" y="650512"/>
            <a:chExt cx="1213161" cy="1209875"/>
          </a:xfrm>
        </p:grpSpPr>
        <p:sp>
          <p:nvSpPr>
            <p:cNvPr id="524" name="Isosceles Triangle 52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5" name="Isosceles Triangle 52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6" name="Isosceles Triangle 52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7" name="Isosceles Triangle 52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28" name="Group 527"/>
          <p:cNvGrpSpPr/>
          <p:nvPr/>
        </p:nvGrpSpPr>
        <p:grpSpPr>
          <a:xfrm>
            <a:off x="6257060" y="5070820"/>
            <a:ext cx="1213161" cy="1209875"/>
            <a:chOff x="4866873" y="650512"/>
            <a:chExt cx="1213161" cy="1209875"/>
          </a:xfrm>
        </p:grpSpPr>
        <p:sp>
          <p:nvSpPr>
            <p:cNvPr id="529" name="Isosceles Triangle 52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0" name="Isosceles Triangle 52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1" name="Isosceles Triangle 53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2" name="Isosceles Triangle 53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33" name="Group 532"/>
          <p:cNvGrpSpPr/>
          <p:nvPr/>
        </p:nvGrpSpPr>
        <p:grpSpPr>
          <a:xfrm>
            <a:off x="7635551" y="5070472"/>
            <a:ext cx="1213161" cy="1209875"/>
            <a:chOff x="4866873" y="650512"/>
            <a:chExt cx="1213161" cy="1209875"/>
          </a:xfrm>
        </p:grpSpPr>
        <p:sp>
          <p:nvSpPr>
            <p:cNvPr id="534" name="Isosceles Triangle 53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5" name="Isosceles Triangle 53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6" name="Isosceles Triangle 53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7" name="Isosceles Triangle 53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60" name="Group 259"/>
          <p:cNvGrpSpPr/>
          <p:nvPr/>
        </p:nvGrpSpPr>
        <p:grpSpPr>
          <a:xfrm>
            <a:off x="309563" y="653385"/>
            <a:ext cx="1213161" cy="1209875"/>
            <a:chOff x="4866873" y="650512"/>
            <a:chExt cx="1213161" cy="1209875"/>
          </a:xfrm>
        </p:grpSpPr>
        <p:sp>
          <p:nvSpPr>
            <p:cNvPr id="261" name="Isosceles Triangle 260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4" name="Isosceles Triangle 263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7" name="Isosceles Triangle 27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8" name="Isosceles Triangle 27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79" name="Group 278"/>
          <p:cNvGrpSpPr/>
          <p:nvPr/>
        </p:nvGrpSpPr>
        <p:grpSpPr>
          <a:xfrm>
            <a:off x="1678625" y="653733"/>
            <a:ext cx="1213161" cy="1209875"/>
            <a:chOff x="4866873" y="650512"/>
            <a:chExt cx="1213161" cy="1209875"/>
          </a:xfrm>
        </p:grpSpPr>
        <p:sp>
          <p:nvSpPr>
            <p:cNvPr id="280" name="Isosceles Triangle 27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1" name="Isosceles Triangle 28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2" name="Isosceles Triangle 28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3" name="Isosceles Triangle 28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84" name="Group 283"/>
          <p:cNvGrpSpPr/>
          <p:nvPr/>
        </p:nvGrpSpPr>
        <p:grpSpPr>
          <a:xfrm>
            <a:off x="3071813" y="676329"/>
            <a:ext cx="1213161" cy="1209875"/>
            <a:chOff x="4866873" y="650512"/>
            <a:chExt cx="1213161" cy="1209875"/>
          </a:xfrm>
        </p:grpSpPr>
        <p:sp>
          <p:nvSpPr>
            <p:cNvPr id="285" name="Isosceles Triangle 28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6" name="Isosceles Triangle 28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7" name="Isosceles Triangle 28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8" name="Isosceles Triangle 28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89" name="Group 288"/>
          <p:cNvGrpSpPr/>
          <p:nvPr/>
        </p:nvGrpSpPr>
        <p:grpSpPr>
          <a:xfrm>
            <a:off x="307159" y="2030213"/>
            <a:ext cx="1213161" cy="1209875"/>
            <a:chOff x="4866873" y="650512"/>
            <a:chExt cx="1213161" cy="1209875"/>
          </a:xfrm>
        </p:grpSpPr>
        <p:sp>
          <p:nvSpPr>
            <p:cNvPr id="290" name="Isosceles Triangle 28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1" name="Isosceles Triangle 29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2" name="Isosceles Triangle 29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3" name="Isosceles Triangle 29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94" name="Group 293"/>
          <p:cNvGrpSpPr/>
          <p:nvPr/>
        </p:nvGrpSpPr>
        <p:grpSpPr>
          <a:xfrm>
            <a:off x="1676221" y="2030213"/>
            <a:ext cx="1213161" cy="1209875"/>
            <a:chOff x="4866873" y="650512"/>
            <a:chExt cx="1213161" cy="1209875"/>
          </a:xfrm>
        </p:grpSpPr>
        <p:sp>
          <p:nvSpPr>
            <p:cNvPr id="295" name="Isosceles Triangle 29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6" name="Isosceles Triangle 29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7" name="Isosceles Triangle 29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8" name="Isosceles Triangle 29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99" name="Group 298"/>
          <p:cNvGrpSpPr/>
          <p:nvPr/>
        </p:nvGrpSpPr>
        <p:grpSpPr>
          <a:xfrm>
            <a:off x="3071813" y="2012787"/>
            <a:ext cx="1213161" cy="1209875"/>
            <a:chOff x="4866873" y="650512"/>
            <a:chExt cx="1213161" cy="1209875"/>
          </a:xfrm>
        </p:grpSpPr>
        <p:sp>
          <p:nvSpPr>
            <p:cNvPr id="300" name="Isosceles Triangle 29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1" name="Isosceles Triangle 30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2" name="Isosceles Triangle 30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3" name="Isosceles Triangle 30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04" name="Group 303"/>
          <p:cNvGrpSpPr/>
          <p:nvPr/>
        </p:nvGrpSpPr>
        <p:grpSpPr>
          <a:xfrm>
            <a:off x="277161" y="3694113"/>
            <a:ext cx="1213161" cy="1209875"/>
            <a:chOff x="4866873" y="650512"/>
            <a:chExt cx="1213161" cy="1209875"/>
          </a:xfrm>
        </p:grpSpPr>
        <p:sp>
          <p:nvSpPr>
            <p:cNvPr id="305" name="Isosceles Triangle 30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6" name="Isosceles Triangle 30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7" name="Isosceles Triangle 30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8" name="Isosceles Triangle 30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09" name="Group 308"/>
          <p:cNvGrpSpPr/>
          <p:nvPr/>
        </p:nvGrpSpPr>
        <p:grpSpPr>
          <a:xfrm>
            <a:off x="1678625" y="3700263"/>
            <a:ext cx="1213161" cy="1209875"/>
            <a:chOff x="4866873" y="650512"/>
            <a:chExt cx="1213161" cy="1209875"/>
          </a:xfrm>
        </p:grpSpPr>
        <p:sp>
          <p:nvSpPr>
            <p:cNvPr id="310" name="Isosceles Triangle 30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1" name="Isosceles Triangle 31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2" name="Isosceles Triangle 31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3" name="Isosceles Triangle 31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14" name="Group 313"/>
          <p:cNvGrpSpPr/>
          <p:nvPr/>
        </p:nvGrpSpPr>
        <p:grpSpPr>
          <a:xfrm>
            <a:off x="3071813" y="3692871"/>
            <a:ext cx="1213161" cy="1209875"/>
            <a:chOff x="4866873" y="650512"/>
            <a:chExt cx="1213161" cy="1209875"/>
          </a:xfrm>
        </p:grpSpPr>
        <p:sp>
          <p:nvSpPr>
            <p:cNvPr id="315" name="Isosceles Triangle 31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6" name="Isosceles Triangle 31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7" name="Isosceles Triangle 31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8" name="Isosceles Triangle 31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19" name="Group 318"/>
          <p:cNvGrpSpPr/>
          <p:nvPr/>
        </p:nvGrpSpPr>
        <p:grpSpPr>
          <a:xfrm>
            <a:off x="274757" y="5070472"/>
            <a:ext cx="1213161" cy="1209875"/>
            <a:chOff x="4866873" y="650512"/>
            <a:chExt cx="1213161" cy="1209875"/>
          </a:xfrm>
        </p:grpSpPr>
        <p:sp>
          <p:nvSpPr>
            <p:cNvPr id="320" name="Isosceles Triangle 31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1" name="Isosceles Triangle 32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2" name="Isosceles Triangle 32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3" name="Isosceles Triangle 32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24" name="Group 323"/>
          <p:cNvGrpSpPr/>
          <p:nvPr/>
        </p:nvGrpSpPr>
        <p:grpSpPr>
          <a:xfrm>
            <a:off x="1671079" y="5070472"/>
            <a:ext cx="1213161" cy="1209875"/>
            <a:chOff x="4866873" y="650512"/>
            <a:chExt cx="1213161" cy="1209875"/>
          </a:xfrm>
        </p:grpSpPr>
        <p:sp>
          <p:nvSpPr>
            <p:cNvPr id="325" name="Isosceles Triangle 32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6" name="Isosceles Triangle 32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7" name="Isosceles Triangle 32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8" name="Isosceles Triangle 32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29" name="Group 328"/>
          <p:cNvGrpSpPr/>
          <p:nvPr/>
        </p:nvGrpSpPr>
        <p:grpSpPr>
          <a:xfrm>
            <a:off x="3071813" y="5078213"/>
            <a:ext cx="1213161" cy="1209875"/>
            <a:chOff x="4866873" y="650512"/>
            <a:chExt cx="1213161" cy="1209875"/>
          </a:xfrm>
        </p:grpSpPr>
        <p:sp>
          <p:nvSpPr>
            <p:cNvPr id="330" name="Isosceles Triangle 32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1" name="Isosceles Triangle 33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2" name="Isosceles Triangle 33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3" name="Isosceles Triangle 33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64" name="TextBox 163"/>
          <p:cNvSpPr txBox="1"/>
          <p:nvPr/>
        </p:nvSpPr>
        <p:spPr>
          <a:xfrm>
            <a:off x="131884" y="509954"/>
            <a:ext cx="4924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CCW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xmlns="" val="3579121194"/>
      </p:ext>
    </p:extLst>
  </p:cSld>
  <p:clrMapOvr>
    <a:masterClrMapping/>
  </p:clrMapOvr>
  <p:transition advClick="0" advTm="600000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6" dur="5000" fill="hold"/>
                                        <p:tgtEl>
                                          <p:spTgt spid="47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8" dur="5000" fill="hold"/>
                                        <p:tgtEl>
                                          <p:spTgt spid="48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10" dur="5000" fill="hold"/>
                                        <p:tgtEl>
                                          <p:spTgt spid="48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12" dur="5000" fill="hold"/>
                                        <p:tgtEl>
                                          <p:spTgt spid="49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14" dur="5000" fill="hold"/>
                                        <p:tgtEl>
                                          <p:spTgt spid="49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16" dur="5000" fill="hold"/>
                                        <p:tgtEl>
                                          <p:spTgt spid="50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18" dur="5000" fill="hold"/>
                                        <p:tgtEl>
                                          <p:spTgt spid="50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20" dur="5000" fill="hold"/>
                                        <p:tgtEl>
                                          <p:spTgt spid="51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22" dur="5000" fill="hold"/>
                                        <p:tgtEl>
                                          <p:spTgt spid="51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24" dur="5000" fill="hold"/>
                                        <p:tgtEl>
                                          <p:spTgt spid="52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26" dur="5000" fill="hold"/>
                                        <p:tgtEl>
                                          <p:spTgt spid="52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28" dur="5000" fill="hold"/>
                                        <p:tgtEl>
                                          <p:spTgt spid="53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30" dur="5000" fill="hold"/>
                                        <p:tgtEl>
                                          <p:spTgt spid="260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32" dur="5000" fill="hold"/>
                                        <p:tgtEl>
                                          <p:spTgt spid="27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34" dur="5000" fill="hold"/>
                                        <p:tgtEl>
                                          <p:spTgt spid="28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36" dur="5000" fill="hold"/>
                                        <p:tgtEl>
                                          <p:spTgt spid="28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38" dur="5000" fill="hold"/>
                                        <p:tgtEl>
                                          <p:spTgt spid="29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40" dur="5000" fill="hold"/>
                                        <p:tgtEl>
                                          <p:spTgt spid="29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42" dur="5000" fill="hold"/>
                                        <p:tgtEl>
                                          <p:spTgt spid="30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44" dur="5000" fill="hold"/>
                                        <p:tgtEl>
                                          <p:spTgt spid="30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46" dur="5000" fill="hold"/>
                                        <p:tgtEl>
                                          <p:spTgt spid="31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48" dur="5000" fill="hold"/>
                                        <p:tgtEl>
                                          <p:spTgt spid="31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50" dur="5000" fill="hold"/>
                                        <p:tgtEl>
                                          <p:spTgt spid="32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5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52" dur="5000" fill="hold"/>
                                        <p:tgtEl>
                                          <p:spTgt spid="32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337" name="Group 17"/>
          <p:cNvGrpSpPr>
            <a:grpSpLocks/>
          </p:cNvGrpSpPr>
          <p:nvPr/>
        </p:nvGrpSpPr>
        <p:grpSpPr bwMode="auto">
          <a:xfrm>
            <a:off x="28575" y="434975"/>
            <a:ext cx="4513263" cy="3008313"/>
            <a:chOff x="232013" y="464024"/>
            <a:chExt cx="4258100" cy="2838735"/>
          </a:xfrm>
        </p:grpSpPr>
        <p:sp>
          <p:nvSpPr>
            <p:cNvPr id="4" name="Oval 3"/>
            <p:cNvSpPr/>
            <p:nvPr/>
          </p:nvSpPr>
          <p:spPr>
            <a:xfrm>
              <a:off x="497115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" name="Rectangle 9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11" name="Oval 10"/>
            <p:cNvSpPr/>
            <p:nvPr/>
          </p:nvSpPr>
          <p:spPr>
            <a:xfrm>
              <a:off x="1803152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2" name="Oval 11"/>
            <p:cNvSpPr/>
            <p:nvPr/>
          </p:nvSpPr>
          <p:spPr>
            <a:xfrm>
              <a:off x="3103198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3" name="Oval 12"/>
            <p:cNvSpPr/>
            <p:nvPr/>
          </p:nvSpPr>
          <p:spPr>
            <a:xfrm>
              <a:off x="497115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4" name="Oval 13"/>
            <p:cNvSpPr/>
            <p:nvPr/>
          </p:nvSpPr>
          <p:spPr>
            <a:xfrm>
              <a:off x="1803152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5" name="Oval 14"/>
            <p:cNvSpPr/>
            <p:nvPr/>
          </p:nvSpPr>
          <p:spPr>
            <a:xfrm>
              <a:off x="3103198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 dirty="0"/>
            </a:p>
          </p:txBody>
        </p:sp>
        <p:sp>
          <p:nvSpPr>
            <p:cNvPr id="16" name="Arc 15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17" name="Arc 16"/>
            <p:cNvSpPr/>
            <p:nvPr/>
          </p:nvSpPr>
          <p:spPr>
            <a:xfrm flipV="1">
              <a:off x="3564504" y="2376987"/>
              <a:ext cx="915124" cy="915285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grpSp>
        <p:nvGrpSpPr>
          <p:cNvPr id="14338" name="Group 61"/>
          <p:cNvGrpSpPr>
            <a:grpSpLocks/>
          </p:cNvGrpSpPr>
          <p:nvPr/>
        </p:nvGrpSpPr>
        <p:grpSpPr bwMode="auto">
          <a:xfrm>
            <a:off x="4589463" y="438150"/>
            <a:ext cx="4513262" cy="3008313"/>
            <a:chOff x="232013" y="464024"/>
            <a:chExt cx="4258100" cy="2838735"/>
          </a:xfrm>
        </p:grpSpPr>
        <p:sp>
          <p:nvSpPr>
            <p:cNvPr id="63" name="Oval 62"/>
            <p:cNvSpPr/>
            <p:nvPr/>
          </p:nvSpPr>
          <p:spPr>
            <a:xfrm>
              <a:off x="497114" y="664758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4" name="Rectangle 63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65" name="Oval 64"/>
            <p:cNvSpPr/>
            <p:nvPr/>
          </p:nvSpPr>
          <p:spPr>
            <a:xfrm>
              <a:off x="1803151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6" name="Oval 65"/>
            <p:cNvSpPr/>
            <p:nvPr/>
          </p:nvSpPr>
          <p:spPr>
            <a:xfrm>
              <a:off x="3103197" y="664758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7" name="Oval 66"/>
            <p:cNvSpPr/>
            <p:nvPr/>
          </p:nvSpPr>
          <p:spPr>
            <a:xfrm>
              <a:off x="497114" y="1965033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8" name="Oval 67"/>
            <p:cNvSpPr/>
            <p:nvPr/>
          </p:nvSpPr>
          <p:spPr>
            <a:xfrm>
              <a:off x="1803151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9" name="Oval 68"/>
            <p:cNvSpPr/>
            <p:nvPr/>
          </p:nvSpPr>
          <p:spPr>
            <a:xfrm>
              <a:off x="3103197" y="1965033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70" name="Arc 69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71" name="Arc 70"/>
            <p:cNvSpPr/>
            <p:nvPr/>
          </p:nvSpPr>
          <p:spPr>
            <a:xfrm flipV="1">
              <a:off x="3564504" y="2376987"/>
              <a:ext cx="915125" cy="915285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grpSp>
        <p:nvGrpSpPr>
          <p:cNvPr id="14339" name="Group 78"/>
          <p:cNvGrpSpPr>
            <a:grpSpLocks/>
          </p:cNvGrpSpPr>
          <p:nvPr/>
        </p:nvGrpSpPr>
        <p:grpSpPr bwMode="auto">
          <a:xfrm>
            <a:off x="28575" y="3486150"/>
            <a:ext cx="4513263" cy="3008313"/>
            <a:chOff x="232013" y="464024"/>
            <a:chExt cx="4258100" cy="2838735"/>
          </a:xfrm>
        </p:grpSpPr>
        <p:sp>
          <p:nvSpPr>
            <p:cNvPr id="80" name="Oval 79"/>
            <p:cNvSpPr/>
            <p:nvPr/>
          </p:nvSpPr>
          <p:spPr>
            <a:xfrm>
              <a:off x="497115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1" name="Rectangle 80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82" name="Oval 81"/>
            <p:cNvSpPr/>
            <p:nvPr/>
          </p:nvSpPr>
          <p:spPr>
            <a:xfrm>
              <a:off x="1803152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3" name="Oval 82"/>
            <p:cNvSpPr/>
            <p:nvPr/>
          </p:nvSpPr>
          <p:spPr>
            <a:xfrm>
              <a:off x="3103198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4" name="Oval 83"/>
            <p:cNvSpPr/>
            <p:nvPr/>
          </p:nvSpPr>
          <p:spPr>
            <a:xfrm>
              <a:off x="497115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5" name="Oval 84"/>
            <p:cNvSpPr/>
            <p:nvPr/>
          </p:nvSpPr>
          <p:spPr>
            <a:xfrm>
              <a:off x="1803152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6" name="Oval 85"/>
            <p:cNvSpPr/>
            <p:nvPr/>
          </p:nvSpPr>
          <p:spPr>
            <a:xfrm>
              <a:off x="3103198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7" name="Arc 86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88" name="Arc 87"/>
            <p:cNvSpPr/>
            <p:nvPr/>
          </p:nvSpPr>
          <p:spPr>
            <a:xfrm flipV="1">
              <a:off x="3564504" y="2376987"/>
              <a:ext cx="915124" cy="915285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grpSp>
        <p:nvGrpSpPr>
          <p:cNvPr id="14340" name="Group 95"/>
          <p:cNvGrpSpPr>
            <a:grpSpLocks/>
          </p:cNvGrpSpPr>
          <p:nvPr/>
        </p:nvGrpSpPr>
        <p:grpSpPr bwMode="auto">
          <a:xfrm>
            <a:off x="4591050" y="3481388"/>
            <a:ext cx="4513263" cy="3008312"/>
            <a:chOff x="232013" y="464024"/>
            <a:chExt cx="4258100" cy="2838735"/>
          </a:xfrm>
        </p:grpSpPr>
        <p:sp>
          <p:nvSpPr>
            <p:cNvPr id="97" name="Oval 96"/>
            <p:cNvSpPr/>
            <p:nvPr/>
          </p:nvSpPr>
          <p:spPr>
            <a:xfrm>
              <a:off x="497115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98" name="Rectangle 97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99" name="Oval 98"/>
            <p:cNvSpPr/>
            <p:nvPr/>
          </p:nvSpPr>
          <p:spPr>
            <a:xfrm>
              <a:off x="1803152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0" name="Oval 99"/>
            <p:cNvSpPr/>
            <p:nvPr/>
          </p:nvSpPr>
          <p:spPr>
            <a:xfrm>
              <a:off x="3103198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1" name="Oval 100"/>
            <p:cNvSpPr/>
            <p:nvPr/>
          </p:nvSpPr>
          <p:spPr>
            <a:xfrm>
              <a:off x="497115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2" name="Oval 101"/>
            <p:cNvSpPr/>
            <p:nvPr/>
          </p:nvSpPr>
          <p:spPr>
            <a:xfrm>
              <a:off x="1803152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3" name="Oval 102"/>
            <p:cNvSpPr/>
            <p:nvPr/>
          </p:nvSpPr>
          <p:spPr>
            <a:xfrm>
              <a:off x="3103198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4" name="Arc 103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105" name="Arc 104"/>
            <p:cNvSpPr/>
            <p:nvPr/>
          </p:nvSpPr>
          <p:spPr>
            <a:xfrm flipV="1">
              <a:off x="3564504" y="2376987"/>
              <a:ext cx="915124" cy="915287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sp>
        <p:nvSpPr>
          <p:cNvPr id="951" name="TextBox 950"/>
          <p:cNvSpPr txBox="1"/>
          <p:nvPr/>
        </p:nvSpPr>
        <p:spPr>
          <a:xfrm>
            <a:off x="1034041" y="68365"/>
            <a:ext cx="15220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Visual stimuli (CW) </a:t>
            </a:r>
            <a:endParaRPr lang="en-US" sz="1200" dirty="0"/>
          </a:p>
        </p:txBody>
      </p:sp>
      <p:sp>
        <p:nvSpPr>
          <p:cNvPr id="952" name="TextBox 951"/>
          <p:cNvSpPr txBox="1"/>
          <p:nvPr/>
        </p:nvSpPr>
        <p:spPr>
          <a:xfrm>
            <a:off x="5459338" y="66941"/>
            <a:ext cx="14787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Visual stimuli (CW)</a:t>
            </a:r>
            <a:endParaRPr lang="en-US" sz="1200" dirty="0"/>
          </a:p>
        </p:txBody>
      </p:sp>
      <p:grpSp>
        <p:nvGrpSpPr>
          <p:cNvPr id="478" name="Group 477"/>
          <p:cNvGrpSpPr/>
          <p:nvPr/>
        </p:nvGrpSpPr>
        <p:grpSpPr>
          <a:xfrm>
            <a:off x="4866873" y="650512"/>
            <a:ext cx="1213161" cy="1209875"/>
            <a:chOff x="4866873" y="650512"/>
            <a:chExt cx="1213161" cy="1209875"/>
          </a:xfrm>
        </p:grpSpPr>
        <p:sp>
          <p:nvSpPr>
            <p:cNvPr id="479" name="Isosceles Triangle 47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0" name="Isosceles Triangle 47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1" name="Isosceles Triangle 48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2" name="Isosceles Triangle 48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83" name="Group 482"/>
          <p:cNvGrpSpPr/>
          <p:nvPr/>
        </p:nvGrpSpPr>
        <p:grpSpPr>
          <a:xfrm>
            <a:off x="6251678" y="651843"/>
            <a:ext cx="1213161" cy="1209875"/>
            <a:chOff x="4866873" y="650512"/>
            <a:chExt cx="1213161" cy="1209875"/>
          </a:xfrm>
        </p:grpSpPr>
        <p:sp>
          <p:nvSpPr>
            <p:cNvPr id="484" name="Isosceles Triangle 48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5" name="Isosceles Triangle 48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6" name="Isosceles Triangle 48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7" name="Isosceles Triangle 48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88" name="Group 487"/>
          <p:cNvGrpSpPr/>
          <p:nvPr/>
        </p:nvGrpSpPr>
        <p:grpSpPr>
          <a:xfrm>
            <a:off x="7635551" y="653733"/>
            <a:ext cx="1213161" cy="1209875"/>
            <a:chOff x="4866873" y="650512"/>
            <a:chExt cx="1213161" cy="1209875"/>
          </a:xfrm>
        </p:grpSpPr>
        <p:sp>
          <p:nvSpPr>
            <p:cNvPr id="489" name="Isosceles Triangle 48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0" name="Isosceles Triangle 48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1" name="Isosceles Triangle 49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2" name="Isosceles Triangle 49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93" name="Group 492"/>
          <p:cNvGrpSpPr/>
          <p:nvPr/>
        </p:nvGrpSpPr>
        <p:grpSpPr>
          <a:xfrm>
            <a:off x="4872038" y="2028825"/>
            <a:ext cx="1213161" cy="1209875"/>
            <a:chOff x="4866873" y="650512"/>
            <a:chExt cx="1213161" cy="1209875"/>
          </a:xfrm>
        </p:grpSpPr>
        <p:sp>
          <p:nvSpPr>
            <p:cNvPr id="494" name="Isosceles Triangle 49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5" name="Isosceles Triangle 49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6" name="Isosceles Triangle 49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7" name="Isosceles Triangle 49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98" name="Group 497"/>
          <p:cNvGrpSpPr/>
          <p:nvPr/>
        </p:nvGrpSpPr>
        <p:grpSpPr>
          <a:xfrm>
            <a:off x="6256338" y="2028477"/>
            <a:ext cx="1213161" cy="1209875"/>
            <a:chOff x="4866873" y="650512"/>
            <a:chExt cx="1213161" cy="1209875"/>
          </a:xfrm>
        </p:grpSpPr>
        <p:sp>
          <p:nvSpPr>
            <p:cNvPr id="499" name="Isosceles Triangle 49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0" name="Isosceles Triangle 49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1" name="Isosceles Triangle 50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2" name="Isosceles Triangle 50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03" name="Group 502"/>
          <p:cNvGrpSpPr/>
          <p:nvPr/>
        </p:nvGrpSpPr>
        <p:grpSpPr>
          <a:xfrm>
            <a:off x="7630802" y="2028955"/>
            <a:ext cx="1213161" cy="1209875"/>
            <a:chOff x="4866873" y="650512"/>
            <a:chExt cx="1213161" cy="1209875"/>
          </a:xfrm>
        </p:grpSpPr>
        <p:sp>
          <p:nvSpPr>
            <p:cNvPr id="504" name="Isosceles Triangle 50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5" name="Isosceles Triangle 50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6" name="Isosceles Triangle 50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7" name="Isosceles Triangle 50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08" name="Group 507"/>
          <p:cNvGrpSpPr/>
          <p:nvPr/>
        </p:nvGrpSpPr>
        <p:grpSpPr>
          <a:xfrm>
            <a:off x="4866873" y="3698974"/>
            <a:ext cx="1213161" cy="1209875"/>
            <a:chOff x="4866873" y="650512"/>
            <a:chExt cx="1213161" cy="1209875"/>
          </a:xfrm>
        </p:grpSpPr>
        <p:sp>
          <p:nvSpPr>
            <p:cNvPr id="509" name="Isosceles Triangle 50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0" name="Isosceles Triangle 50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1" name="Isosceles Triangle 51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2" name="Isosceles Triangle 51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13" name="Group 512"/>
          <p:cNvGrpSpPr/>
          <p:nvPr/>
        </p:nvGrpSpPr>
        <p:grpSpPr>
          <a:xfrm>
            <a:off x="6257060" y="3698974"/>
            <a:ext cx="1213161" cy="1209875"/>
            <a:chOff x="4866873" y="650512"/>
            <a:chExt cx="1213161" cy="1209875"/>
          </a:xfrm>
        </p:grpSpPr>
        <p:sp>
          <p:nvSpPr>
            <p:cNvPr id="514" name="Isosceles Triangle 51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5" name="Isosceles Triangle 51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6" name="Isosceles Triangle 51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7" name="Isosceles Triangle 51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18" name="Group 517"/>
          <p:cNvGrpSpPr/>
          <p:nvPr/>
        </p:nvGrpSpPr>
        <p:grpSpPr>
          <a:xfrm>
            <a:off x="7635551" y="3698974"/>
            <a:ext cx="1213161" cy="1209875"/>
            <a:chOff x="4866873" y="650512"/>
            <a:chExt cx="1213161" cy="1209875"/>
          </a:xfrm>
        </p:grpSpPr>
        <p:sp>
          <p:nvSpPr>
            <p:cNvPr id="519" name="Isosceles Triangle 51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0" name="Isosceles Triangle 51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1" name="Isosceles Triangle 52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2" name="Isosceles Triangle 52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23" name="Group 522"/>
          <p:cNvGrpSpPr/>
          <p:nvPr/>
        </p:nvGrpSpPr>
        <p:grpSpPr>
          <a:xfrm>
            <a:off x="4873223" y="5072063"/>
            <a:ext cx="1213161" cy="1209875"/>
            <a:chOff x="4866873" y="650512"/>
            <a:chExt cx="1213161" cy="1209875"/>
          </a:xfrm>
        </p:grpSpPr>
        <p:sp>
          <p:nvSpPr>
            <p:cNvPr id="524" name="Isosceles Triangle 52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5" name="Isosceles Triangle 52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6" name="Isosceles Triangle 52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7" name="Isosceles Triangle 52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28" name="Group 527"/>
          <p:cNvGrpSpPr/>
          <p:nvPr/>
        </p:nvGrpSpPr>
        <p:grpSpPr>
          <a:xfrm>
            <a:off x="6257060" y="5070820"/>
            <a:ext cx="1213161" cy="1209875"/>
            <a:chOff x="4866873" y="650512"/>
            <a:chExt cx="1213161" cy="1209875"/>
          </a:xfrm>
        </p:grpSpPr>
        <p:sp>
          <p:nvSpPr>
            <p:cNvPr id="529" name="Isosceles Triangle 52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0" name="Isosceles Triangle 52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1" name="Isosceles Triangle 53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2" name="Isosceles Triangle 53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33" name="Group 532"/>
          <p:cNvGrpSpPr/>
          <p:nvPr/>
        </p:nvGrpSpPr>
        <p:grpSpPr>
          <a:xfrm>
            <a:off x="7635551" y="5070472"/>
            <a:ext cx="1213161" cy="1209875"/>
            <a:chOff x="4866873" y="650512"/>
            <a:chExt cx="1213161" cy="1209875"/>
          </a:xfrm>
        </p:grpSpPr>
        <p:sp>
          <p:nvSpPr>
            <p:cNvPr id="534" name="Isosceles Triangle 53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5" name="Isosceles Triangle 53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6" name="Isosceles Triangle 53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7" name="Isosceles Triangle 53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60" name="Group 259"/>
          <p:cNvGrpSpPr/>
          <p:nvPr/>
        </p:nvGrpSpPr>
        <p:grpSpPr>
          <a:xfrm>
            <a:off x="309563" y="653385"/>
            <a:ext cx="1213161" cy="1209875"/>
            <a:chOff x="4866873" y="650512"/>
            <a:chExt cx="1213161" cy="1209875"/>
          </a:xfrm>
        </p:grpSpPr>
        <p:sp>
          <p:nvSpPr>
            <p:cNvPr id="261" name="Isosceles Triangle 260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4" name="Isosceles Triangle 263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7" name="Isosceles Triangle 27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8" name="Isosceles Triangle 27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79" name="Group 278"/>
          <p:cNvGrpSpPr/>
          <p:nvPr/>
        </p:nvGrpSpPr>
        <p:grpSpPr>
          <a:xfrm>
            <a:off x="1678625" y="653733"/>
            <a:ext cx="1213161" cy="1209875"/>
            <a:chOff x="4866873" y="650512"/>
            <a:chExt cx="1213161" cy="1209875"/>
          </a:xfrm>
        </p:grpSpPr>
        <p:sp>
          <p:nvSpPr>
            <p:cNvPr id="280" name="Isosceles Triangle 27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1" name="Isosceles Triangle 28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2" name="Isosceles Triangle 28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3" name="Isosceles Triangle 28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84" name="Group 283"/>
          <p:cNvGrpSpPr/>
          <p:nvPr/>
        </p:nvGrpSpPr>
        <p:grpSpPr>
          <a:xfrm>
            <a:off x="3071813" y="676329"/>
            <a:ext cx="1213161" cy="1209875"/>
            <a:chOff x="4866873" y="650512"/>
            <a:chExt cx="1213161" cy="1209875"/>
          </a:xfrm>
        </p:grpSpPr>
        <p:sp>
          <p:nvSpPr>
            <p:cNvPr id="285" name="Isosceles Triangle 28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6" name="Isosceles Triangle 28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7" name="Isosceles Triangle 28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8" name="Isosceles Triangle 28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89" name="Group 288"/>
          <p:cNvGrpSpPr/>
          <p:nvPr/>
        </p:nvGrpSpPr>
        <p:grpSpPr>
          <a:xfrm>
            <a:off x="307159" y="2030213"/>
            <a:ext cx="1213161" cy="1209875"/>
            <a:chOff x="4866873" y="650512"/>
            <a:chExt cx="1213161" cy="1209875"/>
          </a:xfrm>
        </p:grpSpPr>
        <p:sp>
          <p:nvSpPr>
            <p:cNvPr id="290" name="Isosceles Triangle 28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1" name="Isosceles Triangle 29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2" name="Isosceles Triangle 29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3" name="Isosceles Triangle 29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94" name="Group 293"/>
          <p:cNvGrpSpPr/>
          <p:nvPr/>
        </p:nvGrpSpPr>
        <p:grpSpPr>
          <a:xfrm>
            <a:off x="1676221" y="2030213"/>
            <a:ext cx="1213161" cy="1209875"/>
            <a:chOff x="4866873" y="650512"/>
            <a:chExt cx="1213161" cy="1209875"/>
          </a:xfrm>
        </p:grpSpPr>
        <p:sp>
          <p:nvSpPr>
            <p:cNvPr id="295" name="Isosceles Triangle 29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6" name="Isosceles Triangle 29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7" name="Isosceles Triangle 29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8" name="Isosceles Triangle 29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99" name="Group 298"/>
          <p:cNvGrpSpPr/>
          <p:nvPr/>
        </p:nvGrpSpPr>
        <p:grpSpPr>
          <a:xfrm>
            <a:off x="3071813" y="2012787"/>
            <a:ext cx="1213161" cy="1209875"/>
            <a:chOff x="4866873" y="650512"/>
            <a:chExt cx="1213161" cy="1209875"/>
          </a:xfrm>
        </p:grpSpPr>
        <p:sp>
          <p:nvSpPr>
            <p:cNvPr id="300" name="Isosceles Triangle 29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1" name="Isosceles Triangle 30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2" name="Isosceles Triangle 30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3" name="Isosceles Triangle 30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04" name="Group 303"/>
          <p:cNvGrpSpPr/>
          <p:nvPr/>
        </p:nvGrpSpPr>
        <p:grpSpPr>
          <a:xfrm>
            <a:off x="277161" y="3694113"/>
            <a:ext cx="1213161" cy="1209875"/>
            <a:chOff x="4866873" y="650512"/>
            <a:chExt cx="1213161" cy="1209875"/>
          </a:xfrm>
        </p:grpSpPr>
        <p:sp>
          <p:nvSpPr>
            <p:cNvPr id="305" name="Isosceles Triangle 30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6" name="Isosceles Triangle 30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7" name="Isosceles Triangle 30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8" name="Isosceles Triangle 30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09" name="Group 308"/>
          <p:cNvGrpSpPr/>
          <p:nvPr/>
        </p:nvGrpSpPr>
        <p:grpSpPr>
          <a:xfrm>
            <a:off x="1678625" y="3700263"/>
            <a:ext cx="1213161" cy="1209875"/>
            <a:chOff x="4866873" y="650512"/>
            <a:chExt cx="1213161" cy="1209875"/>
          </a:xfrm>
        </p:grpSpPr>
        <p:sp>
          <p:nvSpPr>
            <p:cNvPr id="310" name="Isosceles Triangle 30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1" name="Isosceles Triangle 31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2" name="Isosceles Triangle 31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3" name="Isosceles Triangle 31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14" name="Group 313"/>
          <p:cNvGrpSpPr/>
          <p:nvPr/>
        </p:nvGrpSpPr>
        <p:grpSpPr>
          <a:xfrm>
            <a:off x="3071813" y="3692871"/>
            <a:ext cx="1213161" cy="1209875"/>
            <a:chOff x="4866873" y="650512"/>
            <a:chExt cx="1213161" cy="1209875"/>
          </a:xfrm>
        </p:grpSpPr>
        <p:sp>
          <p:nvSpPr>
            <p:cNvPr id="315" name="Isosceles Triangle 31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6" name="Isosceles Triangle 31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7" name="Isosceles Triangle 31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8" name="Isosceles Triangle 31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19" name="Group 318"/>
          <p:cNvGrpSpPr/>
          <p:nvPr/>
        </p:nvGrpSpPr>
        <p:grpSpPr>
          <a:xfrm>
            <a:off x="274757" y="5070472"/>
            <a:ext cx="1213161" cy="1209875"/>
            <a:chOff x="4866873" y="650512"/>
            <a:chExt cx="1213161" cy="1209875"/>
          </a:xfrm>
        </p:grpSpPr>
        <p:sp>
          <p:nvSpPr>
            <p:cNvPr id="320" name="Isosceles Triangle 31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1" name="Isosceles Triangle 32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2" name="Isosceles Triangle 32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3" name="Isosceles Triangle 32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24" name="Group 323"/>
          <p:cNvGrpSpPr/>
          <p:nvPr/>
        </p:nvGrpSpPr>
        <p:grpSpPr>
          <a:xfrm>
            <a:off x="1671079" y="5070472"/>
            <a:ext cx="1213161" cy="1209875"/>
            <a:chOff x="4866873" y="650512"/>
            <a:chExt cx="1213161" cy="1209875"/>
          </a:xfrm>
        </p:grpSpPr>
        <p:sp>
          <p:nvSpPr>
            <p:cNvPr id="325" name="Isosceles Triangle 32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6" name="Isosceles Triangle 32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7" name="Isosceles Triangle 32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8" name="Isosceles Triangle 32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29" name="Group 328"/>
          <p:cNvGrpSpPr/>
          <p:nvPr/>
        </p:nvGrpSpPr>
        <p:grpSpPr>
          <a:xfrm>
            <a:off x="3071813" y="5078213"/>
            <a:ext cx="1213161" cy="1209875"/>
            <a:chOff x="4866873" y="650512"/>
            <a:chExt cx="1213161" cy="1209875"/>
          </a:xfrm>
        </p:grpSpPr>
        <p:sp>
          <p:nvSpPr>
            <p:cNvPr id="330" name="Isosceles Triangle 32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1" name="Isosceles Triangle 33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2" name="Isosceles Triangle 33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3" name="Isosceles Triangle 33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64" name="TextBox 163"/>
          <p:cNvSpPr txBox="1"/>
          <p:nvPr/>
        </p:nvSpPr>
        <p:spPr>
          <a:xfrm>
            <a:off x="131884" y="509954"/>
            <a:ext cx="3994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CW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xmlns="" val="2592161572"/>
      </p:ext>
    </p:extLst>
  </p:cSld>
  <p:clrMapOvr>
    <a:masterClrMapping/>
  </p:clrMapOvr>
  <p:transition advClick="0" advTm="600000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6" dur="5000" fill="hold"/>
                                        <p:tgtEl>
                                          <p:spTgt spid="47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8" dur="5000" fill="hold"/>
                                        <p:tgtEl>
                                          <p:spTgt spid="48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10" dur="5000" fill="hold"/>
                                        <p:tgtEl>
                                          <p:spTgt spid="48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12" dur="5000" fill="hold"/>
                                        <p:tgtEl>
                                          <p:spTgt spid="49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14" dur="5000" fill="hold"/>
                                        <p:tgtEl>
                                          <p:spTgt spid="49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16" dur="5000" fill="hold"/>
                                        <p:tgtEl>
                                          <p:spTgt spid="50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18" dur="5000" fill="hold"/>
                                        <p:tgtEl>
                                          <p:spTgt spid="50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20" dur="5000" fill="hold"/>
                                        <p:tgtEl>
                                          <p:spTgt spid="51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22" dur="5000" fill="hold"/>
                                        <p:tgtEl>
                                          <p:spTgt spid="51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24" dur="5000" fill="hold"/>
                                        <p:tgtEl>
                                          <p:spTgt spid="52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26" dur="5000" fill="hold"/>
                                        <p:tgtEl>
                                          <p:spTgt spid="52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28" dur="5000" fill="hold"/>
                                        <p:tgtEl>
                                          <p:spTgt spid="53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30" dur="5000" fill="hold"/>
                                        <p:tgtEl>
                                          <p:spTgt spid="260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32" dur="5000" fill="hold"/>
                                        <p:tgtEl>
                                          <p:spTgt spid="27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34" dur="5000" fill="hold"/>
                                        <p:tgtEl>
                                          <p:spTgt spid="28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36" dur="5000" fill="hold"/>
                                        <p:tgtEl>
                                          <p:spTgt spid="28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38" dur="5000" fill="hold"/>
                                        <p:tgtEl>
                                          <p:spTgt spid="29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40" dur="5000" fill="hold"/>
                                        <p:tgtEl>
                                          <p:spTgt spid="29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42" dur="5000" fill="hold"/>
                                        <p:tgtEl>
                                          <p:spTgt spid="30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44" dur="5000" fill="hold"/>
                                        <p:tgtEl>
                                          <p:spTgt spid="30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46" dur="5000" fill="hold"/>
                                        <p:tgtEl>
                                          <p:spTgt spid="31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48" dur="5000" fill="hold"/>
                                        <p:tgtEl>
                                          <p:spTgt spid="31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50" dur="5000" fill="hold"/>
                                        <p:tgtEl>
                                          <p:spTgt spid="32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5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52" dur="5000" fill="hold"/>
                                        <p:tgtEl>
                                          <p:spTgt spid="32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538</TotalTime>
  <Words>116</Words>
  <Application>Microsoft Office PowerPoint</Application>
  <PresentationFormat>On-screen Show (4:3)</PresentationFormat>
  <Paragraphs>28</Paragraphs>
  <Slides>10</Slides>
  <Notes>1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1" baseType="lpstr">
      <vt:lpstr>Office Theme</vt:lpstr>
      <vt:lpstr>Slide 1</vt:lpstr>
      <vt:lpstr>Slide 2</vt:lpstr>
      <vt:lpstr>Slide 3</vt:lpstr>
      <vt:lpstr>Slide 4</vt:lpstr>
      <vt:lpstr>Slide 5</vt:lpstr>
      <vt:lpstr>Slide 6</vt:lpstr>
      <vt:lpstr>Slide 7</vt:lpstr>
      <vt:lpstr>Slide 8</vt:lpstr>
      <vt:lpstr>Slide 9</vt:lpstr>
      <vt:lpstr>Slide 10</vt:lpstr>
    </vt:vector>
  </TitlesOfParts>
  <Company>Brown University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Robbert</dc:creator>
  <cp:lastModifiedBy>Robbert</cp:lastModifiedBy>
  <cp:revision>106</cp:revision>
  <dcterms:created xsi:type="dcterms:W3CDTF">2010-02-15T14:38:38Z</dcterms:created>
  <dcterms:modified xsi:type="dcterms:W3CDTF">2017-01-28T16:53:47Z</dcterms:modified>
</cp:coreProperties>
</file>